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  <p:sldMasterId id="2147483672" r:id="rId5"/>
  </p:sldMasterIdLst>
  <p:notesMasterIdLst>
    <p:notesMasterId r:id="rId15"/>
  </p:notesMasterIdLst>
  <p:sldIdLst>
    <p:sldId id="300" r:id="rId6"/>
    <p:sldId id="301" r:id="rId7"/>
    <p:sldId id="270" r:id="rId8"/>
    <p:sldId id="306" r:id="rId9"/>
    <p:sldId id="269" r:id="rId10"/>
    <p:sldId id="313" r:id="rId11"/>
    <p:sldId id="303" r:id="rId12"/>
    <p:sldId id="304" r:id="rId13"/>
    <p:sldId id="309" r:id="rId1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970" autoAdjust="0"/>
  </p:normalViewPr>
  <p:slideViewPr>
    <p:cSldViewPr snapToGrid="0">
      <p:cViewPr varScale="1">
        <p:scale>
          <a:sx n="65" d="100"/>
          <a:sy n="65" d="100"/>
        </p:scale>
        <p:origin x="3402" y="28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microsoft.com/office/2016/11/relationships/changesInfo" Target="changesInfos/changesInfo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2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keda, Kenji (SEC)" userId="S::k.ikeda@sony.com::810681ac-ed82-4234-a9fb-9eadd97fd5df" providerId="AD" clId="Web-{E5C73C7E-CA7A-D31F-119B-8D1A8D64EAD5}"/>
    <pc:docChg chg="addSld modSld">
      <pc:chgData name="Ikeda, Kenji (SEC)" userId="S::k.ikeda@sony.com::810681ac-ed82-4234-a9fb-9eadd97fd5df" providerId="AD" clId="Web-{E5C73C7E-CA7A-D31F-119B-8D1A8D64EAD5}" dt="2023-11-20T05:42:53.148" v="2"/>
      <pc:docMkLst>
        <pc:docMk/>
      </pc:docMkLst>
      <pc:sldChg chg="mod modShow">
        <pc:chgData name="Ikeda, Kenji (SEC)" userId="S::k.ikeda@sony.com::810681ac-ed82-4234-a9fb-9eadd97fd5df" providerId="AD" clId="Web-{E5C73C7E-CA7A-D31F-119B-8D1A8D64EAD5}" dt="2023-11-20T05:16:58.065" v="0"/>
        <pc:sldMkLst>
          <pc:docMk/>
          <pc:sldMk cId="879219032" sldId="256"/>
        </pc:sldMkLst>
      </pc:sldChg>
      <pc:sldChg chg="mod modShow">
        <pc:chgData name="Ikeda, Kenji (SEC)" userId="S::k.ikeda@sony.com::810681ac-ed82-4234-a9fb-9eadd97fd5df" providerId="AD" clId="Web-{E5C73C7E-CA7A-D31F-119B-8D1A8D64EAD5}" dt="2023-11-20T05:42:53.148" v="2"/>
        <pc:sldMkLst>
          <pc:docMk/>
          <pc:sldMk cId="1923754617" sldId="258"/>
        </pc:sldMkLst>
      </pc:sldChg>
      <pc:sldChg chg="add">
        <pc:chgData name="Ikeda, Kenji (SEC)" userId="S::k.ikeda@sony.com::810681ac-ed82-4234-a9fb-9eadd97fd5df" providerId="AD" clId="Web-{E5C73C7E-CA7A-D31F-119B-8D1A8D64EAD5}" dt="2023-11-20T05:42:47.101" v="1"/>
        <pc:sldMkLst>
          <pc:docMk/>
          <pc:sldMk cId="1618462788" sldId="294"/>
        </pc:sldMkLst>
      </pc:sldChg>
    </pc:docChg>
  </pc:docChgLst>
  <pc:docChgLst>
    <pc:chgData name="Kaneko, Noe (SEC)" userId="f008250d-f64f-4eff-b87c-a229df23f8a4" providerId="ADAL" clId="{48A4E8E2-D923-4712-8C91-8174DE937673}"/>
    <pc:docChg chg="undo custSel addSld delSld modSld">
      <pc:chgData name="Kaneko, Noe (SEC)" userId="f008250d-f64f-4eff-b87c-a229df23f8a4" providerId="ADAL" clId="{48A4E8E2-D923-4712-8C91-8174DE937673}" dt="2023-11-19T14:29:41.400" v="973"/>
      <pc:docMkLst>
        <pc:docMk/>
      </pc:docMkLst>
      <pc:sldChg chg="addSp delSp modSp mod">
        <pc:chgData name="Kaneko, Noe (SEC)" userId="f008250d-f64f-4eff-b87c-a229df23f8a4" providerId="ADAL" clId="{48A4E8E2-D923-4712-8C91-8174DE937673}" dt="2023-11-18T14:23:02.286" v="954" actId="1076"/>
        <pc:sldMkLst>
          <pc:docMk/>
          <pc:sldMk cId="5918549" sldId="286"/>
        </pc:sldMkLst>
      </pc:sldChg>
      <pc:sldChg chg="addSp delSp modSp mod modShow">
        <pc:chgData name="Kaneko, Noe (SEC)" userId="f008250d-f64f-4eff-b87c-a229df23f8a4" providerId="ADAL" clId="{48A4E8E2-D923-4712-8C91-8174DE937673}" dt="2023-11-19T13:40:37.347" v="959" actId="1035"/>
        <pc:sldMkLst>
          <pc:docMk/>
          <pc:sldMk cId="2943963590" sldId="288"/>
        </pc:sldMkLst>
      </pc:sldChg>
      <pc:sldChg chg="add del">
        <pc:chgData name="Kaneko, Noe (SEC)" userId="f008250d-f64f-4eff-b87c-a229df23f8a4" providerId="ADAL" clId="{48A4E8E2-D923-4712-8C91-8174DE937673}" dt="2023-11-18T14:05:41.286" v="661" actId="47"/>
        <pc:sldMkLst>
          <pc:docMk/>
          <pc:sldMk cId="87228109" sldId="292"/>
        </pc:sldMkLst>
      </pc:sldChg>
      <pc:sldChg chg="addSp delSp modSp add mod">
        <pc:chgData name="Kaneko, Noe (SEC)" userId="f008250d-f64f-4eff-b87c-a229df23f8a4" providerId="ADAL" clId="{48A4E8E2-D923-4712-8C91-8174DE937673}" dt="2023-11-19T14:28:27.479" v="964" actId="1076"/>
        <pc:sldMkLst>
          <pc:docMk/>
          <pc:sldMk cId="1544269567" sldId="292"/>
        </pc:sldMkLst>
      </pc:sldChg>
      <pc:sldChg chg="delSp new del mod">
        <pc:chgData name="Kaneko, Noe (SEC)" userId="f008250d-f64f-4eff-b87c-a229df23f8a4" providerId="ADAL" clId="{48A4E8E2-D923-4712-8C91-8174DE937673}" dt="2023-11-18T13:36:39.882" v="150" actId="47"/>
        <pc:sldMkLst>
          <pc:docMk/>
          <pc:sldMk cId="2186593513" sldId="293"/>
        </pc:sldMkLst>
      </pc:sldChg>
      <pc:sldChg chg="add del">
        <pc:chgData name="Kaneko, Noe (SEC)" userId="f008250d-f64f-4eff-b87c-a229df23f8a4" providerId="ADAL" clId="{48A4E8E2-D923-4712-8C91-8174DE937673}" dt="2023-11-18T13:36:47.354" v="153"/>
        <pc:sldMkLst>
          <pc:docMk/>
          <pc:sldMk cId="3062359862" sldId="293"/>
        </pc:sldMkLst>
      </pc:sldChg>
      <pc:sldChg chg="addSp delSp modSp add mod">
        <pc:chgData name="Kaneko, Noe (SEC)" userId="f008250d-f64f-4eff-b87c-a229df23f8a4" providerId="ADAL" clId="{48A4E8E2-D923-4712-8C91-8174DE937673}" dt="2023-11-19T14:29:41.400" v="973"/>
        <pc:sldMkLst>
          <pc:docMk/>
          <pc:sldMk cId="3765421031" sldId="293"/>
        </pc:sldMkLst>
      </pc:sldChg>
      <pc:sldChg chg="addSp delSp modSp add del mod modShow">
        <pc:chgData name="Kaneko, Noe (SEC)" userId="f008250d-f64f-4eff-b87c-a229df23f8a4" providerId="ADAL" clId="{48A4E8E2-D923-4712-8C91-8174DE937673}" dt="2023-11-19T14:27:16.958" v="960" actId="2696"/>
        <pc:sldMkLst>
          <pc:docMk/>
          <pc:sldMk cId="1334830543" sldId="294"/>
        </pc:sldMkLst>
      </pc:sldChg>
    </pc:docChg>
  </pc:docChgLst>
  <pc:docChgLst>
    <pc:chgData name="Nakamura, Tomohiko (SEC)" userId="S::tomohiko.b.nakamura@sony.com::90bdbacb-404b-41f2-9537-6873be5c7ab7" providerId="AD" clId="Web-{6839BEF4-60CD-C54D-D80D-BCFDEF900672}"/>
    <pc:docChg chg="modSld">
      <pc:chgData name="Nakamura, Tomohiko (SEC)" userId="S::tomohiko.b.nakamura@sony.com::90bdbacb-404b-41f2-9537-6873be5c7ab7" providerId="AD" clId="Web-{6839BEF4-60CD-C54D-D80D-BCFDEF900672}" dt="2024-02-07T05:45:41.141" v="47"/>
      <pc:docMkLst>
        <pc:docMk/>
      </pc:docMkLst>
      <pc:sldChg chg="addSp delSp modSp">
        <pc:chgData name="Nakamura, Tomohiko (SEC)" userId="S::tomohiko.b.nakamura@sony.com::90bdbacb-404b-41f2-9537-6873be5c7ab7" providerId="AD" clId="Web-{6839BEF4-60CD-C54D-D80D-BCFDEF900672}" dt="2024-02-07T05:45:41.141" v="47"/>
        <pc:sldMkLst>
          <pc:docMk/>
          <pc:sldMk cId="408069537" sldId="303"/>
        </pc:sldMkLst>
      </pc:sldChg>
    </pc:docChg>
  </pc:docChgLst>
  <pc:docChgLst>
    <pc:chgData name="Nakamura, Tomohiko (SEC)" userId="90bdbacb-404b-41f2-9537-6873be5c7ab7" providerId="ADAL" clId="{FA2FDD4E-7748-486C-A665-51C9220BAFE2}"/>
    <pc:docChg chg="undo custSel addSld delSld modSld">
      <pc:chgData name="Nakamura, Tomohiko (SEC)" userId="90bdbacb-404b-41f2-9537-6873be5c7ab7" providerId="ADAL" clId="{FA2FDD4E-7748-486C-A665-51C9220BAFE2}" dt="2023-10-16T05:06:34.826" v="197" actId="20577"/>
      <pc:docMkLst>
        <pc:docMk/>
      </pc:docMkLst>
      <pc:sldChg chg="addSp delSp modSp add mod">
        <pc:chgData name="Nakamura, Tomohiko (SEC)" userId="90bdbacb-404b-41f2-9537-6873be5c7ab7" providerId="ADAL" clId="{FA2FDD4E-7748-486C-A665-51C9220BAFE2}" dt="2023-10-16T05:06:19.990" v="193" actId="20577"/>
        <pc:sldMkLst>
          <pc:docMk/>
          <pc:sldMk cId="879219032" sldId="256"/>
        </pc:sldMkLst>
      </pc:sldChg>
      <pc:sldChg chg="addSp delSp modSp mod">
        <pc:chgData name="Nakamura, Tomohiko (SEC)" userId="90bdbacb-404b-41f2-9537-6873be5c7ab7" providerId="ADAL" clId="{FA2FDD4E-7748-486C-A665-51C9220BAFE2}" dt="2023-10-16T05:06:14.566" v="191" actId="20577"/>
        <pc:sldMkLst>
          <pc:docMk/>
          <pc:sldMk cId="2459489055" sldId="269"/>
        </pc:sldMkLst>
      </pc:sldChg>
      <pc:sldChg chg="del">
        <pc:chgData name="Nakamura, Tomohiko (SEC)" userId="90bdbacb-404b-41f2-9537-6873be5c7ab7" providerId="ADAL" clId="{FA2FDD4E-7748-486C-A665-51C9220BAFE2}" dt="2023-10-16T04:47:45.013" v="184" actId="47"/>
        <pc:sldMkLst>
          <pc:docMk/>
          <pc:sldMk cId="3780817493" sldId="272"/>
        </pc:sldMkLst>
      </pc:sldChg>
      <pc:sldChg chg="modSp add mod">
        <pc:chgData name="Nakamura, Tomohiko (SEC)" userId="90bdbacb-404b-41f2-9537-6873be5c7ab7" providerId="ADAL" clId="{FA2FDD4E-7748-486C-A665-51C9220BAFE2}" dt="2023-10-16T04:44:31.291" v="68" actId="20577"/>
        <pc:sldMkLst>
          <pc:docMk/>
          <pc:sldMk cId="5918549" sldId="286"/>
        </pc:sldMkLst>
      </pc:sldChg>
      <pc:sldChg chg="modSp add mod">
        <pc:chgData name="Nakamura, Tomohiko (SEC)" userId="90bdbacb-404b-41f2-9537-6873be5c7ab7" providerId="ADAL" clId="{FA2FDD4E-7748-486C-A665-51C9220BAFE2}" dt="2023-10-16T04:44:26.240" v="63" actId="20577"/>
        <pc:sldMkLst>
          <pc:docMk/>
          <pc:sldMk cId="2943963590" sldId="288"/>
        </pc:sldMkLst>
      </pc:sldChg>
      <pc:sldChg chg="addSp modSp add mod">
        <pc:chgData name="Nakamura, Tomohiko (SEC)" userId="90bdbacb-404b-41f2-9537-6873be5c7ab7" providerId="ADAL" clId="{FA2FDD4E-7748-486C-A665-51C9220BAFE2}" dt="2023-10-16T04:48:05.696" v="185" actId="255"/>
        <pc:sldMkLst>
          <pc:docMk/>
          <pc:sldMk cId="83723295" sldId="289"/>
        </pc:sldMkLst>
      </pc:sldChg>
      <pc:sldChg chg="delSp modSp add mod">
        <pc:chgData name="Nakamura, Tomohiko (SEC)" userId="90bdbacb-404b-41f2-9537-6873be5c7ab7" providerId="ADAL" clId="{FA2FDD4E-7748-486C-A665-51C9220BAFE2}" dt="2023-10-16T05:06:34.826" v="197" actId="20577"/>
        <pc:sldMkLst>
          <pc:docMk/>
          <pc:sldMk cId="2753049653" sldId="290"/>
        </pc:sldMkLst>
      </pc:sldChg>
    </pc:docChg>
  </pc:docChgLst>
  <pc:docChgLst>
    <pc:chgData name="Tomohiko Nakamura" userId="90bdbacb-404b-41f2-9537-6873be5c7ab7" providerId="ADAL" clId="{4B99A6EE-3C84-4F85-987D-B1ECC08EF713}"/>
    <pc:docChg chg="custSel addSld delSld modSld">
      <pc:chgData name="Tomohiko Nakamura" userId="90bdbacb-404b-41f2-9537-6873be5c7ab7" providerId="ADAL" clId="{4B99A6EE-3C84-4F85-987D-B1ECC08EF713}" dt="2024-02-07T06:43:02.118" v="447" actId="47"/>
      <pc:docMkLst>
        <pc:docMk/>
      </pc:docMkLst>
      <pc:sldChg chg="del">
        <pc:chgData name="Tomohiko Nakamura" userId="90bdbacb-404b-41f2-9537-6873be5c7ab7" providerId="ADAL" clId="{4B99A6EE-3C84-4F85-987D-B1ECC08EF713}" dt="2024-02-07T06:43:02.118" v="447" actId="47"/>
        <pc:sldMkLst>
          <pc:docMk/>
          <pc:sldMk cId="83723295" sldId="289"/>
        </pc:sldMkLst>
      </pc:sldChg>
      <pc:sldChg chg="addSp modSp mod">
        <pc:chgData name="Tomohiko Nakamura" userId="90bdbacb-404b-41f2-9537-6873be5c7ab7" providerId="ADAL" clId="{4B99A6EE-3C84-4F85-987D-B1ECC08EF713}" dt="2024-02-07T05:47:34.551" v="15"/>
        <pc:sldMkLst>
          <pc:docMk/>
          <pc:sldMk cId="408069537" sldId="303"/>
        </pc:sldMkLst>
      </pc:sldChg>
      <pc:sldChg chg="addSp delSp modSp add mod">
        <pc:chgData name="Tomohiko Nakamura" userId="90bdbacb-404b-41f2-9537-6873be5c7ab7" providerId="ADAL" clId="{4B99A6EE-3C84-4F85-987D-B1ECC08EF713}" dt="2024-02-07T06:42:30.320" v="446" actId="1036"/>
        <pc:sldMkLst>
          <pc:docMk/>
          <pc:sldMk cId="164998496" sldId="305"/>
        </pc:sldMkLst>
      </pc:sldChg>
    </pc:docChg>
  </pc:docChgLst>
  <pc:docChgLst>
    <pc:chgData name="Nakagawa, Kazuhiro (SEC)" userId="6d29eef2-6567-4447-ac0c-83bd3b0e6f53" providerId="ADAL" clId="{157BF8FB-13DB-45DB-B0A9-F8B10ACA8424}"/>
    <pc:docChg chg="undo custSel addSld delSld modSld">
      <pc:chgData name="Nakagawa, Kazuhiro (SEC)" userId="6d29eef2-6567-4447-ac0c-83bd3b0e6f53" providerId="ADAL" clId="{157BF8FB-13DB-45DB-B0A9-F8B10ACA8424}" dt="2024-01-21T09:13:54.904" v="304" actId="478"/>
      <pc:docMkLst>
        <pc:docMk/>
      </pc:docMkLst>
      <pc:sldChg chg="del">
        <pc:chgData name="Nakagawa, Kazuhiro (SEC)" userId="6d29eef2-6567-4447-ac0c-83bd3b0e6f53" providerId="ADAL" clId="{157BF8FB-13DB-45DB-B0A9-F8B10ACA8424}" dt="2024-01-15T05:56:40.029" v="172" actId="47"/>
        <pc:sldMkLst>
          <pc:docMk/>
          <pc:sldMk cId="879219032" sldId="256"/>
        </pc:sldMkLst>
      </pc:sldChg>
      <pc:sldChg chg="del">
        <pc:chgData name="Nakagawa, Kazuhiro (SEC)" userId="6d29eef2-6567-4447-ac0c-83bd3b0e6f53" providerId="ADAL" clId="{157BF8FB-13DB-45DB-B0A9-F8B10ACA8424}" dt="2024-01-15T06:01:42.419" v="213" actId="47"/>
        <pc:sldMkLst>
          <pc:docMk/>
          <pc:sldMk cId="1923754617" sldId="258"/>
        </pc:sldMkLst>
      </pc:sldChg>
      <pc:sldChg chg="addSp delSp modSp add mod">
        <pc:chgData name="Nakagawa, Kazuhiro (SEC)" userId="6d29eef2-6567-4447-ac0c-83bd3b0e6f53" providerId="ADAL" clId="{157BF8FB-13DB-45DB-B0A9-F8B10ACA8424}" dt="2024-01-15T05:44:25.985" v="104" actId="20577"/>
        <pc:sldMkLst>
          <pc:docMk/>
          <pc:sldMk cId="307697936" sldId="270"/>
        </pc:sldMkLst>
      </pc:sldChg>
      <pc:sldChg chg="addSp delSp modSp add mod modNotesTx">
        <pc:chgData name="Nakagawa, Kazuhiro (SEC)" userId="6d29eef2-6567-4447-ac0c-83bd3b0e6f53" providerId="ADAL" clId="{157BF8FB-13DB-45DB-B0A9-F8B10ACA8424}" dt="2024-01-21T09:13:54.904" v="304" actId="478"/>
        <pc:sldMkLst>
          <pc:docMk/>
          <pc:sldMk cId="415996067" sldId="271"/>
        </pc:sldMkLst>
      </pc:sldChg>
      <pc:sldChg chg="addSp delSp modSp add mod">
        <pc:chgData name="Nakagawa, Kazuhiro (SEC)" userId="6d29eef2-6567-4447-ac0c-83bd3b0e6f53" providerId="ADAL" clId="{157BF8FB-13DB-45DB-B0A9-F8B10ACA8424}" dt="2024-01-15T05:45:30.972" v="124" actId="20577"/>
        <pc:sldMkLst>
          <pc:docMk/>
          <pc:sldMk cId="2480820879" sldId="272"/>
        </pc:sldMkLst>
      </pc:sldChg>
      <pc:sldChg chg="del">
        <pc:chgData name="Nakagawa, Kazuhiro (SEC)" userId="6d29eef2-6567-4447-ac0c-83bd3b0e6f53" providerId="ADAL" clId="{157BF8FB-13DB-45DB-B0A9-F8B10ACA8424}" dt="2024-01-15T06:05:07.241" v="215" actId="47"/>
        <pc:sldMkLst>
          <pc:docMk/>
          <pc:sldMk cId="5918549" sldId="286"/>
        </pc:sldMkLst>
      </pc:sldChg>
      <pc:sldChg chg="modSp mod">
        <pc:chgData name="Nakagawa, Kazuhiro (SEC)" userId="6d29eef2-6567-4447-ac0c-83bd3b0e6f53" providerId="ADAL" clId="{157BF8FB-13DB-45DB-B0A9-F8B10ACA8424}" dt="2024-01-15T10:29:42.420" v="217" actId="1076"/>
        <pc:sldMkLst>
          <pc:docMk/>
          <pc:sldMk cId="2753049653" sldId="290"/>
        </pc:sldMkLst>
      </pc:sldChg>
      <pc:sldChg chg="del">
        <pc:chgData name="Nakagawa, Kazuhiro (SEC)" userId="6d29eef2-6567-4447-ac0c-83bd3b0e6f53" providerId="ADAL" clId="{157BF8FB-13DB-45DB-B0A9-F8B10ACA8424}" dt="2024-01-15T06:05:09.076" v="216" actId="47"/>
        <pc:sldMkLst>
          <pc:docMk/>
          <pc:sldMk cId="1544269567" sldId="292"/>
        </pc:sldMkLst>
      </pc:sldChg>
      <pc:sldChg chg="modSp del">
        <pc:chgData name="Nakagawa, Kazuhiro (SEC)" userId="6d29eef2-6567-4447-ac0c-83bd3b0e6f53" providerId="ADAL" clId="{157BF8FB-13DB-45DB-B0A9-F8B10ACA8424}" dt="2024-01-15T06:01:44.029" v="214" actId="47"/>
        <pc:sldMkLst>
          <pc:docMk/>
          <pc:sldMk cId="1618462788" sldId="294"/>
        </pc:sldMkLst>
      </pc:sldChg>
      <pc:sldChg chg="modSp mod">
        <pc:chgData name="Nakagawa, Kazuhiro (SEC)" userId="6d29eef2-6567-4447-ac0c-83bd3b0e6f53" providerId="ADAL" clId="{157BF8FB-13DB-45DB-B0A9-F8B10ACA8424}" dt="2024-01-15T05:39:25.581" v="13" actId="20577"/>
        <pc:sldMkLst>
          <pc:docMk/>
          <pc:sldMk cId="21367330" sldId="295"/>
        </pc:sldMkLst>
      </pc:sldChg>
      <pc:sldChg chg="addSp delSp modSp mod">
        <pc:chgData name="Nakagawa, Kazuhiro (SEC)" userId="6d29eef2-6567-4447-ac0c-83bd3b0e6f53" providerId="ADAL" clId="{157BF8FB-13DB-45DB-B0A9-F8B10ACA8424}" dt="2024-01-15T10:30:18.117" v="255" actId="1035"/>
        <pc:sldMkLst>
          <pc:docMk/>
          <pc:sldMk cId="1168303320" sldId="296"/>
        </pc:sldMkLst>
      </pc:sldChg>
      <pc:sldChg chg="addSp delSp modSp mod">
        <pc:chgData name="Nakagawa, Kazuhiro (SEC)" userId="6d29eef2-6567-4447-ac0c-83bd3b0e6f53" providerId="ADAL" clId="{157BF8FB-13DB-45DB-B0A9-F8B10ACA8424}" dt="2024-01-15T05:50:01.261" v="171" actId="1076"/>
        <pc:sldMkLst>
          <pc:docMk/>
          <pc:sldMk cId="3489683900" sldId="298"/>
        </pc:sldMkLst>
      </pc:sldChg>
      <pc:sldChg chg="addSp delSp modSp mod">
        <pc:chgData name="Nakagawa, Kazuhiro (SEC)" userId="6d29eef2-6567-4447-ac0c-83bd3b0e6f53" providerId="ADAL" clId="{157BF8FB-13DB-45DB-B0A9-F8B10ACA8424}" dt="2024-01-15T05:44:36.507" v="106" actId="20577"/>
        <pc:sldMkLst>
          <pc:docMk/>
          <pc:sldMk cId="2857622161" sldId="300"/>
        </pc:sldMkLst>
      </pc:sldChg>
      <pc:sldChg chg="addSp delSp modSp mod">
        <pc:chgData name="Nakagawa, Kazuhiro (SEC)" userId="6d29eef2-6567-4447-ac0c-83bd3b0e6f53" providerId="ADAL" clId="{157BF8FB-13DB-45DB-B0A9-F8B10ACA8424}" dt="2024-01-15T05:44:42.011" v="108" actId="20577"/>
        <pc:sldMkLst>
          <pc:docMk/>
          <pc:sldMk cId="1576618249" sldId="301"/>
        </pc:sldMkLst>
      </pc:sldChg>
      <pc:sldChg chg="addSp delSp modSp add mod">
        <pc:chgData name="Nakagawa, Kazuhiro (SEC)" userId="6d29eef2-6567-4447-ac0c-83bd3b0e6f53" providerId="ADAL" clId="{157BF8FB-13DB-45DB-B0A9-F8B10ACA8424}" dt="2024-01-15T05:45:20.509" v="120" actId="1037"/>
        <pc:sldMkLst>
          <pc:docMk/>
          <pc:sldMk cId="3831214645" sldId="302"/>
        </pc:sldMkLst>
      </pc:sldChg>
    </pc:docChg>
  </pc:docChgLst>
  <pc:docChgLst>
    <pc:chgData name="Nakamura, Tomohiko (SEC)" userId="90bdbacb-404b-41f2-9537-6873be5c7ab7" providerId="ADAL" clId="{6113E758-C5A0-41A6-9E85-1429D9754783}"/>
    <pc:docChg chg="modSld">
      <pc:chgData name="Nakamura, Tomohiko (SEC)" userId="90bdbacb-404b-41f2-9537-6873be5c7ab7" providerId="ADAL" clId="{6113E758-C5A0-41A6-9E85-1429D9754783}" dt="2023-12-10T14:23:34.509" v="0"/>
      <pc:docMkLst>
        <pc:docMk/>
      </pc:docMkLst>
      <pc:sldChg chg="addSp modSp">
        <pc:chgData name="Nakamura, Tomohiko (SEC)" userId="90bdbacb-404b-41f2-9537-6873be5c7ab7" providerId="ADAL" clId="{6113E758-C5A0-41A6-9E85-1429D9754783}" dt="2023-12-10T14:23:34.509" v="0"/>
        <pc:sldMkLst>
          <pc:docMk/>
          <pc:sldMk cId="2753049653" sldId="290"/>
        </pc:sldMkLst>
      </pc:sldChg>
    </pc:docChg>
  </pc:docChgLst>
  <pc:docChgLst>
    <pc:chgData name="Kaneko, Noe (SEC)" userId="f008250d-f64f-4eff-b87c-a229df23f8a4" providerId="ADAL" clId="{6207FCF7-DFF0-49DF-9F28-B51910A4A963}"/>
    <pc:docChg chg="undo custSel addSld modSld">
      <pc:chgData name="Kaneko, Noe (SEC)" userId="f008250d-f64f-4eff-b87c-a229df23f8a4" providerId="ADAL" clId="{6207FCF7-DFF0-49DF-9F28-B51910A4A963}" dt="2023-12-28T05:59:13.021" v="198" actId="478"/>
      <pc:docMkLst>
        <pc:docMk/>
      </pc:docMkLst>
      <pc:sldChg chg="modSp mod">
        <pc:chgData name="Kaneko, Noe (SEC)" userId="f008250d-f64f-4eff-b87c-a229df23f8a4" providerId="ADAL" clId="{6207FCF7-DFF0-49DF-9F28-B51910A4A963}" dt="2023-12-27T06:05:15.454" v="131" actId="1036"/>
        <pc:sldMkLst>
          <pc:docMk/>
          <pc:sldMk cId="5918549" sldId="286"/>
        </pc:sldMkLst>
      </pc:sldChg>
      <pc:sldChg chg="addSp delSp modSp mod">
        <pc:chgData name="Kaneko, Noe (SEC)" userId="f008250d-f64f-4eff-b87c-a229df23f8a4" providerId="ADAL" clId="{6207FCF7-DFF0-49DF-9F28-B51910A4A963}" dt="2023-12-28T05:59:13.021" v="198" actId="478"/>
        <pc:sldMkLst>
          <pc:docMk/>
          <pc:sldMk cId="2943963590" sldId="288"/>
        </pc:sldMkLst>
      </pc:sldChg>
      <pc:sldChg chg="modSp mod">
        <pc:chgData name="Kaneko, Noe (SEC)" userId="f008250d-f64f-4eff-b87c-a229df23f8a4" providerId="ADAL" clId="{6207FCF7-DFF0-49DF-9F28-B51910A4A963}" dt="2023-12-27T07:40:07.823" v="180" actId="14100"/>
        <pc:sldMkLst>
          <pc:docMk/>
          <pc:sldMk cId="1544269567" sldId="292"/>
        </pc:sldMkLst>
      </pc:sldChg>
      <pc:sldChg chg="modSp mod">
        <pc:chgData name="Kaneko, Noe (SEC)" userId="f008250d-f64f-4eff-b87c-a229df23f8a4" providerId="ADAL" clId="{6207FCF7-DFF0-49DF-9F28-B51910A4A963}" dt="2023-12-25T09:18:23.236" v="128" actId="732"/>
        <pc:sldMkLst>
          <pc:docMk/>
          <pc:sldMk cId="3765421031" sldId="293"/>
        </pc:sldMkLst>
      </pc:sldChg>
      <pc:sldChg chg="addSp delSp modSp add mod">
        <pc:chgData name="Kaneko, Noe (SEC)" userId="f008250d-f64f-4eff-b87c-a229df23f8a4" providerId="ADAL" clId="{6207FCF7-DFF0-49DF-9F28-B51910A4A963}" dt="2023-12-27T07:41:10.873" v="185" actId="14100"/>
        <pc:sldMkLst>
          <pc:docMk/>
          <pc:sldMk cId="2529814187" sldId="297"/>
        </pc:sldMkLst>
      </pc:sldChg>
    </pc:docChg>
  </pc:docChgLst>
  <pc:docChgLst>
    <pc:chgData name="Kaneko, Noe (SEC)" userId="f008250d-f64f-4eff-b87c-a229df23f8a4" providerId="ADAL" clId="{F856CADF-12F0-4E8E-B45E-901A4151E5E6}"/>
    <pc:docChg chg="custSel modSld">
      <pc:chgData name="Kaneko, Noe (SEC)" userId="f008250d-f64f-4eff-b87c-a229df23f8a4" providerId="ADAL" clId="{F856CADF-12F0-4E8E-B45E-901A4151E5E6}" dt="2024-04-10T05:47:18.096" v="43" actId="1076"/>
      <pc:docMkLst>
        <pc:docMk/>
      </pc:docMkLst>
      <pc:sldChg chg="addSp delSp modSp mod">
        <pc:chgData name="Kaneko, Noe (SEC)" userId="f008250d-f64f-4eff-b87c-a229df23f8a4" providerId="ADAL" clId="{F856CADF-12F0-4E8E-B45E-901A4151E5E6}" dt="2024-04-10T05:47:18.096" v="43" actId="1076"/>
        <pc:sldMkLst>
          <pc:docMk/>
          <pc:sldMk cId="633908724" sldId="304"/>
        </pc:sldMkLst>
      </pc:sldChg>
    </pc:docChg>
  </pc:docChgLst>
  <pc:docChgLst>
    <pc:chgData name="Nakagawa, Kazuhiro (SEC)" userId="S::kazuhiro.nakagawa@sony.com::6d29eef2-6567-4447-ac0c-83bd3b0e6f53" providerId="AD" clId="Web-{1ED944E4-15BF-4D7C-B1E5-5BE98B20271F}"/>
    <pc:docChg chg="modSld sldOrd">
      <pc:chgData name="Nakagawa, Kazuhiro (SEC)" userId="S::kazuhiro.nakagawa@sony.com::6d29eef2-6567-4447-ac0c-83bd3b0e6f53" providerId="AD" clId="Web-{1ED944E4-15BF-4D7C-B1E5-5BE98B20271F}" dt="2024-01-15T05:38:18.004" v="9" actId="20577"/>
      <pc:docMkLst>
        <pc:docMk/>
      </pc:docMkLst>
      <pc:sldChg chg="delSp modSp ord">
        <pc:chgData name="Nakagawa, Kazuhiro (SEC)" userId="S::kazuhiro.nakagawa@sony.com::6d29eef2-6567-4447-ac0c-83bd3b0e6f53" providerId="AD" clId="Web-{1ED944E4-15BF-4D7C-B1E5-5BE98B20271F}" dt="2024-01-15T05:38:18.004" v="9" actId="20577"/>
        <pc:sldMkLst>
          <pc:docMk/>
          <pc:sldMk cId="21367330" sldId="295"/>
        </pc:sldMkLst>
      </pc:sldChg>
      <pc:sldChg chg="ord">
        <pc:chgData name="Nakagawa, Kazuhiro (SEC)" userId="S::kazuhiro.nakagawa@sony.com::6d29eef2-6567-4447-ac0c-83bd3b0e6f53" providerId="AD" clId="Web-{1ED944E4-15BF-4D7C-B1E5-5BE98B20271F}" dt="2024-01-15T05:36:48.346" v="0"/>
        <pc:sldMkLst>
          <pc:docMk/>
          <pc:sldMk cId="3489683900" sldId="298"/>
        </pc:sldMkLst>
      </pc:sldChg>
    </pc:docChg>
  </pc:docChgLst>
  <pc:docChgLst>
    <pc:chgData name="Nakamura, Tomohiko (SEC)" userId="90bdbacb-404b-41f2-9537-6873be5c7ab7" providerId="ADAL" clId="{07698D82-BF16-4D34-AA22-E33EECB235C4}"/>
    <pc:docChg chg="undo custSel addSld delSld modSld sldOrd">
      <pc:chgData name="Nakamura, Tomohiko (SEC)" userId="90bdbacb-404b-41f2-9537-6873be5c7ab7" providerId="ADAL" clId="{07698D82-BF16-4D34-AA22-E33EECB235C4}" dt="2024-01-22T10:54:01.024" v="271" actId="478"/>
      <pc:docMkLst>
        <pc:docMk/>
      </pc:docMkLst>
      <pc:sldChg chg="del">
        <pc:chgData name="Nakamura, Tomohiko (SEC)" userId="90bdbacb-404b-41f2-9537-6873be5c7ab7" providerId="ADAL" clId="{07698D82-BF16-4D34-AA22-E33EECB235C4}" dt="2024-01-22T10:12:24.920" v="178" actId="47"/>
        <pc:sldMkLst>
          <pc:docMk/>
          <pc:sldMk cId="2480820879" sldId="272"/>
        </pc:sldMkLst>
      </pc:sldChg>
      <pc:sldChg chg="modSp mod ord">
        <pc:chgData name="Nakamura, Tomohiko (SEC)" userId="90bdbacb-404b-41f2-9537-6873be5c7ab7" providerId="ADAL" clId="{07698D82-BF16-4D34-AA22-E33EECB235C4}" dt="2024-01-10T04:31:43.021" v="176" actId="20577"/>
        <pc:sldMkLst>
          <pc:docMk/>
          <pc:sldMk cId="83723295" sldId="289"/>
        </pc:sldMkLst>
      </pc:sldChg>
      <pc:sldChg chg="addSp delSp modSp mod">
        <pc:chgData name="Nakamura, Tomohiko (SEC)" userId="90bdbacb-404b-41f2-9537-6873be5c7ab7" providerId="ADAL" clId="{07698D82-BF16-4D34-AA22-E33EECB235C4}" dt="2024-01-22T10:46:32.187" v="197" actId="20577"/>
        <pc:sldMkLst>
          <pc:docMk/>
          <pc:sldMk cId="21367330" sldId="295"/>
        </pc:sldMkLst>
      </pc:sldChg>
      <pc:sldChg chg="modSp add mod">
        <pc:chgData name="Nakamura, Tomohiko (SEC)" userId="90bdbacb-404b-41f2-9537-6873be5c7ab7" providerId="ADAL" clId="{07698D82-BF16-4D34-AA22-E33EECB235C4}" dt="2024-01-07T13:29:31.180" v="126" actId="20577"/>
        <pc:sldMkLst>
          <pc:docMk/>
          <pc:sldMk cId="3489683900" sldId="298"/>
        </pc:sldMkLst>
      </pc:sldChg>
      <pc:sldChg chg="add del">
        <pc:chgData name="Nakamura, Tomohiko (SEC)" userId="90bdbacb-404b-41f2-9537-6873be5c7ab7" providerId="ADAL" clId="{07698D82-BF16-4D34-AA22-E33EECB235C4}" dt="2024-01-07T06:46:14.963" v="29" actId="47"/>
        <pc:sldMkLst>
          <pc:docMk/>
          <pc:sldMk cId="143635441" sldId="299"/>
        </pc:sldMkLst>
      </pc:sldChg>
      <pc:sldChg chg="addSp delSp modSp add mod ord setBg">
        <pc:chgData name="Nakamura, Tomohiko (SEC)" userId="90bdbacb-404b-41f2-9537-6873be5c7ab7" providerId="ADAL" clId="{07698D82-BF16-4D34-AA22-E33EECB235C4}" dt="2024-01-22T10:54:01.024" v="271" actId="478"/>
        <pc:sldMkLst>
          <pc:docMk/>
          <pc:sldMk cId="2857622161" sldId="300"/>
        </pc:sldMkLst>
      </pc:sldChg>
      <pc:sldChg chg="modSp add mod">
        <pc:chgData name="Nakamura, Tomohiko (SEC)" userId="90bdbacb-404b-41f2-9537-6873be5c7ab7" providerId="ADAL" clId="{07698D82-BF16-4D34-AA22-E33EECB235C4}" dt="2024-01-07T13:29:21.428" v="120" actId="20577"/>
        <pc:sldMkLst>
          <pc:docMk/>
          <pc:sldMk cId="1576618249" sldId="301"/>
        </pc:sldMkLst>
      </pc:sldChg>
      <pc:sldChg chg="add">
        <pc:chgData name="Nakamura, Tomohiko (SEC)" userId="90bdbacb-404b-41f2-9537-6873be5c7ab7" providerId="ADAL" clId="{07698D82-BF16-4D34-AA22-E33EECB235C4}" dt="2024-01-22T10:12:18.213" v="177"/>
        <pc:sldMkLst>
          <pc:docMk/>
          <pc:sldMk cId="408069537" sldId="303"/>
        </pc:sldMkLst>
      </pc:sldChg>
    </pc:docChg>
  </pc:docChgLst>
  <pc:docChgLst>
    <pc:chgData name="Kaneko, Noe (SEC)" userId="S::noe.kaneko@sony.com::f008250d-f64f-4eff-b87c-a229df23f8a4" providerId="AD" clId="Web-{F204845A-5445-4C28-841E-AED1607234D2}"/>
    <pc:docChg chg="modSld">
      <pc:chgData name="Kaneko, Noe (SEC)" userId="S::noe.kaneko@sony.com::f008250d-f64f-4eff-b87c-a229df23f8a4" providerId="AD" clId="Web-{F204845A-5445-4C28-841E-AED1607234D2}" dt="2023-11-27T05:24:53.972" v="25" actId="20577"/>
      <pc:docMkLst>
        <pc:docMk/>
      </pc:docMkLst>
      <pc:sldChg chg="delSp modSp">
        <pc:chgData name="Kaneko, Noe (SEC)" userId="S::noe.kaneko@sony.com::f008250d-f64f-4eff-b87c-a229df23f8a4" providerId="AD" clId="Web-{F204845A-5445-4C28-841E-AED1607234D2}" dt="2023-11-27T05:24:53.972" v="25" actId="20577"/>
        <pc:sldMkLst>
          <pc:docMk/>
          <pc:sldMk cId="1544269567" sldId="292"/>
        </pc:sldMkLst>
      </pc:sldChg>
    </pc:docChg>
  </pc:docChgLst>
  <pc:docChgLst>
    <pc:chgData name="Nakamura, Tomohiko (SEC)" userId="90bdbacb-404b-41f2-9537-6873be5c7ab7" providerId="ADAL" clId="{4B99A6EE-3C84-4F85-987D-B1ECC08EF713}"/>
    <pc:docChg chg="undo custSel addSld delSld modSld sldOrd">
      <pc:chgData name="Nakamura, Tomohiko (SEC)" userId="90bdbacb-404b-41f2-9537-6873be5c7ab7" providerId="ADAL" clId="{4B99A6EE-3C84-4F85-987D-B1ECC08EF713}" dt="2024-02-25T08:15:11.372" v="639" actId="167"/>
      <pc:docMkLst>
        <pc:docMk/>
      </pc:docMkLst>
      <pc:sldChg chg="modSp mod">
        <pc:chgData name="Nakamura, Tomohiko (SEC)" userId="90bdbacb-404b-41f2-9537-6873be5c7ab7" providerId="ADAL" clId="{4B99A6EE-3C84-4F85-987D-B1ECC08EF713}" dt="2024-02-12T05:12:41.877" v="56" actId="20577"/>
        <pc:sldMkLst>
          <pc:docMk/>
          <pc:sldMk cId="307697936" sldId="270"/>
        </pc:sldMkLst>
      </pc:sldChg>
      <pc:sldChg chg="del">
        <pc:chgData name="Nakamura, Tomohiko (SEC)" userId="90bdbacb-404b-41f2-9537-6873be5c7ab7" providerId="ADAL" clId="{4B99A6EE-3C84-4F85-987D-B1ECC08EF713}" dt="2024-02-12T13:06:25.282" v="60" actId="47"/>
        <pc:sldMkLst>
          <pc:docMk/>
          <pc:sldMk cId="3846465329" sldId="273"/>
        </pc:sldMkLst>
      </pc:sldChg>
      <pc:sldChg chg="modSp add mod">
        <pc:chgData name="Nakamura, Tomohiko (SEC)" userId="90bdbacb-404b-41f2-9537-6873be5c7ab7" providerId="ADAL" clId="{4B99A6EE-3C84-4F85-987D-B1ECC08EF713}" dt="2024-02-12T13:36:21.620" v="62" actId="554"/>
        <pc:sldMkLst>
          <pc:docMk/>
          <pc:sldMk cId="520582425" sldId="274"/>
        </pc:sldMkLst>
      </pc:sldChg>
      <pc:sldChg chg="ord">
        <pc:chgData name="Nakamura, Tomohiko (SEC)" userId="90bdbacb-404b-41f2-9537-6873be5c7ab7" providerId="ADAL" clId="{4B99A6EE-3C84-4F85-987D-B1ECC08EF713}" dt="2024-02-20T12:18:53.097" v="79"/>
        <pc:sldMkLst>
          <pc:docMk/>
          <pc:sldMk cId="3489683900" sldId="298"/>
        </pc:sldMkLst>
      </pc:sldChg>
      <pc:sldChg chg="addSp delSp modSp mod">
        <pc:chgData name="Nakamura, Tomohiko (SEC)" userId="90bdbacb-404b-41f2-9537-6873be5c7ab7" providerId="ADAL" clId="{4B99A6EE-3C84-4F85-987D-B1ECC08EF713}" dt="2024-02-12T15:49:53.607" v="63" actId="20577"/>
        <pc:sldMkLst>
          <pc:docMk/>
          <pc:sldMk cId="2857622161" sldId="300"/>
        </pc:sldMkLst>
      </pc:sldChg>
      <pc:sldChg chg="modSp mod ord">
        <pc:chgData name="Nakamura, Tomohiko (SEC)" userId="90bdbacb-404b-41f2-9537-6873be5c7ab7" providerId="ADAL" clId="{4B99A6EE-3C84-4F85-987D-B1ECC08EF713}" dt="2024-02-12T05:12:37.590" v="54" actId="20577"/>
        <pc:sldMkLst>
          <pc:docMk/>
          <pc:sldMk cId="1576618249" sldId="301"/>
        </pc:sldMkLst>
      </pc:sldChg>
      <pc:sldChg chg="addSp delSp modSp mod">
        <pc:chgData name="Nakamura, Tomohiko (SEC)" userId="90bdbacb-404b-41f2-9537-6873be5c7ab7" providerId="ADAL" clId="{4B99A6EE-3C84-4F85-987D-B1ECC08EF713}" dt="2024-02-20T12:17:50.205" v="75" actId="478"/>
        <pc:sldMkLst>
          <pc:docMk/>
          <pc:sldMk cId="408069537" sldId="303"/>
        </pc:sldMkLst>
      </pc:sldChg>
      <pc:sldChg chg="addSp delSp modSp mod">
        <pc:chgData name="Nakamura, Tomohiko (SEC)" userId="90bdbacb-404b-41f2-9537-6873be5c7ab7" providerId="ADAL" clId="{4B99A6EE-3C84-4F85-987D-B1ECC08EF713}" dt="2024-02-25T08:14:54.031" v="638" actId="167"/>
        <pc:sldMkLst>
          <pc:docMk/>
          <pc:sldMk cId="164998496" sldId="305"/>
        </pc:sldMkLst>
      </pc:sldChg>
      <pc:sldChg chg="modSp add mod ord">
        <pc:chgData name="Nakamura, Tomohiko (SEC)" userId="90bdbacb-404b-41f2-9537-6873be5c7ab7" providerId="ADAL" clId="{4B99A6EE-3C84-4F85-987D-B1ECC08EF713}" dt="2024-02-12T05:12:47.524" v="58" actId="20577"/>
        <pc:sldMkLst>
          <pc:docMk/>
          <pc:sldMk cId="459418047" sldId="306"/>
        </pc:sldMkLst>
      </pc:sldChg>
      <pc:sldChg chg="addSp delSp modSp add mod">
        <pc:chgData name="Nakamura, Tomohiko (SEC)" userId="90bdbacb-404b-41f2-9537-6873be5c7ab7" providerId="ADAL" clId="{4B99A6EE-3C84-4F85-987D-B1ECC08EF713}" dt="2024-02-25T08:15:11.372" v="639" actId="167"/>
        <pc:sldMkLst>
          <pc:docMk/>
          <pc:sldMk cId="2537672918" sldId="307"/>
        </pc:sldMkLst>
      </pc:sldChg>
      <pc:sldChg chg="add del">
        <pc:chgData name="Nakamura, Tomohiko (SEC)" userId="90bdbacb-404b-41f2-9537-6873be5c7ab7" providerId="ADAL" clId="{4B99A6EE-3C84-4F85-987D-B1ECC08EF713}" dt="2024-02-25T08:13:52.700" v="637" actId="47"/>
        <pc:sldMkLst>
          <pc:docMk/>
          <pc:sldMk cId="4015661887" sldId="308"/>
        </pc:sldMkLst>
      </pc:sldChg>
    </pc:docChg>
  </pc:docChgLst>
  <pc:docChgLst>
    <pc:chgData name="Nakamura, Tomohiko (SEC)" userId="90bdbacb-404b-41f2-9537-6873be5c7ab7" providerId="ADAL" clId="{2C662FF9-A149-49CD-B696-013E4D243A3F}"/>
    <pc:docChg chg="undo custSel addSld delSld modSld">
      <pc:chgData name="Nakamura, Tomohiko (SEC)" userId="90bdbacb-404b-41f2-9537-6873be5c7ab7" providerId="ADAL" clId="{2C662FF9-A149-49CD-B696-013E4D243A3F}" dt="2024-04-17T01:10:20.872" v="12" actId="47"/>
      <pc:docMkLst>
        <pc:docMk/>
      </pc:docMkLst>
      <pc:sldChg chg="addSp delSp modSp mod">
        <pc:chgData name="Nakamura, Tomohiko (SEC)" userId="90bdbacb-404b-41f2-9537-6873be5c7ab7" providerId="ADAL" clId="{2C662FF9-A149-49CD-B696-013E4D243A3F}" dt="2024-04-17T01:08:49.021" v="11"/>
        <pc:sldMkLst>
          <pc:docMk/>
          <pc:sldMk cId="2459489055" sldId="269"/>
        </pc:sldMkLst>
      </pc:sldChg>
      <pc:sldChg chg="del">
        <pc:chgData name="Nakamura, Tomohiko (SEC)" userId="90bdbacb-404b-41f2-9537-6873be5c7ab7" providerId="ADAL" clId="{2C662FF9-A149-49CD-B696-013E4D243A3F}" dt="2024-04-14T14:47:57.799" v="1" actId="47"/>
        <pc:sldMkLst>
          <pc:docMk/>
          <pc:sldMk cId="520582425" sldId="274"/>
        </pc:sldMkLst>
      </pc:sldChg>
      <pc:sldChg chg="addSp delSp modSp add mod modNotesTx">
        <pc:chgData name="Nakamura, Tomohiko (SEC)" userId="90bdbacb-404b-41f2-9537-6873be5c7ab7" providerId="ADAL" clId="{2C662FF9-A149-49CD-B696-013E4D243A3F}" dt="2024-04-14T14:52:17.914" v="6" actId="21"/>
        <pc:sldMkLst>
          <pc:docMk/>
          <pc:sldMk cId="3227244968" sldId="308"/>
        </pc:sldMkLst>
      </pc:sldChg>
      <pc:sldChg chg="add del">
        <pc:chgData name="Nakamura, Tomohiko (SEC)" userId="90bdbacb-404b-41f2-9537-6873be5c7ab7" providerId="ADAL" clId="{2C662FF9-A149-49CD-B696-013E4D243A3F}" dt="2024-04-17T01:10:20.872" v="12" actId="47"/>
        <pc:sldMkLst>
          <pc:docMk/>
          <pc:sldMk cId="776387270" sldId="309"/>
        </pc:sldMkLst>
      </pc:sldChg>
    </pc:docChg>
  </pc:docChgLst>
  <pc:docChgLst>
    <pc:chgData name="Kaneko, Noe (SEC)" userId="f008250d-f64f-4eff-b87c-a229df23f8a4" providerId="ADAL" clId="{394E8A85-EBDB-436A-A149-3302A515B239}"/>
    <pc:docChg chg="addSld delSld modSld">
      <pc:chgData name="Kaneko, Noe (SEC)" userId="f008250d-f64f-4eff-b87c-a229df23f8a4" providerId="ADAL" clId="{394E8A85-EBDB-436A-A149-3302A515B239}" dt="2024-10-16T10:11:53.962" v="4" actId="47"/>
      <pc:docMkLst>
        <pc:docMk/>
      </pc:docMkLst>
      <pc:sldChg chg="del">
        <pc:chgData name="Kaneko, Noe (SEC)" userId="f008250d-f64f-4eff-b87c-a229df23f8a4" providerId="ADAL" clId="{394E8A85-EBDB-436A-A149-3302A515B239}" dt="2024-10-16T10:11:53.962" v="4" actId="47"/>
        <pc:sldMkLst>
          <pc:docMk/>
          <pc:sldMk cId="2943963590" sldId="288"/>
        </pc:sldMkLst>
      </pc:sldChg>
      <pc:sldChg chg="del">
        <pc:chgData name="Kaneko, Noe (SEC)" userId="f008250d-f64f-4eff-b87c-a229df23f8a4" providerId="ADAL" clId="{394E8A85-EBDB-436A-A149-3302A515B239}" dt="2024-10-16T10:11:36.635" v="2" actId="47"/>
        <pc:sldMkLst>
          <pc:docMk/>
          <pc:sldMk cId="2529814187" sldId="297"/>
        </pc:sldMkLst>
      </pc:sldChg>
      <pc:sldChg chg="add">
        <pc:chgData name="Kaneko, Noe (SEC)" userId="f008250d-f64f-4eff-b87c-a229df23f8a4" providerId="ADAL" clId="{394E8A85-EBDB-436A-A149-3302A515B239}" dt="2024-10-16T10:10:41.461" v="1"/>
        <pc:sldMkLst>
          <pc:docMk/>
          <pc:sldMk cId="3150598339" sldId="305"/>
        </pc:sldMkLst>
      </pc:sldChg>
      <pc:sldChg chg="add">
        <pc:chgData name="Kaneko, Noe (SEC)" userId="f008250d-f64f-4eff-b87c-a229df23f8a4" providerId="ADAL" clId="{394E8A85-EBDB-436A-A149-3302A515B239}" dt="2024-10-16T10:10:21.477" v="0"/>
        <pc:sldMkLst>
          <pc:docMk/>
          <pc:sldMk cId="659949532" sldId="309"/>
        </pc:sldMkLst>
      </pc:sldChg>
      <pc:sldChg chg="add">
        <pc:chgData name="Kaneko, Noe (SEC)" userId="f008250d-f64f-4eff-b87c-a229df23f8a4" providerId="ADAL" clId="{394E8A85-EBDB-436A-A149-3302A515B239}" dt="2024-10-16T10:11:49.233" v="3"/>
        <pc:sldMkLst>
          <pc:docMk/>
          <pc:sldMk cId="1677895424" sldId="310"/>
        </pc:sldMkLst>
      </pc:sldChg>
    </pc:docChg>
  </pc:docChgLst>
  <pc:docChgLst>
    <pc:chgData name="Nakamura, Tomohiko (SEC)" userId="90bdbacb-404b-41f2-9537-6873be5c7ab7" providerId="ADAL" clId="{BA559584-A5A7-4771-A0EF-8AD62C83CFE9}"/>
    <pc:docChg chg="undo redo custSel delSld modSld">
      <pc:chgData name="Nakamura, Tomohiko (SEC)" userId="90bdbacb-404b-41f2-9537-6873be5c7ab7" providerId="ADAL" clId="{BA559584-A5A7-4771-A0EF-8AD62C83CFE9}" dt="2025-10-07T04:14:29.259" v="6" actId="6549"/>
      <pc:docMkLst>
        <pc:docMk/>
      </pc:docMkLst>
      <pc:sldChg chg="del">
        <pc:chgData name="Nakamura, Tomohiko (SEC)" userId="90bdbacb-404b-41f2-9537-6873be5c7ab7" providerId="ADAL" clId="{BA559584-A5A7-4771-A0EF-8AD62C83CFE9}" dt="2025-10-07T04:13:41.133" v="4" actId="47"/>
        <pc:sldMkLst>
          <pc:docMk/>
          <pc:sldMk cId="415996067" sldId="271"/>
        </pc:sldMkLst>
      </pc:sldChg>
      <pc:sldChg chg="modSp mod">
        <pc:chgData name="Nakamura, Tomohiko (SEC)" userId="90bdbacb-404b-41f2-9537-6873be5c7ab7" providerId="ADAL" clId="{BA559584-A5A7-4771-A0EF-8AD62C83CFE9}" dt="2025-10-07T04:13:11.407" v="2" actId="313"/>
        <pc:sldMkLst>
          <pc:docMk/>
          <pc:sldMk cId="2857622161" sldId="300"/>
        </pc:sldMkLst>
        <pc:graphicFrameChg chg="modGraphic">
          <ac:chgData name="Nakamura, Tomohiko (SEC)" userId="90bdbacb-404b-41f2-9537-6873be5c7ab7" providerId="ADAL" clId="{BA559584-A5A7-4771-A0EF-8AD62C83CFE9}" dt="2025-10-07T04:13:11.407" v="2" actId="313"/>
          <ac:graphicFrameMkLst>
            <pc:docMk/>
            <pc:sldMk cId="2857622161" sldId="300"/>
            <ac:graphicFrameMk id="4" creationId="{178AE8E8-83C9-1264-2709-40D9FB602F3D}"/>
          </ac:graphicFrameMkLst>
        </pc:graphicFrameChg>
      </pc:sldChg>
      <pc:sldChg chg="modNotesTx">
        <pc:chgData name="Nakamura, Tomohiko (SEC)" userId="90bdbacb-404b-41f2-9537-6873be5c7ab7" providerId="ADAL" clId="{BA559584-A5A7-4771-A0EF-8AD62C83CFE9}" dt="2025-10-07T04:14:29.259" v="6" actId="6549"/>
        <pc:sldMkLst>
          <pc:docMk/>
          <pc:sldMk cId="408069537" sldId="303"/>
        </pc:sldMkLst>
      </pc:sldChg>
      <pc:sldChg chg="modNotesTx">
        <pc:chgData name="Nakamura, Tomohiko (SEC)" userId="90bdbacb-404b-41f2-9537-6873be5c7ab7" providerId="ADAL" clId="{BA559584-A5A7-4771-A0EF-8AD62C83CFE9}" dt="2025-10-07T04:13:31.152" v="3" actId="6549"/>
        <pc:sldMkLst>
          <pc:docMk/>
          <pc:sldMk cId="633908724" sldId="304"/>
        </pc:sldMkLst>
      </pc:sldChg>
      <pc:sldChg chg="delSp mod">
        <pc:chgData name="Nakamura, Tomohiko (SEC)" userId="90bdbacb-404b-41f2-9537-6873be5c7ab7" providerId="ADAL" clId="{BA559584-A5A7-4771-A0EF-8AD62C83CFE9}" dt="2025-10-07T04:14:14.216" v="5" actId="478"/>
        <pc:sldMkLst>
          <pc:docMk/>
          <pc:sldMk cId="2168406966" sldId="313"/>
        </pc:sldMkLst>
        <pc:spChg chg="del">
          <ac:chgData name="Nakamura, Tomohiko (SEC)" userId="90bdbacb-404b-41f2-9537-6873be5c7ab7" providerId="ADAL" clId="{BA559584-A5A7-4771-A0EF-8AD62C83CFE9}" dt="2025-10-07T04:14:14.216" v="5" actId="478"/>
          <ac:spMkLst>
            <pc:docMk/>
            <pc:sldMk cId="2168406966" sldId="313"/>
            <ac:spMk id="69" creationId="{2449D9DC-0891-5F2C-E3B9-77B010A314C3}"/>
          </ac:spMkLst>
        </pc:spChg>
        <pc:spChg chg="del">
          <ac:chgData name="Nakamura, Tomohiko (SEC)" userId="90bdbacb-404b-41f2-9537-6873be5c7ab7" providerId="ADAL" clId="{BA559584-A5A7-4771-A0EF-8AD62C83CFE9}" dt="2025-10-07T04:14:14.216" v="5" actId="478"/>
          <ac:spMkLst>
            <pc:docMk/>
            <pc:sldMk cId="2168406966" sldId="313"/>
            <ac:spMk id="142" creationId="{D1F5F455-2CB7-462F-F575-95932BED691D}"/>
          </ac:spMkLst>
        </pc:spChg>
        <pc:grpChg chg="del">
          <ac:chgData name="Nakamura, Tomohiko (SEC)" userId="90bdbacb-404b-41f2-9537-6873be5c7ab7" providerId="ADAL" clId="{BA559584-A5A7-4771-A0EF-8AD62C83CFE9}" dt="2025-10-07T04:14:14.216" v="5" actId="478"/>
          <ac:grpSpMkLst>
            <pc:docMk/>
            <pc:sldMk cId="2168406966" sldId="313"/>
            <ac:grpSpMk id="41" creationId="{ECC16787-3172-1762-0067-1F6C3FC41217}"/>
          </ac:grpSpMkLst>
        </pc:grpChg>
        <pc:grpChg chg="del">
          <ac:chgData name="Nakamura, Tomohiko (SEC)" userId="90bdbacb-404b-41f2-9537-6873be5c7ab7" providerId="ADAL" clId="{BA559584-A5A7-4771-A0EF-8AD62C83CFE9}" dt="2025-10-07T04:14:14.216" v="5" actId="478"/>
          <ac:grpSpMkLst>
            <pc:docMk/>
            <pc:sldMk cId="2168406966" sldId="313"/>
            <ac:grpSpMk id="79" creationId="{A1821035-909D-3143-D705-0EF92CE84811}"/>
          </ac:grpSpMkLst>
        </pc:grpChg>
        <pc:cxnChg chg="del">
          <ac:chgData name="Nakamura, Tomohiko (SEC)" userId="90bdbacb-404b-41f2-9537-6873be5c7ab7" providerId="ADAL" clId="{BA559584-A5A7-4771-A0EF-8AD62C83CFE9}" dt="2025-10-07T04:14:14.216" v="5" actId="478"/>
          <ac:cxnSpMkLst>
            <pc:docMk/>
            <pc:sldMk cId="2168406966" sldId="313"/>
            <ac:cxnSpMk id="143" creationId="{B191BBE8-BF08-109A-4D2E-0AB826266D37}"/>
          </ac:cxnSpMkLst>
        </pc:cxnChg>
        <pc:cxnChg chg="del">
          <ac:chgData name="Nakamura, Tomohiko (SEC)" userId="90bdbacb-404b-41f2-9537-6873be5c7ab7" providerId="ADAL" clId="{BA559584-A5A7-4771-A0EF-8AD62C83CFE9}" dt="2025-10-07T04:14:14.216" v="5" actId="478"/>
          <ac:cxnSpMkLst>
            <pc:docMk/>
            <pc:sldMk cId="2168406966" sldId="313"/>
            <ac:cxnSpMk id="144" creationId="{85B3A9E0-E1A3-C09A-C747-5FDA15DFC281}"/>
          </ac:cxnSpMkLst>
        </pc:cxnChg>
      </pc:sldChg>
    </pc:docChg>
  </pc:docChgLst>
  <pc:docChgLst>
    <pc:chgData name="倉田　盛人" userId="S::kurata.pth2_tmd.ac.jp#ext#@sony.onmicrosoft.com::f9aa91ed-df94-4f44-8f34-dca0266f4e12" providerId="AD" clId="Web-{30BB3EBE-A87E-4CF6-895B-50B8F1EFDFD9}"/>
    <pc:docChg chg="sldOrd">
      <pc:chgData name="倉田　盛人" userId="S::kurata.pth2_tmd.ac.jp#ext#@sony.onmicrosoft.com::f9aa91ed-df94-4f44-8f34-dca0266f4e12" providerId="AD" clId="Web-{30BB3EBE-A87E-4CF6-895B-50B8F1EFDFD9}" dt="2024-01-22T23:49:07.130" v="0"/>
      <pc:docMkLst>
        <pc:docMk/>
      </pc:docMkLst>
      <pc:sldChg chg="ord">
        <pc:chgData name="倉田　盛人" userId="S::kurata.pth2_tmd.ac.jp#ext#@sony.onmicrosoft.com::f9aa91ed-df94-4f44-8f34-dca0266f4e12" providerId="AD" clId="Web-{30BB3EBE-A87E-4CF6-895B-50B8F1EFDFD9}" dt="2024-01-22T23:49:07.130" v="0"/>
        <pc:sldMkLst>
          <pc:docMk/>
          <pc:sldMk cId="3489683900" sldId="298"/>
        </pc:sldMkLst>
      </pc:sldChg>
    </pc:docChg>
  </pc:docChgLst>
  <pc:docChgLst>
    <pc:chgData name="Kenji" userId="810681ac-ed82-4234-a9fb-9eadd97fd5df" providerId="ADAL" clId="{B97A5211-E4A9-4A25-9667-0CD19705CED2}"/>
    <pc:docChg chg="undo custSel modSld">
      <pc:chgData name="Kenji" userId="810681ac-ed82-4234-a9fb-9eadd97fd5df" providerId="ADAL" clId="{B97A5211-E4A9-4A25-9667-0CD19705CED2}" dt="2023-10-16T05:22:07.099" v="191" actId="1076"/>
      <pc:docMkLst>
        <pc:docMk/>
      </pc:docMkLst>
      <pc:sldChg chg="modSp mod">
        <pc:chgData name="Kenji" userId="810681ac-ed82-4234-a9fb-9eadd97fd5df" providerId="ADAL" clId="{B97A5211-E4A9-4A25-9667-0CD19705CED2}" dt="2023-10-16T05:22:07.099" v="191" actId="1076"/>
        <pc:sldMkLst>
          <pc:docMk/>
          <pc:sldMk cId="879219032" sldId="256"/>
        </pc:sldMkLst>
      </pc:sldChg>
    </pc:docChg>
  </pc:docChgLst>
  <pc:docChgLst>
    <pc:chgData name="Nakagawa, Kazuhiro (SEC)" userId="6d29eef2-6567-4447-ac0c-83bd3b0e6f53" providerId="ADAL" clId="{976BECC4-642A-49DE-A57A-25D815F463BF}"/>
    <pc:docChg chg="undo custSel addSld delSld modSld sldOrd delMainMaster">
      <pc:chgData name="Nakagawa, Kazuhiro (SEC)" userId="6d29eef2-6567-4447-ac0c-83bd3b0e6f53" providerId="ADAL" clId="{976BECC4-642A-49DE-A57A-25D815F463BF}" dt="2024-10-29T01:15:43.393" v="252" actId="47"/>
      <pc:docMkLst>
        <pc:docMk/>
      </pc:docMkLst>
      <pc:sldChg chg="addSp delSp modSp mod ord">
        <pc:chgData name="Nakagawa, Kazuhiro (SEC)" userId="6d29eef2-6567-4447-ac0c-83bd3b0e6f53" providerId="ADAL" clId="{976BECC4-642A-49DE-A57A-25D815F463BF}" dt="2024-10-29T00:06:37.173" v="70"/>
        <pc:sldMkLst>
          <pc:docMk/>
          <pc:sldMk cId="2459489055" sldId="269"/>
        </pc:sldMkLst>
      </pc:sldChg>
      <pc:sldChg chg="modSp mod">
        <pc:chgData name="Nakagawa, Kazuhiro (SEC)" userId="6d29eef2-6567-4447-ac0c-83bd3b0e6f53" providerId="ADAL" clId="{976BECC4-642A-49DE-A57A-25D815F463BF}" dt="2024-10-29T00:07:58.093" v="89" actId="20577"/>
        <pc:sldMkLst>
          <pc:docMk/>
          <pc:sldMk cId="415996067" sldId="271"/>
        </pc:sldMkLst>
      </pc:sldChg>
      <pc:sldChg chg="modSp mod">
        <pc:chgData name="Nakagawa, Kazuhiro (SEC)" userId="6d29eef2-6567-4447-ac0c-83bd3b0e6f53" providerId="ADAL" clId="{976BECC4-642A-49DE-A57A-25D815F463BF}" dt="2024-10-29T01:14:11.396" v="157" actId="20577"/>
        <pc:sldMkLst>
          <pc:docMk/>
          <pc:sldMk cId="2753049653" sldId="290"/>
        </pc:sldMkLst>
      </pc:sldChg>
      <pc:sldChg chg="addSp delSp modSp mod">
        <pc:chgData name="Nakagawa, Kazuhiro (SEC)" userId="6d29eef2-6567-4447-ac0c-83bd3b0e6f53" providerId="ADAL" clId="{976BECC4-642A-49DE-A57A-25D815F463BF}" dt="2024-10-29T01:13:29.109" v="149" actId="478"/>
        <pc:sldMkLst>
          <pc:docMk/>
          <pc:sldMk cId="78237282" sldId="291"/>
        </pc:sldMkLst>
      </pc:sldChg>
      <pc:sldChg chg="del">
        <pc:chgData name="Nakagawa, Kazuhiro (SEC)" userId="6d29eef2-6567-4447-ac0c-83bd3b0e6f53" providerId="ADAL" clId="{976BECC4-642A-49DE-A57A-25D815F463BF}" dt="2024-10-29T00:11:55.171" v="99" actId="47"/>
        <pc:sldMkLst>
          <pc:docMk/>
          <pc:sldMk cId="1168303320" sldId="296"/>
        </pc:sldMkLst>
      </pc:sldChg>
      <pc:sldChg chg="del">
        <pc:chgData name="Nakagawa, Kazuhiro (SEC)" userId="6d29eef2-6567-4447-ac0c-83bd3b0e6f53" providerId="ADAL" clId="{976BECC4-642A-49DE-A57A-25D815F463BF}" dt="2024-10-29T00:06:40.370" v="71" actId="47"/>
        <pc:sldMkLst>
          <pc:docMk/>
          <pc:sldMk cId="3831214645" sldId="302"/>
        </pc:sldMkLst>
      </pc:sldChg>
      <pc:sldChg chg="modSp mod">
        <pc:chgData name="Nakagawa, Kazuhiro (SEC)" userId="6d29eef2-6567-4447-ac0c-83bd3b0e6f53" providerId="ADAL" clId="{976BECC4-642A-49DE-A57A-25D815F463BF}" dt="2024-10-29T00:07:16.441" v="77" actId="20577"/>
        <pc:sldMkLst>
          <pc:docMk/>
          <pc:sldMk cId="408069537" sldId="303"/>
        </pc:sldMkLst>
      </pc:sldChg>
      <pc:sldChg chg="modSp mod">
        <pc:chgData name="Nakagawa, Kazuhiro (SEC)" userId="6d29eef2-6567-4447-ac0c-83bd3b0e6f53" providerId="ADAL" clId="{976BECC4-642A-49DE-A57A-25D815F463BF}" dt="2024-10-29T00:07:32.326" v="83" actId="20577"/>
        <pc:sldMkLst>
          <pc:docMk/>
          <pc:sldMk cId="633908724" sldId="304"/>
        </pc:sldMkLst>
      </pc:sldChg>
      <pc:sldChg chg="modSp mod">
        <pc:chgData name="Nakagawa, Kazuhiro (SEC)" userId="6d29eef2-6567-4447-ac0c-83bd3b0e6f53" providerId="ADAL" clId="{976BECC4-642A-49DE-A57A-25D815F463BF}" dt="2024-10-29T01:14:21.629" v="161" actId="20577"/>
        <pc:sldMkLst>
          <pc:docMk/>
          <pc:sldMk cId="3150598339" sldId="305"/>
        </pc:sldMkLst>
      </pc:sldChg>
      <pc:sldChg chg="modSp mod">
        <pc:chgData name="Nakagawa, Kazuhiro (SEC)" userId="6d29eef2-6567-4447-ac0c-83bd3b0e6f53" providerId="ADAL" clId="{976BECC4-642A-49DE-A57A-25D815F463BF}" dt="2024-10-29T01:14:06.146" v="155" actId="20577"/>
        <pc:sldMkLst>
          <pc:docMk/>
          <pc:sldMk cId="3522346926" sldId="307"/>
        </pc:sldMkLst>
      </pc:sldChg>
      <pc:sldChg chg="addSp delSp modSp mod">
        <pc:chgData name="Nakagawa, Kazuhiro (SEC)" userId="6d29eef2-6567-4447-ac0c-83bd3b0e6f53" providerId="ADAL" clId="{976BECC4-642A-49DE-A57A-25D815F463BF}" dt="2024-10-29T01:14:00.086" v="153" actId="478"/>
        <pc:sldMkLst>
          <pc:docMk/>
          <pc:sldMk cId="3227244968" sldId="308"/>
        </pc:sldMkLst>
      </pc:sldChg>
      <pc:sldChg chg="addSp delSp modSp mod">
        <pc:chgData name="Nakagawa, Kazuhiro (SEC)" userId="6d29eef2-6567-4447-ac0c-83bd3b0e6f53" providerId="ADAL" clId="{976BECC4-642A-49DE-A57A-25D815F463BF}" dt="2024-10-29T00:07:51.925" v="87" actId="20577"/>
        <pc:sldMkLst>
          <pc:docMk/>
          <pc:sldMk cId="659949532" sldId="309"/>
        </pc:sldMkLst>
      </pc:sldChg>
      <pc:sldChg chg="modSp mod">
        <pc:chgData name="Nakagawa, Kazuhiro (SEC)" userId="6d29eef2-6567-4447-ac0c-83bd3b0e6f53" providerId="ADAL" clId="{976BECC4-642A-49DE-A57A-25D815F463BF}" dt="2024-10-29T01:14:16.741" v="159" actId="20577"/>
        <pc:sldMkLst>
          <pc:docMk/>
          <pc:sldMk cId="1677895424" sldId="310"/>
        </pc:sldMkLst>
      </pc:sldChg>
      <pc:sldChg chg="addSp delSp modSp new mod">
        <pc:chgData name="Nakagawa, Kazuhiro (SEC)" userId="6d29eef2-6567-4447-ac0c-83bd3b0e6f53" providerId="ADAL" clId="{976BECC4-642A-49DE-A57A-25D815F463BF}" dt="2024-10-29T00:37:10.122" v="146" actId="1076"/>
        <pc:sldMkLst>
          <pc:docMk/>
          <pc:sldMk cId="4113844467" sldId="311"/>
        </pc:sldMkLst>
      </pc:sldChg>
      <pc:sldChg chg="addSp delSp modSp new del mod">
        <pc:chgData name="Nakagawa, Kazuhiro (SEC)" userId="6d29eef2-6567-4447-ac0c-83bd3b0e6f53" providerId="ADAL" clId="{976BECC4-642A-49DE-A57A-25D815F463BF}" dt="2024-10-29T01:15:43.393" v="252" actId="47"/>
        <pc:sldMkLst>
          <pc:docMk/>
          <pc:sldMk cId="2453162805" sldId="312"/>
        </pc:sldMkLst>
      </pc:sldChg>
      <pc:sldChg chg="addSp delSp modSp mod">
        <pc:chgData name="Nakagawa, Kazuhiro (SEC)" userId="6d29eef2-6567-4447-ac0c-83bd3b0e6f53" providerId="ADAL" clId="{976BECC4-642A-49DE-A57A-25D815F463BF}" dt="2024-10-29T01:15:39.905" v="251"/>
        <pc:sldMkLst>
          <pc:docMk/>
          <pc:sldMk cId="2168406966" sldId="313"/>
        </pc:sldMkLst>
      </pc:sldChg>
      <pc:sldMasterChg chg="del delSldLayout">
        <pc:chgData name="Nakagawa, Kazuhiro (SEC)" userId="6d29eef2-6567-4447-ac0c-83bd3b0e6f53" providerId="ADAL" clId="{976BECC4-642A-49DE-A57A-25D815F463BF}" dt="2024-10-29T00:11:55.171" v="99" actId="47"/>
        <pc:sldMasterMkLst>
          <pc:docMk/>
          <pc:sldMasterMk cId="550545521" sldId="2147483672"/>
        </pc:sldMasterMkLst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3429064450" sldId="2147483673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3548737780" sldId="2147483674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581775006" sldId="2147483675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1855024083" sldId="2147483676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486742497" sldId="2147483677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1388890865" sldId="2147483678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513116350" sldId="2147483679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796866360" sldId="2147483680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1853420650" sldId="2147483681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3471252557" sldId="2147483682"/>
          </pc:sldLayoutMkLst>
        </pc:sldLayoutChg>
        <pc:sldLayoutChg chg="del">
          <pc:chgData name="Nakagawa, Kazuhiro (SEC)" userId="6d29eef2-6567-4447-ac0c-83bd3b0e6f53" providerId="ADAL" clId="{976BECC4-642A-49DE-A57A-25D815F463BF}" dt="2024-10-29T00:11:55.171" v="99" actId="47"/>
          <pc:sldLayoutMkLst>
            <pc:docMk/>
            <pc:sldMasterMk cId="550545521" sldId="2147483672"/>
            <pc:sldLayoutMk cId="1977730424" sldId="2147483683"/>
          </pc:sldLayoutMkLst>
        </pc:sldLayoutChg>
      </pc:sldMasterChg>
    </pc:docChg>
  </pc:docChgLst>
  <pc:docChgLst>
    <pc:chgData name="倉田　盛人" userId="S::kurata.pth2_tmd.ac.jp#ext#@sony.onmicrosoft.com::f9aa91ed-df94-4f44-8f34-dca0266f4e12" providerId="AD" clId="Web-{7363DBCF-BF78-7ABF-B079-C397B06FEA4F}"/>
    <pc:docChg chg="sldOrd">
      <pc:chgData name="倉田　盛人" userId="S::kurata.pth2_tmd.ac.jp#ext#@sony.onmicrosoft.com::f9aa91ed-df94-4f44-8f34-dca0266f4e12" providerId="AD" clId="Web-{7363DBCF-BF78-7ABF-B079-C397B06FEA4F}" dt="2024-04-16T05:46:46.867" v="1"/>
      <pc:docMkLst>
        <pc:docMk/>
      </pc:docMkLst>
      <pc:sldChg chg="ord">
        <pc:chgData name="倉田　盛人" userId="S::kurata.pth2_tmd.ac.jp#ext#@sony.onmicrosoft.com::f9aa91ed-df94-4f44-8f34-dca0266f4e12" providerId="AD" clId="Web-{7363DBCF-BF78-7ABF-B079-C397B06FEA4F}" dt="2024-04-16T05:46:46.867" v="1"/>
        <pc:sldMkLst>
          <pc:docMk/>
          <pc:sldMk cId="3522346926" sldId="307"/>
        </pc:sldMkLst>
      </pc:sldChg>
    </pc:docChg>
  </pc:docChgLst>
  <pc:docChgLst>
    <pc:chgData name="Nakagawa, Kazuhiro (SEC)" userId="6d29eef2-6567-4447-ac0c-83bd3b0e6f53" providerId="ADAL" clId="{F333D313-17DE-4A55-B2C4-188A1F82E2E7}"/>
    <pc:docChg chg="undo custSel modSld">
      <pc:chgData name="Nakagawa, Kazuhiro (SEC)" userId="6d29eef2-6567-4447-ac0c-83bd3b0e6f53" providerId="ADAL" clId="{F333D313-17DE-4A55-B2C4-188A1F82E2E7}" dt="2024-12-15T14:03:10.771" v="649" actId="1076"/>
      <pc:docMkLst>
        <pc:docMk/>
      </pc:docMkLst>
      <pc:sldChg chg="modSp mod">
        <pc:chgData name="Nakagawa, Kazuhiro (SEC)" userId="6d29eef2-6567-4447-ac0c-83bd3b0e6f53" providerId="ADAL" clId="{F333D313-17DE-4A55-B2C4-188A1F82E2E7}" dt="2024-12-15T14:03:10.771" v="649" actId="1076"/>
        <pc:sldMkLst>
          <pc:docMk/>
          <pc:sldMk cId="659949532" sldId="309"/>
        </pc:sldMkLst>
      </pc:sldChg>
      <pc:sldChg chg="addSp delSp modSp mod">
        <pc:chgData name="Nakagawa, Kazuhiro (SEC)" userId="6d29eef2-6567-4447-ac0c-83bd3b0e6f53" providerId="ADAL" clId="{F333D313-17DE-4A55-B2C4-188A1F82E2E7}" dt="2024-12-15T10:49:32.711" v="648" actId="1035"/>
        <pc:sldMkLst>
          <pc:docMk/>
          <pc:sldMk cId="4113844467" sldId="311"/>
        </pc:sldMkLst>
      </pc:sldChg>
    </pc:docChg>
  </pc:docChgLst>
  <pc:docChgLst>
    <pc:chgData name="Kaneko, Noe (SEC)" userId="S::noe.kaneko@sony.com::f008250d-f64f-4eff-b87c-a229df23f8a4" providerId="AD" clId="Web-{FC7FB522-98C5-1152-ABC0-FBF1CD578B34}"/>
    <pc:docChg chg="addSld">
      <pc:chgData name="Kaneko, Noe (SEC)" userId="S::noe.kaneko@sony.com::f008250d-f64f-4eff-b87c-a229df23f8a4" providerId="AD" clId="Web-{FC7FB522-98C5-1152-ABC0-FBF1CD578B34}" dt="2024-01-31T09:20:50.538" v="0"/>
      <pc:docMkLst>
        <pc:docMk/>
      </pc:docMkLst>
      <pc:sldChg chg="add replId">
        <pc:chgData name="Kaneko, Noe (SEC)" userId="S::noe.kaneko@sony.com::f008250d-f64f-4eff-b87c-a229df23f8a4" providerId="AD" clId="Web-{FC7FB522-98C5-1152-ABC0-FBF1CD578B34}" dt="2024-01-31T09:20:50.538" v="0"/>
        <pc:sldMkLst>
          <pc:docMk/>
          <pc:sldMk cId="633908724" sldId="304"/>
        </pc:sldMkLst>
      </pc:sldChg>
    </pc:docChg>
  </pc:docChgLst>
  <pc:docChgLst>
    <pc:chgData name="Nakagawa, Kazuhiro (SEC)" userId="6d29eef2-6567-4447-ac0c-83bd3b0e6f53" providerId="ADAL" clId="{C5945858-D96C-49A1-B82E-28581A70B146}"/>
    <pc:docChg chg="undo custSel addSld modSld sldOrd">
      <pc:chgData name="Nakagawa, Kazuhiro (SEC)" userId="6d29eef2-6567-4447-ac0c-83bd3b0e6f53" providerId="ADAL" clId="{C5945858-D96C-49A1-B82E-28581A70B146}" dt="2023-11-13T06:43:20.545" v="711" actId="478"/>
      <pc:docMkLst>
        <pc:docMk/>
      </pc:docMkLst>
      <pc:sldChg chg="addSp delSp modSp mod">
        <pc:chgData name="Nakagawa, Kazuhiro (SEC)" userId="6d29eef2-6567-4447-ac0c-83bd3b0e6f53" providerId="ADAL" clId="{C5945858-D96C-49A1-B82E-28581A70B146}" dt="2023-11-13T06:42:27.733" v="687" actId="478"/>
        <pc:sldMkLst>
          <pc:docMk/>
          <pc:sldMk cId="879219032" sldId="256"/>
        </pc:sldMkLst>
      </pc:sldChg>
      <pc:sldChg chg="addSp delSp modSp mod">
        <pc:chgData name="Nakagawa, Kazuhiro (SEC)" userId="6d29eef2-6567-4447-ac0c-83bd3b0e6f53" providerId="ADAL" clId="{C5945858-D96C-49A1-B82E-28581A70B146}" dt="2023-11-13T06:42:35.704" v="691" actId="478"/>
        <pc:sldMkLst>
          <pc:docMk/>
          <pc:sldMk cId="1923754617" sldId="258"/>
        </pc:sldMkLst>
      </pc:sldChg>
      <pc:sldChg chg="addSp delSp modSp mod">
        <pc:chgData name="Nakagawa, Kazuhiro (SEC)" userId="6d29eef2-6567-4447-ac0c-83bd3b0e6f53" providerId="ADAL" clId="{C5945858-D96C-49A1-B82E-28581A70B146}" dt="2023-11-13T06:42:20.250" v="685" actId="478"/>
        <pc:sldMkLst>
          <pc:docMk/>
          <pc:sldMk cId="2459489055" sldId="269"/>
        </pc:sldMkLst>
      </pc:sldChg>
      <pc:sldChg chg="addSp delSp modSp mod">
        <pc:chgData name="Nakagawa, Kazuhiro (SEC)" userId="6d29eef2-6567-4447-ac0c-83bd3b0e6f53" providerId="ADAL" clId="{C5945858-D96C-49A1-B82E-28581A70B146}" dt="2023-11-13T06:42:44.393" v="695" actId="478"/>
        <pc:sldMkLst>
          <pc:docMk/>
          <pc:sldMk cId="3846465329" sldId="273"/>
        </pc:sldMkLst>
      </pc:sldChg>
      <pc:sldChg chg="addSp delSp modSp mod">
        <pc:chgData name="Nakagawa, Kazuhiro (SEC)" userId="6d29eef2-6567-4447-ac0c-83bd3b0e6f53" providerId="ADAL" clId="{C5945858-D96C-49A1-B82E-28581A70B146}" dt="2023-11-13T06:43:20.545" v="711" actId="478"/>
        <pc:sldMkLst>
          <pc:docMk/>
          <pc:sldMk cId="5918549" sldId="286"/>
        </pc:sldMkLst>
      </pc:sldChg>
      <pc:sldChg chg="addSp delSp modSp mod">
        <pc:chgData name="Nakagawa, Kazuhiro (SEC)" userId="6d29eef2-6567-4447-ac0c-83bd3b0e6f53" providerId="ADAL" clId="{C5945858-D96C-49A1-B82E-28581A70B146}" dt="2023-11-13T06:43:10.103" v="707" actId="478"/>
        <pc:sldMkLst>
          <pc:docMk/>
          <pc:sldMk cId="2943963590" sldId="288"/>
        </pc:sldMkLst>
      </pc:sldChg>
      <pc:sldChg chg="addSp delSp modSp mod">
        <pc:chgData name="Nakagawa, Kazuhiro (SEC)" userId="6d29eef2-6567-4447-ac0c-83bd3b0e6f53" providerId="ADAL" clId="{C5945858-D96C-49A1-B82E-28581A70B146}" dt="2023-11-13T06:42:52.514" v="699" actId="478"/>
        <pc:sldMkLst>
          <pc:docMk/>
          <pc:sldMk cId="83723295" sldId="289"/>
        </pc:sldMkLst>
      </pc:sldChg>
      <pc:sldChg chg="addSp delSp modSp mod">
        <pc:chgData name="Nakagawa, Kazuhiro (SEC)" userId="6d29eef2-6567-4447-ac0c-83bd3b0e6f53" providerId="ADAL" clId="{C5945858-D96C-49A1-B82E-28581A70B146}" dt="2023-11-13T06:43:00.815" v="703" actId="478"/>
        <pc:sldMkLst>
          <pc:docMk/>
          <pc:sldMk cId="2753049653" sldId="290"/>
        </pc:sldMkLst>
      </pc:sldChg>
      <pc:sldChg chg="addSp delSp modSp new mod ord">
        <pc:chgData name="Nakagawa, Kazuhiro (SEC)" userId="6d29eef2-6567-4447-ac0c-83bd3b0e6f53" providerId="ADAL" clId="{C5945858-D96C-49A1-B82E-28581A70B146}" dt="2023-11-13T06:42:10.805" v="681" actId="1076"/>
        <pc:sldMkLst>
          <pc:docMk/>
          <pc:sldMk cId="78237282" sldId="291"/>
        </pc:sldMkLst>
      </pc:sldChg>
    </pc:docChg>
  </pc:docChgLst>
  <pc:docChgLst>
    <pc:chgData name="Nakamura, Tomohiko (SEC)" userId="90bdbacb-404b-41f2-9537-6873be5c7ab7" providerId="ADAL" clId="{5A33CF19-02F5-422F-BE2F-E4CAAA22D953}"/>
    <pc:docChg chg="custSel addSld delSld modSld">
      <pc:chgData name="Nakamura, Tomohiko (SEC)" userId="90bdbacb-404b-41f2-9537-6873be5c7ab7" providerId="ADAL" clId="{5A33CF19-02F5-422F-BE2F-E4CAAA22D953}" dt="2023-10-16T04:22:38.498" v="10" actId="20577"/>
      <pc:docMkLst>
        <pc:docMk/>
      </pc:docMkLst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2239190444" sldId="257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2263633980" sldId="260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725149520" sldId="261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1198545058" sldId="262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114613011" sldId="263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1641502360" sldId="264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514996892" sldId="265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1275763734" sldId="266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3666449480" sldId="267"/>
        </pc:sldMkLst>
      </pc:sldChg>
      <pc:sldChg chg="del">
        <pc:chgData name="Nakamura, Tomohiko (SEC)" userId="90bdbacb-404b-41f2-9537-6873be5c7ab7" providerId="ADAL" clId="{5A33CF19-02F5-422F-BE2F-E4CAAA22D953}" dt="2023-10-16T04:22:07.159" v="0" actId="47"/>
        <pc:sldMkLst>
          <pc:docMk/>
          <pc:sldMk cId="1754442231" sldId="268"/>
        </pc:sldMkLst>
      </pc:sldChg>
      <pc:sldChg chg="delSp modSp mod modNotesTx">
        <pc:chgData name="Nakamura, Tomohiko (SEC)" userId="90bdbacb-404b-41f2-9537-6873be5c7ab7" providerId="ADAL" clId="{5A33CF19-02F5-422F-BE2F-E4CAAA22D953}" dt="2023-10-16T04:22:38.498" v="10" actId="20577"/>
        <pc:sldMkLst>
          <pc:docMk/>
          <pc:sldMk cId="2459489055" sldId="269"/>
        </pc:sldMkLst>
      </pc:sldChg>
      <pc:sldChg chg="modNotesTx">
        <pc:chgData name="Nakamura, Tomohiko (SEC)" userId="90bdbacb-404b-41f2-9537-6873be5c7ab7" providerId="ADAL" clId="{5A33CF19-02F5-422F-BE2F-E4CAAA22D953}" dt="2023-10-16T04:22:15.628" v="2" actId="6549"/>
        <pc:sldMkLst>
          <pc:docMk/>
          <pc:sldMk cId="3780817493" sldId="272"/>
        </pc:sldMkLst>
      </pc:sldChg>
      <pc:sldChg chg="del">
        <pc:chgData name="Nakamura, Tomohiko (SEC)" userId="90bdbacb-404b-41f2-9537-6873be5c7ab7" providerId="ADAL" clId="{5A33CF19-02F5-422F-BE2F-E4CAAA22D953}" dt="2023-10-16T04:22:12.449" v="1" actId="47"/>
        <pc:sldMkLst>
          <pc:docMk/>
          <pc:sldMk cId="2716657899" sldId="273"/>
        </pc:sldMkLst>
      </pc:sldChg>
      <pc:sldChg chg="add">
        <pc:chgData name="Nakamura, Tomohiko (SEC)" userId="90bdbacb-404b-41f2-9537-6873be5c7ab7" providerId="ADAL" clId="{5A33CF19-02F5-422F-BE2F-E4CAAA22D953}" dt="2023-10-16T04:22:23.914" v="4"/>
        <pc:sldMkLst>
          <pc:docMk/>
          <pc:sldMk cId="3846465329" sldId="273"/>
        </pc:sldMkLst>
      </pc:sldChg>
    </pc:docChg>
  </pc:docChgLst>
  <pc:docChgLst>
    <pc:chgData name="Ikeda, Kenji (SEC)" userId="810681ac-ed82-4234-a9fb-9eadd97fd5df" providerId="ADAL" clId="{13BB13D9-AC28-4304-93DB-A7633822809F}"/>
    <pc:docChg chg="modSld">
      <pc:chgData name="Ikeda, Kenji (SEC)" userId="810681ac-ed82-4234-a9fb-9eadd97fd5df" providerId="ADAL" clId="{13BB13D9-AC28-4304-93DB-A7633822809F}" dt="2023-11-13T06:18:36.299" v="0"/>
      <pc:docMkLst>
        <pc:docMk/>
      </pc:docMkLst>
      <pc:sldChg chg="modSp">
        <pc:chgData name="Ikeda, Kenji (SEC)" userId="810681ac-ed82-4234-a9fb-9eadd97fd5df" providerId="ADAL" clId="{13BB13D9-AC28-4304-93DB-A7633822809F}" dt="2023-11-13T06:18:36.299" v="0"/>
        <pc:sldMkLst>
          <pc:docMk/>
          <pc:sldMk cId="879219032" sldId="256"/>
        </pc:sldMkLst>
      </pc:sldChg>
    </pc:docChg>
  </pc:docChgLst>
  <pc:docChgLst>
    <pc:chgData name="Nakamura, Tomohiko (SEC)" userId="90bdbacb-404b-41f2-9537-6873be5c7ab7" providerId="ADAL" clId="{DDED3807-CE86-4321-A5B2-C23CB4E8C822}"/>
    <pc:docChg chg="undo custSel addSld delSld modSld">
      <pc:chgData name="Nakamura, Tomohiko (SEC)" userId="90bdbacb-404b-41f2-9537-6873be5c7ab7" providerId="ADAL" clId="{DDED3807-CE86-4321-A5B2-C23CB4E8C822}" dt="2024-03-14T05:16:40.895" v="8" actId="47"/>
      <pc:docMkLst>
        <pc:docMk/>
      </pc:docMkLst>
      <pc:sldChg chg="del">
        <pc:chgData name="Nakamura, Tomohiko (SEC)" userId="90bdbacb-404b-41f2-9537-6873be5c7ab7" providerId="ADAL" clId="{DDED3807-CE86-4321-A5B2-C23CB4E8C822}" dt="2024-03-14T05:16:40.895" v="8" actId="47"/>
        <pc:sldMkLst>
          <pc:docMk/>
          <pc:sldMk cId="164998496" sldId="305"/>
        </pc:sldMkLst>
      </pc:sldChg>
      <pc:sldChg chg="del">
        <pc:chgData name="Nakamura, Tomohiko (SEC)" userId="90bdbacb-404b-41f2-9537-6873be5c7ab7" providerId="ADAL" clId="{DDED3807-CE86-4321-A5B2-C23CB4E8C822}" dt="2024-03-14T05:15:25.150" v="0" actId="2696"/>
        <pc:sldMkLst>
          <pc:docMk/>
          <pc:sldMk cId="2537672918" sldId="307"/>
        </pc:sldMkLst>
      </pc:sldChg>
      <pc:sldChg chg="addSp delSp modSp add mod">
        <pc:chgData name="Nakamura, Tomohiko (SEC)" userId="90bdbacb-404b-41f2-9537-6873be5c7ab7" providerId="ADAL" clId="{DDED3807-CE86-4321-A5B2-C23CB4E8C822}" dt="2024-03-14T05:16:21.916" v="7" actId="478"/>
        <pc:sldMkLst>
          <pc:docMk/>
          <pc:sldMk cId="3522346926" sldId="307"/>
        </pc:sldMkLst>
      </pc:sldChg>
    </pc:docChg>
  </pc:docChgLst>
  <pc:docChgLst>
    <pc:chgData name="Kaneko, Noe (SEC)" userId="S::noe.kaneko@sony.com::f008250d-f64f-4eff-b87c-a229df23f8a4" providerId="AD" clId="Web-{DD3A70A2-45B1-95B0-BC4E-4803BD700DDE}"/>
    <pc:docChg chg="modSld sldOrd">
      <pc:chgData name="Kaneko, Noe (SEC)" userId="S::noe.kaneko@sony.com::f008250d-f64f-4eff-b87c-a229df23f8a4" providerId="AD" clId="Web-{DD3A70A2-45B1-95B0-BC4E-4803BD700DDE}" dt="2024-04-10T05:20:36.925" v="1"/>
      <pc:docMkLst>
        <pc:docMk/>
      </pc:docMkLst>
      <pc:sldChg chg="mod modShow">
        <pc:chgData name="Kaneko, Noe (SEC)" userId="S::noe.kaneko@sony.com::f008250d-f64f-4eff-b87c-a229df23f8a4" providerId="AD" clId="Web-{DD3A70A2-45B1-95B0-BC4E-4803BD700DDE}" dt="2024-04-10T05:20:36.925" v="1"/>
        <pc:sldMkLst>
          <pc:docMk/>
          <pc:sldMk cId="415996067" sldId="271"/>
        </pc:sldMkLst>
      </pc:sldChg>
      <pc:sldChg chg="ord">
        <pc:chgData name="Kaneko, Noe (SEC)" userId="S::noe.kaneko@sony.com::f008250d-f64f-4eff-b87c-a229df23f8a4" providerId="AD" clId="Web-{DD3A70A2-45B1-95B0-BC4E-4803BD700DDE}" dt="2024-04-10T05:20:27.519" v="0"/>
        <pc:sldMkLst>
          <pc:docMk/>
          <pc:sldMk cId="633908724" sldId="304"/>
        </pc:sldMkLst>
      </pc:sldChg>
    </pc:docChg>
  </pc:docChgLst>
  <pc:docChgLst>
    <pc:chgData name="Nakamura, Tomohiko (SEC)" userId="90bdbacb-404b-41f2-9537-6873be5c7ab7" providerId="ADAL" clId="{7E3E65E1-DEC8-4FE4-BA2D-38A63F28DDB2}"/>
    <pc:docChg chg="undo redo custSel addSld delSld modSld sldOrd">
      <pc:chgData name="Nakamura, Tomohiko (SEC)" userId="90bdbacb-404b-41f2-9537-6873be5c7ab7" providerId="ADAL" clId="{7E3E65E1-DEC8-4FE4-BA2D-38A63F28DDB2}" dt="2023-09-05T05:33:51.611" v="7155"/>
      <pc:docMkLst>
        <pc:docMk/>
      </pc:docMkLst>
      <pc:sldChg chg="addSp delSp modSp del mod">
        <pc:chgData name="Nakamura, Tomohiko (SEC)" userId="90bdbacb-404b-41f2-9537-6873be5c7ab7" providerId="ADAL" clId="{7E3E65E1-DEC8-4FE4-BA2D-38A63F28DDB2}" dt="2023-08-08T11:35:35.898" v="1085" actId="47"/>
        <pc:sldMkLst>
          <pc:docMk/>
          <pc:sldMk cId="1503556866" sldId="256"/>
        </pc:sldMkLst>
      </pc:sldChg>
      <pc:sldChg chg="addSp delSp modSp mod ord modNotes modNotesTx">
        <pc:chgData name="Nakamura, Tomohiko (SEC)" userId="90bdbacb-404b-41f2-9537-6873be5c7ab7" providerId="ADAL" clId="{7E3E65E1-DEC8-4FE4-BA2D-38A63F28DDB2}" dt="2023-09-05T03:15:05.702" v="7150"/>
        <pc:sldMkLst>
          <pc:docMk/>
          <pc:sldMk cId="2239190444" sldId="257"/>
        </pc:sldMkLst>
      </pc:sldChg>
      <pc:sldChg chg="delSp modSp add del mod modNotesTx">
        <pc:chgData name="Nakamura, Tomohiko (SEC)" userId="90bdbacb-404b-41f2-9537-6873be5c7ab7" providerId="ADAL" clId="{7E3E65E1-DEC8-4FE4-BA2D-38A63F28DDB2}" dt="2023-08-08T11:38:13.536" v="1225" actId="47"/>
        <pc:sldMkLst>
          <pc:docMk/>
          <pc:sldMk cId="317380609" sldId="258"/>
        </pc:sldMkLst>
      </pc:sldChg>
      <pc:sldChg chg="delSp add del mod">
        <pc:chgData name="Nakamura, Tomohiko (SEC)" userId="90bdbacb-404b-41f2-9537-6873be5c7ab7" providerId="ADAL" clId="{7E3E65E1-DEC8-4FE4-BA2D-38A63F28DDB2}" dt="2023-08-08T11:38:14.573" v="1226" actId="47"/>
        <pc:sldMkLst>
          <pc:docMk/>
          <pc:sldMk cId="418305989" sldId="259"/>
        </pc:sldMkLst>
      </pc:sldChg>
      <pc:sldChg chg="addSp delSp modSp add mod modNotesTx">
        <pc:chgData name="Nakamura, Tomohiko (SEC)" userId="90bdbacb-404b-41f2-9537-6873be5c7ab7" providerId="ADAL" clId="{7E3E65E1-DEC8-4FE4-BA2D-38A63F28DDB2}" dt="2023-09-05T04:05:25.029" v="7154" actId="20577"/>
        <pc:sldMkLst>
          <pc:docMk/>
          <pc:sldMk cId="2263633980" sldId="260"/>
        </pc:sldMkLst>
      </pc:sldChg>
      <pc:sldChg chg="addSp delSp modSp add mod modNotesTx">
        <pc:chgData name="Nakamura, Tomohiko (SEC)" userId="90bdbacb-404b-41f2-9537-6873be5c7ab7" providerId="ADAL" clId="{7E3E65E1-DEC8-4FE4-BA2D-38A63F28DDB2}" dt="2023-08-30T02:24:29.259" v="7076" actId="20577"/>
        <pc:sldMkLst>
          <pc:docMk/>
          <pc:sldMk cId="725149520" sldId="261"/>
        </pc:sldMkLst>
      </pc:sldChg>
      <pc:sldChg chg="addSp delSp modSp add del mod modNotesTx">
        <pc:chgData name="Nakamura, Tomohiko (SEC)" userId="90bdbacb-404b-41f2-9537-6873be5c7ab7" providerId="ADAL" clId="{7E3E65E1-DEC8-4FE4-BA2D-38A63F28DDB2}" dt="2023-08-10T02:31:23.679" v="4157" actId="2696"/>
        <pc:sldMkLst>
          <pc:docMk/>
          <pc:sldMk cId="3707819991" sldId="261"/>
        </pc:sldMkLst>
      </pc:sldChg>
      <pc:sldChg chg="addSp delSp modSp add mod modNotes modNotesTx">
        <pc:chgData name="Nakamura, Tomohiko (SEC)" userId="90bdbacb-404b-41f2-9537-6873be5c7ab7" providerId="ADAL" clId="{7E3E65E1-DEC8-4FE4-BA2D-38A63F28DDB2}" dt="2023-09-05T03:14:48.141" v="7149"/>
        <pc:sldMkLst>
          <pc:docMk/>
          <pc:sldMk cId="1198545058" sldId="262"/>
        </pc:sldMkLst>
      </pc:sldChg>
      <pc:sldChg chg="addSp delSp modSp add mod ord modNotesTx">
        <pc:chgData name="Nakamura, Tomohiko (SEC)" userId="90bdbacb-404b-41f2-9537-6873be5c7ab7" providerId="ADAL" clId="{7E3E65E1-DEC8-4FE4-BA2D-38A63F28DDB2}" dt="2023-09-05T03:14:09.448" v="7144" actId="20577"/>
        <pc:sldMkLst>
          <pc:docMk/>
          <pc:sldMk cId="114613011" sldId="263"/>
        </pc:sldMkLst>
      </pc:sldChg>
      <pc:sldChg chg="modSp add mod modNotes modNotesTx">
        <pc:chgData name="Nakamura, Tomohiko (SEC)" userId="90bdbacb-404b-41f2-9537-6873be5c7ab7" providerId="ADAL" clId="{7E3E65E1-DEC8-4FE4-BA2D-38A63F28DDB2}" dt="2023-09-05T03:15:05.702" v="7150"/>
        <pc:sldMkLst>
          <pc:docMk/>
          <pc:sldMk cId="1641502360" sldId="264"/>
        </pc:sldMkLst>
      </pc:sldChg>
      <pc:sldChg chg="delSp modSp add mod modNotes">
        <pc:chgData name="Nakamura, Tomohiko (SEC)" userId="90bdbacb-404b-41f2-9537-6873be5c7ab7" providerId="ADAL" clId="{7E3E65E1-DEC8-4FE4-BA2D-38A63F28DDB2}" dt="2023-09-05T03:15:05.702" v="7150"/>
        <pc:sldMkLst>
          <pc:docMk/>
          <pc:sldMk cId="514996892" sldId="265"/>
        </pc:sldMkLst>
      </pc:sldChg>
      <pc:sldChg chg="add modNotes">
        <pc:chgData name="Nakamura, Tomohiko (SEC)" userId="90bdbacb-404b-41f2-9537-6873be5c7ab7" providerId="ADAL" clId="{7E3E65E1-DEC8-4FE4-BA2D-38A63F28DDB2}" dt="2023-09-05T03:15:05.702" v="7150"/>
        <pc:sldMkLst>
          <pc:docMk/>
          <pc:sldMk cId="1275763734" sldId="266"/>
        </pc:sldMkLst>
      </pc:sldChg>
      <pc:sldChg chg="add">
        <pc:chgData name="Nakamura, Tomohiko (SEC)" userId="90bdbacb-404b-41f2-9537-6873be5c7ab7" providerId="ADAL" clId="{7E3E65E1-DEC8-4FE4-BA2D-38A63F28DDB2}" dt="2023-08-29T05:15:01.712" v="4592"/>
        <pc:sldMkLst>
          <pc:docMk/>
          <pc:sldMk cId="3666449480" sldId="267"/>
        </pc:sldMkLst>
      </pc:sldChg>
      <pc:sldChg chg="add ord modNotes">
        <pc:chgData name="Nakamura, Tomohiko (SEC)" userId="90bdbacb-404b-41f2-9537-6873be5c7ab7" providerId="ADAL" clId="{7E3E65E1-DEC8-4FE4-BA2D-38A63F28DDB2}" dt="2023-09-05T03:15:05.702" v="7150"/>
        <pc:sldMkLst>
          <pc:docMk/>
          <pc:sldMk cId="1754442231" sldId="268"/>
        </pc:sldMkLst>
      </pc:sldChg>
      <pc:sldChg chg="addSp delSp modSp add mod ord modNotes modNotesTx">
        <pc:chgData name="Nakamura, Tomohiko (SEC)" userId="90bdbacb-404b-41f2-9537-6873be5c7ab7" providerId="ADAL" clId="{7E3E65E1-DEC8-4FE4-BA2D-38A63F28DDB2}" dt="2023-09-05T03:15:05.702" v="7150"/>
        <pc:sldMkLst>
          <pc:docMk/>
          <pc:sldMk cId="2459489055" sldId="269"/>
        </pc:sldMkLst>
      </pc:sldChg>
      <pc:sldChg chg="add del">
        <pc:chgData name="Nakamura, Tomohiko (SEC)" userId="90bdbacb-404b-41f2-9537-6873be5c7ab7" providerId="ADAL" clId="{7E3E65E1-DEC8-4FE4-BA2D-38A63F28DDB2}" dt="2023-08-30T01:20:12.777" v="5108" actId="47"/>
        <pc:sldMkLst>
          <pc:docMk/>
          <pc:sldMk cId="1729738240" sldId="270"/>
        </pc:sldMkLst>
      </pc:sldChg>
      <pc:sldChg chg="addSp delSp modSp add del mod modNotesTx">
        <pc:chgData name="Nakamura, Tomohiko (SEC)" userId="90bdbacb-404b-41f2-9537-6873be5c7ab7" providerId="ADAL" clId="{7E3E65E1-DEC8-4FE4-BA2D-38A63F28DDB2}" dt="2023-08-30T01:52:59.958" v="6329" actId="47"/>
        <pc:sldMkLst>
          <pc:docMk/>
          <pc:sldMk cId="3617139141" sldId="270"/>
        </pc:sldMkLst>
      </pc:sldChg>
      <pc:sldChg chg="add del">
        <pc:chgData name="Nakamura, Tomohiko (SEC)" userId="90bdbacb-404b-41f2-9537-6873be5c7ab7" providerId="ADAL" clId="{7E3E65E1-DEC8-4FE4-BA2D-38A63F28DDB2}" dt="2023-08-30T02:04:01.094" v="6729" actId="47"/>
        <pc:sldMkLst>
          <pc:docMk/>
          <pc:sldMk cId="199408816" sldId="271"/>
        </pc:sldMkLst>
      </pc:sldChg>
      <pc:sldChg chg="addSp delSp modSp add mod modNotesTx">
        <pc:chgData name="Nakamura, Tomohiko (SEC)" userId="90bdbacb-404b-41f2-9537-6873be5c7ab7" providerId="ADAL" clId="{7E3E65E1-DEC8-4FE4-BA2D-38A63F28DDB2}" dt="2023-09-05T04:05:16.514" v="7152" actId="20577"/>
        <pc:sldMkLst>
          <pc:docMk/>
          <pc:sldMk cId="3780817493" sldId="272"/>
        </pc:sldMkLst>
      </pc:sldChg>
      <pc:sldChg chg="add">
        <pc:chgData name="Nakamura, Tomohiko (SEC)" userId="90bdbacb-404b-41f2-9537-6873be5c7ab7" providerId="ADAL" clId="{7E3E65E1-DEC8-4FE4-BA2D-38A63F28DDB2}" dt="2023-09-05T05:33:51.611" v="7155"/>
        <pc:sldMkLst>
          <pc:docMk/>
          <pc:sldMk cId="2716657899" sldId="273"/>
        </pc:sldMkLst>
      </pc:sldChg>
    </pc:docChg>
  </pc:docChgLst>
  <pc:docChgLst>
    <pc:chgData name="Noe Kaneko" userId="f008250d-f64f-4eff-b87c-a229df23f8a4" providerId="ADAL" clId="{6207FCF7-DFF0-49DF-9F28-B51910A4A963}"/>
    <pc:docChg chg="custSel delSld modSld">
      <pc:chgData name="Noe Kaneko" userId="f008250d-f64f-4eff-b87c-a229df23f8a4" providerId="ADAL" clId="{6207FCF7-DFF0-49DF-9F28-B51910A4A963}" dt="2023-12-26T07:51:51.693" v="53" actId="20577"/>
      <pc:docMkLst>
        <pc:docMk/>
      </pc:docMkLst>
      <pc:sldChg chg="addSp delSp modSp mod">
        <pc:chgData name="Noe Kaneko" userId="f008250d-f64f-4eff-b87c-a229df23f8a4" providerId="ADAL" clId="{6207FCF7-DFF0-49DF-9F28-B51910A4A963}" dt="2023-12-26T07:51:51.693" v="53" actId="20577"/>
        <pc:sldMkLst>
          <pc:docMk/>
          <pc:sldMk cId="5918549" sldId="286"/>
        </pc:sldMkLst>
      </pc:sldChg>
      <pc:sldChg chg="addSp delSp modSp mod">
        <pc:chgData name="Noe Kaneko" userId="f008250d-f64f-4eff-b87c-a229df23f8a4" providerId="ADAL" clId="{6207FCF7-DFF0-49DF-9F28-B51910A4A963}" dt="2023-12-26T07:51:40.736" v="35" actId="20577"/>
        <pc:sldMkLst>
          <pc:docMk/>
          <pc:sldMk cId="1544269567" sldId="292"/>
        </pc:sldMkLst>
      </pc:sldChg>
      <pc:sldChg chg="del">
        <pc:chgData name="Noe Kaneko" userId="f008250d-f64f-4eff-b87c-a229df23f8a4" providerId="ADAL" clId="{6207FCF7-DFF0-49DF-9F28-B51910A4A963}" dt="2023-12-26T06:44:51.310" v="0" actId="47"/>
        <pc:sldMkLst>
          <pc:docMk/>
          <pc:sldMk cId="3765421031" sldId="293"/>
        </pc:sldMkLst>
      </pc:sldChg>
    </pc:docChg>
  </pc:docChgLst>
  <pc:docChgLst>
    <pc:chgData name="Nakamura, Tomohiko (SEC)" userId="90bdbacb-404b-41f2-9537-6873be5c7ab7" providerId="ADAL" clId="{F931E7D1-DEA5-46F7-9972-DD74A6BE25E9}"/>
    <pc:docChg chg="modSld sldOrd">
      <pc:chgData name="Nakamura, Tomohiko (SEC)" userId="90bdbacb-404b-41f2-9537-6873be5c7ab7" providerId="ADAL" clId="{F931E7D1-DEA5-46F7-9972-DD74A6BE25E9}" dt="2024-10-29T00:49:04.946" v="26" actId="122"/>
      <pc:docMkLst>
        <pc:docMk/>
      </pc:docMkLst>
      <pc:sldChg chg="modSp mod">
        <pc:chgData name="Nakamura, Tomohiko (SEC)" userId="90bdbacb-404b-41f2-9537-6873be5c7ab7" providerId="ADAL" clId="{F931E7D1-DEA5-46F7-9972-DD74A6BE25E9}" dt="2024-10-29T00:49:04.946" v="26" actId="122"/>
        <pc:sldMkLst>
          <pc:docMk/>
          <pc:sldMk cId="3522346926" sldId="307"/>
        </pc:sldMkLst>
      </pc:sldChg>
      <pc:sldChg chg="ord">
        <pc:chgData name="Nakamura, Tomohiko (SEC)" userId="90bdbacb-404b-41f2-9537-6873be5c7ab7" providerId="ADAL" clId="{F931E7D1-DEA5-46F7-9972-DD74A6BE25E9}" dt="2024-10-29T00:35:45.596" v="0" actId="20578"/>
        <pc:sldMkLst>
          <pc:docMk/>
          <pc:sldMk cId="4113844467" sldId="311"/>
        </pc:sldMkLst>
      </pc:sldChg>
    </pc:docChg>
  </pc:docChgLst>
  <pc:docChgLst>
    <pc:chgData name="倉田　盛人" userId="S::kurata.pth2_tmd.ac.jp#ext#@sony.onmicrosoft.com::f9aa91ed-df94-4f44-8f34-dca0266f4e12" providerId="AD" clId="Web-{A2F520A0-614A-73B3-EBC6-CEB491C925FD}"/>
    <pc:docChg chg="sldOrd">
      <pc:chgData name="倉田　盛人" userId="S::kurata.pth2_tmd.ac.jp#ext#@sony.onmicrosoft.com::f9aa91ed-df94-4f44-8f34-dca0266f4e12" providerId="AD" clId="Web-{A2F520A0-614A-73B3-EBC6-CEB491C925FD}" dt="2024-04-16T05:41:50.727" v="4"/>
      <pc:docMkLst>
        <pc:docMk/>
      </pc:docMkLst>
      <pc:sldChg chg="ord">
        <pc:chgData name="倉田　盛人" userId="S::kurata.pth2_tmd.ac.jp#ext#@sony.onmicrosoft.com::f9aa91ed-df94-4f44-8f34-dca0266f4e12" providerId="AD" clId="Web-{A2F520A0-614A-73B3-EBC6-CEB491C925FD}" dt="2024-04-16T05:41:50.727" v="4"/>
        <pc:sldMkLst>
          <pc:docMk/>
          <pc:sldMk cId="3522346926" sldId="307"/>
        </pc:sldMkLst>
      </pc:sldChg>
    </pc:docChg>
  </pc:docChgLst>
  <pc:docChgLst>
    <pc:chgData name="Kaneko, Noe (SEC)" userId="f008250d-f64f-4eff-b87c-a229df23f8a4" providerId="ADAL" clId="{A97330CB-159F-4552-92FD-D726B84E12A1}"/>
    <pc:docChg chg="undo custSel addSld delSld modSld">
      <pc:chgData name="Kaneko, Noe (SEC)" userId="f008250d-f64f-4eff-b87c-a229df23f8a4" providerId="ADAL" clId="{A97330CB-159F-4552-92FD-D726B84E12A1}" dt="2024-01-31T09:28:38.141" v="209" actId="1076"/>
      <pc:docMkLst>
        <pc:docMk/>
      </pc:docMkLst>
      <pc:sldChg chg="addSp delSp modSp mod">
        <pc:chgData name="Kaneko, Noe (SEC)" userId="f008250d-f64f-4eff-b87c-a229df23f8a4" providerId="ADAL" clId="{A97330CB-159F-4552-92FD-D726B84E12A1}" dt="2024-01-30T09:55:58.558" v="129" actId="1076"/>
        <pc:sldMkLst>
          <pc:docMk/>
          <pc:sldMk cId="415996067" sldId="271"/>
        </pc:sldMkLst>
      </pc:sldChg>
      <pc:sldChg chg="addSp delSp modSp mod">
        <pc:chgData name="Kaneko, Noe (SEC)" userId="f008250d-f64f-4eff-b87c-a229df23f8a4" providerId="ADAL" clId="{A97330CB-159F-4552-92FD-D726B84E12A1}" dt="2024-01-30T10:13:06.769" v="190" actId="732"/>
        <pc:sldMkLst>
          <pc:docMk/>
          <pc:sldMk cId="2529814187" sldId="297"/>
        </pc:sldMkLst>
      </pc:sldChg>
      <pc:sldChg chg="addSp delSp modSp mod">
        <pc:chgData name="Kaneko, Noe (SEC)" userId="f008250d-f64f-4eff-b87c-a229df23f8a4" providerId="ADAL" clId="{A97330CB-159F-4552-92FD-D726B84E12A1}" dt="2024-01-31T09:28:38.141" v="209" actId="1076"/>
        <pc:sldMkLst>
          <pc:docMk/>
          <pc:sldMk cId="633908724" sldId="304"/>
        </pc:sldMkLst>
      </pc:sldChg>
      <pc:sldChg chg="add del mod modShow">
        <pc:chgData name="Kaneko, Noe (SEC)" userId="f008250d-f64f-4eff-b87c-a229df23f8a4" providerId="ADAL" clId="{A97330CB-159F-4552-92FD-D726B84E12A1}" dt="2024-01-30T09:56:11.995" v="130" actId="47"/>
        <pc:sldMkLst>
          <pc:docMk/>
          <pc:sldMk cId="1204904516" sldId="304"/>
        </pc:sldMkLst>
      </pc:sldChg>
    </pc:docChg>
  </pc:docChgLst>
  <pc:docChgLst>
    <pc:chgData name="Kenji Ikeda" userId="810681ac-ed82-4234-a9fb-9eadd97fd5df" providerId="ADAL" clId="{377D3FB2-D3FE-41E9-ACF8-E7C190365900}"/>
    <pc:docChg chg="custSel addSld modSld">
      <pc:chgData name="Kenji Ikeda" userId="810681ac-ed82-4234-a9fb-9eadd97fd5df" providerId="ADAL" clId="{377D3FB2-D3FE-41E9-ACF8-E7C190365900}" dt="2023-11-27T05:17:09.490" v="23" actId="1582"/>
      <pc:docMkLst>
        <pc:docMk/>
      </pc:docMkLst>
      <pc:sldChg chg="mod modShow">
        <pc:chgData name="Kenji Ikeda" userId="810681ac-ed82-4234-a9fb-9eadd97fd5df" providerId="ADAL" clId="{377D3FB2-D3FE-41E9-ACF8-E7C190365900}" dt="2023-11-27T05:10:00.495" v="14" actId="729"/>
        <pc:sldMkLst>
          <pc:docMk/>
          <pc:sldMk cId="1618462788" sldId="294"/>
        </pc:sldMkLst>
      </pc:sldChg>
      <pc:sldChg chg="addSp delSp modSp add mod">
        <pc:chgData name="Kenji Ikeda" userId="810681ac-ed82-4234-a9fb-9eadd97fd5df" providerId="ADAL" clId="{377D3FB2-D3FE-41E9-ACF8-E7C190365900}" dt="2023-11-27T05:17:09.490" v="23" actId="1582"/>
        <pc:sldMkLst>
          <pc:docMk/>
          <pc:sldMk cId="1168303320" sldId="296"/>
        </pc:sldMkLst>
      </pc:sldChg>
    </pc:docChg>
  </pc:docChgLst>
  <pc:docChgLst>
    <pc:chgData name="Nakamura, Tomohiko (SEC)" userId="90bdbacb-404b-41f2-9537-6873be5c7ab7" providerId="ADAL" clId="{88F6DCFE-6EA6-43E8-9202-EA4F7BB1736D}"/>
    <pc:docChg chg="modSld">
      <pc:chgData name="Nakamura, Tomohiko (SEC)" userId="90bdbacb-404b-41f2-9537-6873be5c7ab7" providerId="ADAL" clId="{88F6DCFE-6EA6-43E8-9202-EA4F7BB1736D}" dt="2025-03-27T00:05:43.245" v="6" actId="20577"/>
      <pc:docMkLst>
        <pc:docMk/>
      </pc:docMkLst>
      <pc:sldChg chg="modSp mod">
        <pc:chgData name="Nakamura, Tomohiko (SEC)" userId="90bdbacb-404b-41f2-9537-6873be5c7ab7" providerId="ADAL" clId="{88F6DCFE-6EA6-43E8-9202-EA4F7BB1736D}" dt="2025-03-27T00:05:01.896" v="0" actId="207"/>
        <pc:sldMkLst>
          <pc:docMk/>
          <pc:sldMk cId="2857622161" sldId="300"/>
        </pc:sldMkLst>
      </pc:sldChg>
      <pc:sldChg chg="modSp mod">
        <pc:chgData name="Nakamura, Tomohiko (SEC)" userId="90bdbacb-404b-41f2-9537-6873be5c7ab7" providerId="ADAL" clId="{88F6DCFE-6EA6-43E8-9202-EA4F7BB1736D}" dt="2025-03-27T00:05:43.245" v="6" actId="20577"/>
        <pc:sldMkLst>
          <pc:docMk/>
          <pc:sldMk cId="1576618249" sldId="301"/>
        </pc:sldMkLst>
      </pc:sldChg>
    </pc:docChg>
  </pc:docChgLst>
  <pc:docChgLst>
    <pc:chgData name="Noe" userId="f008250d-f64f-4eff-b87c-a229df23f8a4" providerId="ADAL" clId="{48A4E8E2-D923-4712-8C91-8174DE937673}"/>
    <pc:docChg chg="undo redo custSel addSld delSld modSld">
      <pc:chgData name="Noe" userId="f008250d-f64f-4eff-b87c-a229df23f8a4" providerId="ADAL" clId="{48A4E8E2-D923-4712-8C91-8174DE937673}" dt="2023-11-20T09:43:09.482" v="190" actId="20577"/>
      <pc:docMkLst>
        <pc:docMk/>
      </pc:docMkLst>
      <pc:sldChg chg="addSp delSp modSp mod">
        <pc:chgData name="Noe" userId="f008250d-f64f-4eff-b87c-a229df23f8a4" providerId="ADAL" clId="{48A4E8E2-D923-4712-8C91-8174DE937673}" dt="2023-11-20T09:15:51.032" v="87" actId="1076"/>
        <pc:sldMkLst>
          <pc:docMk/>
          <pc:sldMk cId="5918549" sldId="286"/>
        </pc:sldMkLst>
      </pc:sldChg>
      <pc:sldChg chg="addSp delSp modSp mod">
        <pc:chgData name="Noe" userId="f008250d-f64f-4eff-b87c-a229df23f8a4" providerId="ADAL" clId="{48A4E8E2-D923-4712-8C91-8174DE937673}" dt="2023-11-20T09:21:16.082" v="145" actId="404"/>
        <pc:sldMkLst>
          <pc:docMk/>
          <pc:sldMk cId="2943963590" sldId="288"/>
        </pc:sldMkLst>
      </pc:sldChg>
      <pc:sldChg chg="modSp add del mod">
        <pc:chgData name="Noe" userId="f008250d-f64f-4eff-b87c-a229df23f8a4" providerId="ADAL" clId="{48A4E8E2-D923-4712-8C91-8174DE937673}" dt="2023-11-17T10:18:14.845" v="46" actId="47"/>
        <pc:sldMkLst>
          <pc:docMk/>
          <pc:sldMk cId="1000703781" sldId="292"/>
        </pc:sldMkLst>
      </pc:sldChg>
      <pc:sldChg chg="addSp delSp modSp mod">
        <pc:chgData name="Noe" userId="f008250d-f64f-4eff-b87c-a229df23f8a4" providerId="ADAL" clId="{48A4E8E2-D923-4712-8C91-8174DE937673}" dt="2023-11-20T09:36:42.956" v="183" actId="478"/>
        <pc:sldMkLst>
          <pc:docMk/>
          <pc:sldMk cId="1544269567" sldId="292"/>
        </pc:sldMkLst>
      </pc:sldChg>
      <pc:sldChg chg="delSp modSp add mod">
        <pc:chgData name="Noe" userId="f008250d-f64f-4eff-b87c-a229df23f8a4" providerId="ADAL" clId="{48A4E8E2-D923-4712-8C91-8174DE937673}" dt="2023-11-20T09:43:09.482" v="190" actId="20577"/>
        <pc:sldMkLst>
          <pc:docMk/>
          <pc:sldMk cId="21367330" sldId="29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73F9E1-E227-4DA7-BBB4-A60BA67E64D5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899144-A85B-4FD7-B7B8-C8DFF53D10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17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ja-JP" altLang="en-US">
              <a:ea typeface="游ゴシック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899144-A85B-4FD7-B7B8-C8DFF53D10AB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0976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899144-A85B-4FD7-B7B8-C8DFF53D10AB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5415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9899144-A85B-4FD7-B7B8-C8DFF53D10A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3172794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899144-A85B-4FD7-B7B8-C8DFF53D10AB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54157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C67479F-2986-705E-754F-172335F869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48EA01A-731D-A87F-B671-A7D3FD365E0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B759597-E9EE-8A71-746C-A62BE3A86CD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6E1AB7A-876E-B02D-8F67-87D73009B6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899144-A85B-4FD7-B7B8-C8DFF53D10AB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154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725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4256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05364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31" indent="0" algn="ctr">
              <a:buNone/>
              <a:defRPr sz="1385"/>
            </a:lvl2pPr>
            <a:lvl3pPr marL="633062" indent="0" algn="ctr">
              <a:buNone/>
              <a:defRPr sz="1246"/>
            </a:lvl3pPr>
            <a:lvl4pPr marL="949593" indent="0" algn="ctr">
              <a:buNone/>
              <a:defRPr sz="1108"/>
            </a:lvl4pPr>
            <a:lvl5pPr marL="1266124" indent="0" algn="ctr">
              <a:buNone/>
              <a:defRPr sz="1108"/>
            </a:lvl5pPr>
            <a:lvl6pPr marL="1582655" indent="0" algn="ctr">
              <a:buNone/>
              <a:defRPr sz="1108"/>
            </a:lvl6pPr>
            <a:lvl7pPr marL="1899186" indent="0" algn="ctr">
              <a:buNone/>
              <a:defRPr sz="1108"/>
            </a:lvl7pPr>
            <a:lvl8pPr marL="2215717" indent="0" algn="ctr">
              <a:buNone/>
              <a:defRPr sz="1108"/>
            </a:lvl8pPr>
            <a:lvl9pPr marL="2532248" indent="0" algn="ctr">
              <a:buNone/>
              <a:defRPr sz="1108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467831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12884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4"/>
            <a:ext cx="5915025" cy="3803649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6"/>
            <a:ext cx="5915025" cy="2000249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31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62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93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124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655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8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7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24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473700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728068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31" indent="0">
              <a:buNone/>
              <a:defRPr sz="1385" b="1"/>
            </a:lvl2pPr>
            <a:lvl3pPr marL="633062" indent="0">
              <a:buNone/>
              <a:defRPr sz="1246" b="1"/>
            </a:lvl3pPr>
            <a:lvl4pPr marL="949593" indent="0">
              <a:buNone/>
              <a:defRPr sz="1108" b="1"/>
            </a:lvl4pPr>
            <a:lvl5pPr marL="1266124" indent="0">
              <a:buNone/>
              <a:defRPr sz="1108" b="1"/>
            </a:lvl5pPr>
            <a:lvl6pPr marL="1582655" indent="0">
              <a:buNone/>
              <a:defRPr sz="1108" b="1"/>
            </a:lvl6pPr>
            <a:lvl7pPr marL="1899186" indent="0">
              <a:buNone/>
              <a:defRPr sz="1108" b="1"/>
            </a:lvl7pPr>
            <a:lvl8pPr marL="2215717" indent="0">
              <a:buNone/>
              <a:defRPr sz="1108" b="1"/>
            </a:lvl8pPr>
            <a:lvl9pPr marL="2532248" indent="0">
              <a:buNone/>
              <a:defRPr sz="11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2"/>
            <a:ext cx="2915543" cy="1098549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31" indent="0">
              <a:buNone/>
              <a:defRPr sz="1385" b="1"/>
            </a:lvl2pPr>
            <a:lvl3pPr marL="633062" indent="0">
              <a:buNone/>
              <a:defRPr sz="1246" b="1"/>
            </a:lvl3pPr>
            <a:lvl4pPr marL="949593" indent="0">
              <a:buNone/>
              <a:defRPr sz="1108" b="1"/>
            </a:lvl4pPr>
            <a:lvl5pPr marL="1266124" indent="0">
              <a:buNone/>
              <a:defRPr sz="1108" b="1"/>
            </a:lvl5pPr>
            <a:lvl6pPr marL="1582655" indent="0">
              <a:buNone/>
              <a:defRPr sz="1108" b="1"/>
            </a:lvl6pPr>
            <a:lvl7pPr marL="1899186" indent="0">
              <a:buNone/>
              <a:defRPr sz="1108" b="1"/>
            </a:lvl7pPr>
            <a:lvl8pPr marL="2215717" indent="0">
              <a:buNone/>
              <a:defRPr sz="1108" b="1"/>
            </a:lvl8pPr>
            <a:lvl9pPr marL="2532248" indent="0">
              <a:buNone/>
              <a:defRPr sz="110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1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77503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79907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57245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0"/>
            <a:ext cx="3471863" cy="6498167"/>
          </a:xfrm>
        </p:spPr>
        <p:txBody>
          <a:bodyPr/>
          <a:lstStyle>
            <a:lvl1pPr>
              <a:defRPr sz="2215"/>
            </a:lvl1pPr>
            <a:lvl2pPr>
              <a:defRPr sz="1939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108"/>
            </a:lvl1pPr>
            <a:lvl2pPr marL="316531" indent="0">
              <a:buNone/>
              <a:defRPr sz="969"/>
            </a:lvl2pPr>
            <a:lvl3pPr marL="633062" indent="0">
              <a:buNone/>
              <a:defRPr sz="831"/>
            </a:lvl3pPr>
            <a:lvl4pPr marL="949593" indent="0">
              <a:buNone/>
              <a:defRPr sz="692"/>
            </a:lvl4pPr>
            <a:lvl5pPr marL="1266124" indent="0">
              <a:buNone/>
              <a:defRPr sz="692"/>
            </a:lvl5pPr>
            <a:lvl6pPr marL="1582655" indent="0">
              <a:buNone/>
              <a:defRPr sz="692"/>
            </a:lvl6pPr>
            <a:lvl7pPr marL="1899186" indent="0">
              <a:buNone/>
              <a:defRPr sz="692"/>
            </a:lvl7pPr>
            <a:lvl8pPr marL="2215717" indent="0">
              <a:buNone/>
              <a:defRPr sz="692"/>
            </a:lvl8pPr>
            <a:lvl9pPr marL="2532248" indent="0">
              <a:buNone/>
              <a:defRPr sz="6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698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5333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0"/>
            <a:ext cx="3471863" cy="6498167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31" indent="0">
              <a:buNone/>
              <a:defRPr sz="1939"/>
            </a:lvl2pPr>
            <a:lvl3pPr marL="633062" indent="0">
              <a:buNone/>
              <a:defRPr sz="1662"/>
            </a:lvl3pPr>
            <a:lvl4pPr marL="949593" indent="0">
              <a:buNone/>
              <a:defRPr sz="1385"/>
            </a:lvl4pPr>
            <a:lvl5pPr marL="1266124" indent="0">
              <a:buNone/>
              <a:defRPr sz="1385"/>
            </a:lvl5pPr>
            <a:lvl6pPr marL="1582655" indent="0">
              <a:buNone/>
              <a:defRPr sz="1385"/>
            </a:lvl6pPr>
            <a:lvl7pPr marL="1899186" indent="0">
              <a:buNone/>
              <a:defRPr sz="1385"/>
            </a:lvl7pPr>
            <a:lvl8pPr marL="2215717" indent="0">
              <a:buNone/>
              <a:defRPr sz="1385"/>
            </a:lvl8pPr>
            <a:lvl9pPr marL="2532248" indent="0">
              <a:buNone/>
              <a:defRPr sz="1385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108"/>
            </a:lvl1pPr>
            <a:lvl2pPr marL="316531" indent="0">
              <a:buNone/>
              <a:defRPr sz="969"/>
            </a:lvl2pPr>
            <a:lvl3pPr marL="633062" indent="0">
              <a:buNone/>
              <a:defRPr sz="831"/>
            </a:lvl3pPr>
            <a:lvl4pPr marL="949593" indent="0">
              <a:buNone/>
              <a:defRPr sz="692"/>
            </a:lvl4pPr>
            <a:lvl5pPr marL="1266124" indent="0">
              <a:buNone/>
              <a:defRPr sz="692"/>
            </a:lvl5pPr>
            <a:lvl6pPr marL="1582655" indent="0">
              <a:buNone/>
              <a:defRPr sz="692"/>
            </a:lvl6pPr>
            <a:lvl7pPr marL="1899186" indent="0">
              <a:buNone/>
              <a:defRPr sz="692"/>
            </a:lvl7pPr>
            <a:lvl8pPr marL="2215717" indent="0">
              <a:buNone/>
              <a:defRPr sz="692"/>
            </a:lvl8pPr>
            <a:lvl9pPr marL="2532248" indent="0">
              <a:buNone/>
              <a:defRPr sz="6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970138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2440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5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5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5456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9490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4098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536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37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584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098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699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5812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4E56F-3324-4899-853E-234AF84E16D3}" type="datetimeFigureOut">
              <a:rPr kumimoji="1" lang="ja-JP" altLang="en-US" smtClean="0"/>
              <a:t>2025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5F8BA-E141-4FD0-BFAC-AC9EA22FC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6610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33062" rtl="0" eaLnBrk="1" latinLnBrk="0" hangingPunct="1">
        <a:lnSpc>
          <a:spcPct val="90000"/>
        </a:lnSpc>
        <a:spcBef>
          <a:spcPct val="0"/>
        </a:spcBef>
        <a:buNone/>
        <a:defRPr kumimoji="1"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5" indent="-158265" algn="l" defTabSz="633062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kumimoji="1" sz="1939" kern="1200">
          <a:solidFill>
            <a:schemeClr val="tx1"/>
          </a:solidFill>
          <a:latin typeface="+mn-lt"/>
          <a:ea typeface="+mn-ea"/>
          <a:cs typeface="+mn-cs"/>
        </a:defRPr>
      </a:lvl1pPr>
      <a:lvl2pPr marL="474796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327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58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89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920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451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982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513" indent="-158265" algn="l" defTabSz="633062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31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62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93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124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655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86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717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248" algn="l" defTabSz="633062" rtl="0" eaLnBrk="1" latinLnBrk="0" hangingPunct="1">
        <a:defRPr kumimoji="1"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openxmlformats.org/officeDocument/2006/relationships/image" Target="../media/image14.jpeg"/><Relationship Id="rId18" Type="http://schemas.openxmlformats.org/officeDocument/2006/relationships/image" Target="../media/image19.jpeg"/><Relationship Id="rId3" Type="http://schemas.openxmlformats.org/officeDocument/2006/relationships/image" Target="../media/image4.jpeg"/><Relationship Id="rId21" Type="http://schemas.openxmlformats.org/officeDocument/2006/relationships/image" Target="../media/image22.jpe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17" Type="http://schemas.openxmlformats.org/officeDocument/2006/relationships/image" Target="../media/image18.jpe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7.jpeg"/><Relationship Id="rId20" Type="http://schemas.openxmlformats.org/officeDocument/2006/relationships/image" Target="../media/image2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24" Type="http://schemas.openxmlformats.org/officeDocument/2006/relationships/image" Target="../media/image25.jpeg"/><Relationship Id="rId5" Type="http://schemas.openxmlformats.org/officeDocument/2006/relationships/image" Target="../media/image6.jpeg"/><Relationship Id="rId15" Type="http://schemas.openxmlformats.org/officeDocument/2006/relationships/image" Target="../media/image16.jpeg"/><Relationship Id="rId23" Type="http://schemas.openxmlformats.org/officeDocument/2006/relationships/image" Target="../media/image24.jpeg"/><Relationship Id="rId10" Type="http://schemas.openxmlformats.org/officeDocument/2006/relationships/image" Target="../media/image11.jpeg"/><Relationship Id="rId19" Type="http://schemas.openxmlformats.org/officeDocument/2006/relationships/image" Target="../media/image20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Relationship Id="rId14" Type="http://schemas.openxmlformats.org/officeDocument/2006/relationships/image" Target="../media/image15.jpeg"/><Relationship Id="rId22" Type="http://schemas.openxmlformats.org/officeDocument/2006/relationships/image" Target="../media/image23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25D860-AB8D-04AC-73AF-21C1822B5DC0}"/>
              </a:ext>
            </a:extLst>
          </p:cNvPr>
          <p:cNvSpPr txBox="1"/>
          <p:nvPr/>
        </p:nvSpPr>
        <p:spPr>
          <a:xfrm>
            <a:off x="2974651" y="60769"/>
            <a:ext cx="38547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table 1 Nakamura </a:t>
            </a:r>
            <a:r>
              <a:rPr lang="en-US" altLang="ja-JP" i="1"/>
              <a:t>et al.</a:t>
            </a: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78AE8E8-83C9-1264-2709-40D9FB602F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6976179"/>
              </p:ext>
            </p:extLst>
          </p:nvPr>
        </p:nvGraphicFramePr>
        <p:xfrm>
          <a:off x="411473" y="1320925"/>
          <a:ext cx="6220822" cy="2275731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306894">
                  <a:extLst>
                    <a:ext uri="{9D8B030D-6E8A-4147-A177-3AD203B41FA5}">
                      <a16:colId xmlns:a16="http://schemas.microsoft.com/office/drawing/2014/main" val="2352238490"/>
                    </a:ext>
                  </a:extLst>
                </a:gridCol>
                <a:gridCol w="3913928">
                  <a:extLst>
                    <a:ext uri="{9D8B030D-6E8A-4147-A177-3AD203B41FA5}">
                      <a16:colId xmlns:a16="http://schemas.microsoft.com/office/drawing/2014/main" val="515629339"/>
                    </a:ext>
                  </a:extLst>
                </a:gridCol>
              </a:tblGrid>
              <a:tr h="286297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Methods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6963650"/>
                  </a:ext>
                </a:extLst>
              </a:tr>
              <a:tr h="572594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phological observation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pia of lymphoid cells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ss of structure of lymph nodes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580674387"/>
                  </a:ext>
                </a:extLst>
              </a:tr>
              <a:tr h="572594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histochemical analysis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ge decision (CD3-positive), 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errant expression or deletion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57855443"/>
                  </a:ext>
                </a:extLst>
              </a:tr>
              <a:tr h="557949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cytometry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etion of common T-cell surface markers, 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.e.) CD3, CD5, CD7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2370121"/>
                  </a:ext>
                </a:extLst>
              </a:tr>
              <a:tr h="286297"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ic analysis</a:t>
                      </a:r>
                      <a:endParaRPr lang="ja-JP" sz="12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-cell receptor rearrangements</a:t>
                      </a:r>
                      <a:endParaRPr lang="ja-JP" sz="12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955569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ED7F27DD-BE90-E254-A3A1-4C01C8BE23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473" y="674594"/>
            <a:ext cx="520225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ntal table 1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ndings for the diagnosis of general T-cell lymphoma</a:t>
            </a:r>
            <a:endParaRPr kumimoji="0" lang="en-US" altLang="ja-JP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7622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E015F0E-71DE-7D6E-2A7F-FE6F7EB4A9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4964075"/>
              </p:ext>
            </p:extLst>
          </p:nvPr>
        </p:nvGraphicFramePr>
        <p:xfrm>
          <a:off x="198307" y="568180"/>
          <a:ext cx="6578670" cy="4876326"/>
        </p:xfrm>
        <a:graphic>
          <a:graphicData uri="http://schemas.openxmlformats.org/drawingml/2006/table">
            <a:tbl>
              <a:tblPr/>
              <a:tblGrid>
                <a:gridCol w="657867">
                  <a:extLst>
                    <a:ext uri="{9D8B030D-6E8A-4147-A177-3AD203B41FA5}">
                      <a16:colId xmlns:a16="http://schemas.microsoft.com/office/drawing/2014/main" val="1088904712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3828729324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391483412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2714682437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2893332692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3941438333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2829014978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298273313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965940288"/>
                    </a:ext>
                  </a:extLst>
                </a:gridCol>
                <a:gridCol w="657867">
                  <a:extLst>
                    <a:ext uri="{9D8B030D-6E8A-4147-A177-3AD203B41FA5}">
                      <a16:colId xmlns:a16="http://schemas.microsoft.com/office/drawing/2014/main" val="1618270654"/>
                    </a:ext>
                  </a:extLst>
                </a:gridCol>
              </a:tblGrid>
              <a:tr h="123372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5 case list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7802383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sitio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iagnosis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CM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-IF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CM/m-IF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HC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CM/IHC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ytoplasmic CD3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1319609"/>
                  </a:ext>
                </a:extLst>
              </a:tr>
              <a:tr h="12748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CM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-IF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86944988"/>
                  </a:ext>
                </a:extLst>
              </a:tr>
              <a:tr h="1274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IT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971957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-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799202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3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-NOS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1259077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4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/CD5(-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8076700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5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-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987922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6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-NOS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9097430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7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-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0489306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8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xtranodal NK/T 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-)/CD5(-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1082457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9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-NOS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/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5867689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0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nsi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-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/CD5(-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5698355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1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-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2569896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2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-NOS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8634832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3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-NOS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/CD5(-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uspected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3400782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4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-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5947715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5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ITL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0133032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6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/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2448971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7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ITL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2394480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8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TCL-NOS+B-LPD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-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/CD5(-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4850059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19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kin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ITL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010586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0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L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2121989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1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9757839"/>
                  </a:ext>
                </a:extLst>
              </a:tr>
              <a:tr h="1398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2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L and classical Hodgkin Lymphoma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5897236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3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ismatch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1284424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4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L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+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ea typeface="游ゴシック"/>
                        </a:rPr>
                        <a:t>+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5513565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se 25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ymph node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C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D5(+)CD7(-)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0997083"/>
                  </a:ext>
                </a:extLst>
              </a:tr>
              <a:tr h="123372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5931608"/>
                  </a:ext>
                </a:extLst>
              </a:tr>
              <a:tr h="185059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ITL; Angioimmunoblastic T-cell lymphoma, TCL; T-cell lymphoma, C-TCL; cutaneous T-cell lymphoma, PTCL; Peripheral T-cell lymphoma, NOS; Not otherwise special</a:t>
                      </a: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112" marR="4112" marT="41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8815364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F9A605A-870E-EB12-A5E0-5EAFD6E61C88}"/>
              </a:ext>
            </a:extLst>
          </p:cNvPr>
          <p:cNvSpPr txBox="1"/>
          <p:nvPr/>
        </p:nvSpPr>
        <p:spPr>
          <a:xfrm>
            <a:off x="2974651" y="60769"/>
            <a:ext cx="38138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table 2 Nakamura </a:t>
            </a:r>
            <a:r>
              <a:rPr lang="en-US" altLang="ja-JP" i="1"/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15766182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B4F5BFA-0750-432D-F310-4DE3C3FDF44A}"/>
              </a:ext>
            </a:extLst>
          </p:cNvPr>
          <p:cNvSpPr txBox="1"/>
          <p:nvPr/>
        </p:nvSpPr>
        <p:spPr>
          <a:xfrm>
            <a:off x="2333215" y="7488590"/>
            <a:ext cx="3648485" cy="2847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/>
            <a:r>
              <a:rPr kumimoji="1" lang="en-US" altLang="ja-JP" sz="12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Cells exceeding the cutoff value are colored blue</a:t>
            </a:r>
            <a:endParaRPr kumimoji="1" lang="ja-JP" altLang="en-US" sz="12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F3602262-8FDF-7B53-A398-4303F0B0E7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8875" y="1370630"/>
            <a:ext cx="4540250" cy="605017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9A6A1D5-5AE8-F4F0-03E5-A9F62FAA6BAF}"/>
              </a:ext>
            </a:extLst>
          </p:cNvPr>
          <p:cNvSpPr txBox="1"/>
          <p:nvPr/>
        </p:nvSpPr>
        <p:spPr>
          <a:xfrm>
            <a:off x="2974651" y="60769"/>
            <a:ext cx="38138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table 3 Nakamura </a:t>
            </a:r>
            <a:r>
              <a:rPr lang="en-US" altLang="ja-JP" i="1"/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3076979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25D860-AB8D-04AC-73AF-21C1822B5DC0}"/>
              </a:ext>
            </a:extLst>
          </p:cNvPr>
          <p:cNvSpPr txBox="1"/>
          <p:nvPr/>
        </p:nvSpPr>
        <p:spPr>
          <a:xfrm>
            <a:off x="2974651" y="60769"/>
            <a:ext cx="38138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table 4 Nakamura </a:t>
            </a:r>
            <a:r>
              <a:rPr lang="en-US" altLang="ja-JP" i="1"/>
              <a:t>et al.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2CD66CA-DAFC-6F18-D8E0-2B066A77911A}"/>
              </a:ext>
            </a:extLst>
          </p:cNvPr>
          <p:cNvGraphicFramePr>
            <a:graphicFrameLocks noGrp="1"/>
          </p:cNvGraphicFramePr>
          <p:nvPr/>
        </p:nvGraphicFramePr>
        <p:xfrm>
          <a:off x="100759" y="399324"/>
          <a:ext cx="6656482" cy="858673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25276">
                  <a:extLst>
                    <a:ext uri="{9D8B030D-6E8A-4147-A177-3AD203B41FA5}">
                      <a16:colId xmlns:a16="http://schemas.microsoft.com/office/drawing/2014/main" val="2005741087"/>
                    </a:ext>
                  </a:extLst>
                </a:gridCol>
                <a:gridCol w="315100">
                  <a:extLst>
                    <a:ext uri="{9D8B030D-6E8A-4147-A177-3AD203B41FA5}">
                      <a16:colId xmlns:a16="http://schemas.microsoft.com/office/drawing/2014/main" val="1751369600"/>
                    </a:ext>
                  </a:extLst>
                </a:gridCol>
                <a:gridCol w="625276">
                  <a:extLst>
                    <a:ext uri="{9D8B030D-6E8A-4147-A177-3AD203B41FA5}">
                      <a16:colId xmlns:a16="http://schemas.microsoft.com/office/drawing/2014/main" val="3943495449"/>
                    </a:ext>
                  </a:extLst>
                </a:gridCol>
                <a:gridCol w="521204">
                  <a:extLst>
                    <a:ext uri="{9D8B030D-6E8A-4147-A177-3AD203B41FA5}">
                      <a16:colId xmlns:a16="http://schemas.microsoft.com/office/drawing/2014/main" val="1046867241"/>
                    </a:ext>
                  </a:extLst>
                </a:gridCol>
                <a:gridCol w="625033">
                  <a:extLst>
                    <a:ext uri="{9D8B030D-6E8A-4147-A177-3AD203B41FA5}">
                      <a16:colId xmlns:a16="http://schemas.microsoft.com/office/drawing/2014/main" val="1219299464"/>
                    </a:ext>
                  </a:extLst>
                </a:gridCol>
                <a:gridCol w="729591">
                  <a:extLst>
                    <a:ext uri="{9D8B030D-6E8A-4147-A177-3AD203B41FA5}">
                      <a16:colId xmlns:a16="http://schemas.microsoft.com/office/drawing/2014/main" val="3585312118"/>
                    </a:ext>
                  </a:extLst>
                </a:gridCol>
                <a:gridCol w="659371">
                  <a:extLst>
                    <a:ext uri="{9D8B030D-6E8A-4147-A177-3AD203B41FA5}">
                      <a16:colId xmlns:a16="http://schemas.microsoft.com/office/drawing/2014/main" val="614572021"/>
                    </a:ext>
                  </a:extLst>
                </a:gridCol>
                <a:gridCol w="439838">
                  <a:extLst>
                    <a:ext uri="{9D8B030D-6E8A-4147-A177-3AD203B41FA5}">
                      <a16:colId xmlns:a16="http://schemas.microsoft.com/office/drawing/2014/main" val="1300949749"/>
                    </a:ext>
                  </a:extLst>
                </a:gridCol>
                <a:gridCol w="776619">
                  <a:extLst>
                    <a:ext uri="{9D8B030D-6E8A-4147-A177-3AD203B41FA5}">
                      <a16:colId xmlns:a16="http://schemas.microsoft.com/office/drawing/2014/main" val="718294323"/>
                    </a:ext>
                  </a:extLst>
                </a:gridCol>
                <a:gridCol w="647067">
                  <a:extLst>
                    <a:ext uri="{9D8B030D-6E8A-4147-A177-3AD203B41FA5}">
                      <a16:colId xmlns:a16="http://schemas.microsoft.com/office/drawing/2014/main" val="2349612711"/>
                    </a:ext>
                  </a:extLst>
                </a:gridCol>
                <a:gridCol w="692107">
                  <a:extLst>
                    <a:ext uri="{9D8B030D-6E8A-4147-A177-3AD203B41FA5}">
                      <a16:colId xmlns:a16="http://schemas.microsoft.com/office/drawing/2014/main" val="820572178"/>
                    </a:ext>
                  </a:extLst>
                </a:gridCol>
              </a:tblGrid>
              <a:tr h="109802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rimary antibodies</a:t>
                      </a: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9830916"/>
                  </a:ext>
                </a:extLst>
              </a:tr>
              <a:tr h="2172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gur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ne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y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arge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ocatio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l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ncentration </a:t>
                      </a:r>
                      <a:r>
                        <a:rPr lang="el-GR" sz="800" u="none" strike="noStrike">
                          <a:effectLst/>
                        </a:rPr>
                        <a:t>μ</a:t>
                      </a:r>
                      <a:r>
                        <a:rPr lang="en-US" sz="800" u="none" strike="noStrike">
                          <a:effectLst/>
                        </a:rPr>
                        <a:t>g/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peci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anufactur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atalog numb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7831045"/>
                  </a:ext>
                </a:extLst>
              </a:tr>
              <a:tr h="109802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g.4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rs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4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R68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1963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1432710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5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D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AT-1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8086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5329798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5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Ki-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ucle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R36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119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96289884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D-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73-10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374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89708334"/>
                  </a:ext>
                </a:extLst>
              </a:tr>
              <a:tr h="32477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44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260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njugated using labeling k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544167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7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kerat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E1-A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vus Biological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BP2-33200AF7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16487571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7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8-144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ell Signaling Technolog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53912B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6283726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7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KP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anta Cruz Biotechnolog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c-20060-AF79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77110093"/>
                  </a:ext>
                </a:extLst>
              </a:tr>
              <a:tr h="109802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g.4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eco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4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5R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CH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304212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1445708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5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44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085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51704298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D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AT-1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203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9819051"/>
                  </a:ext>
                </a:extLst>
              </a:tr>
              <a:tr h="32477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OX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ucle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P2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4576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onjugated using labeling k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73619268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7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kerat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E1-A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v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BP2-33200AF7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5590810"/>
                  </a:ext>
                </a:extLst>
              </a:tr>
              <a:tr h="109802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g.4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hir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4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R68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19637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8344914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F5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ox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ucle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236A-7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herm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41-4777-82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76126900"/>
                  </a:ext>
                </a:extLst>
              </a:tr>
              <a:tr h="14258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F6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herm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42-0202-82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9094817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8-144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372906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77498123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KP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anta Cruz Biotechnolog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c-20060-AF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6395609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7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kerat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E1-A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vus Biological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BP2-33200AF7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90484917"/>
                  </a:ext>
                </a:extLst>
              </a:tr>
              <a:tr h="10980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g.5-8 I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48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R42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1990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5600792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55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44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085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4516665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F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P295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8535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5234170"/>
                  </a:ext>
                </a:extLst>
              </a:tr>
              <a:tr h="20102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ig.6 B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N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5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67219886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4C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1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718645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P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2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1699424"/>
                  </a:ext>
                </a:extLst>
              </a:tr>
              <a:tr h="201022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upplement Fig. 2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4B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4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3733796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D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AT-1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525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6032340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Ki-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ucle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M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1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215552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D-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73-10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8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04856470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N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5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3237203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kerat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E1-A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0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3579624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4B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1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32477361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514H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2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21962359"/>
                  </a:ext>
                </a:extLst>
              </a:tr>
              <a:tr h="201022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upplement Fig. 2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5R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CH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14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62621325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N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55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4560090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D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AT-1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5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5258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7617394"/>
                  </a:ext>
                </a:extLst>
              </a:tr>
              <a:tr h="10980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OX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ucle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P26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b227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16931510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kerat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E1-A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0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35137210"/>
                  </a:ext>
                </a:extLst>
              </a:tr>
              <a:tr h="201022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upplement Fig. 2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4B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4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4612994"/>
                  </a:ext>
                </a:extLst>
              </a:tr>
              <a:tr h="2172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ox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ucleu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2W8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</a:rPr>
                        <a:t>3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bi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ell Signaling Technolog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98377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7939784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2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9199211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mbra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4B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1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7915264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6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514H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27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36557435"/>
                  </a:ext>
                </a:extLst>
              </a:tr>
              <a:tr h="20102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kerat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ytopla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E1-AE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ady to 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ica Bio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A009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>
                          <a:effectLst/>
                        </a:rPr>
                        <a:t>　</a:t>
                      </a:r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メイリオ" panose="020B0604030504040204" pitchFamily="50" charset="-128"/>
                        <a:cs typeface="Arial" panose="020B0604020202020204" pitchFamily="34" charset="0"/>
                      </a:endParaRPr>
                    </a:p>
                  </a:txBody>
                  <a:tcPr marL="2625" marR="2625" marT="2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122350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94180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D1772F2-3DCE-4EA7-CC20-D1220FC619D5}"/>
              </a:ext>
            </a:extLst>
          </p:cNvPr>
          <p:cNvSpPr txBox="1"/>
          <p:nvPr/>
        </p:nvSpPr>
        <p:spPr>
          <a:xfrm>
            <a:off x="252317" y="761424"/>
            <a:ext cx="316850" cy="3255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978E594-716C-80FD-5DA4-7AB66856E6AF}"/>
              </a:ext>
            </a:extLst>
          </p:cNvPr>
          <p:cNvSpPr txBox="1"/>
          <p:nvPr/>
        </p:nvSpPr>
        <p:spPr>
          <a:xfrm>
            <a:off x="252317" y="6281002"/>
            <a:ext cx="328152" cy="3255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357596B8-4875-0B55-78EA-571A5463F50E}"/>
              </a:ext>
            </a:extLst>
          </p:cNvPr>
          <p:cNvGrpSpPr/>
          <p:nvPr/>
        </p:nvGrpSpPr>
        <p:grpSpPr>
          <a:xfrm>
            <a:off x="471902" y="6466513"/>
            <a:ext cx="4953643" cy="1877964"/>
            <a:chOff x="7254306" y="709616"/>
            <a:chExt cx="2534715" cy="1077387"/>
          </a:xfrm>
        </p:grpSpPr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id="{B21D3FD5-4C9B-D814-B041-06371E82D5B6}"/>
                </a:ext>
              </a:extLst>
            </p:cNvPr>
            <p:cNvGrpSpPr/>
            <p:nvPr/>
          </p:nvGrpSpPr>
          <p:grpSpPr>
            <a:xfrm>
              <a:off x="8101604" y="1045607"/>
              <a:ext cx="755603" cy="706688"/>
              <a:chOff x="8037877" y="1120544"/>
              <a:chExt cx="522407" cy="444741"/>
            </a:xfrm>
          </p:grpSpPr>
          <p:sp>
            <p:nvSpPr>
              <p:cNvPr id="195" name="正方形/長方形 194">
                <a:extLst>
                  <a:ext uri="{FF2B5EF4-FFF2-40B4-BE49-F238E27FC236}">
                    <a16:creationId xmlns:a16="http://schemas.microsoft.com/office/drawing/2014/main" id="{10497C55-F574-846C-3B9A-E6840B9C1099}"/>
                  </a:ext>
                </a:extLst>
              </p:cNvPr>
              <p:cNvSpPr/>
              <p:nvPr/>
            </p:nvSpPr>
            <p:spPr>
              <a:xfrm>
                <a:off x="8037877" y="1120544"/>
                <a:ext cx="522406" cy="444741"/>
              </a:xfrm>
              <a:prstGeom prst="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endParaRPr lang="ja-JP" altLang="en-US" sz="1200">
                  <a:latin typeface="Arial" panose="020B0604020202020204" pitchFamily="34" charset="0"/>
                  <a:ea typeface="メイリオ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96" name="正方形/長方形 195">
                <a:extLst>
                  <a:ext uri="{FF2B5EF4-FFF2-40B4-BE49-F238E27FC236}">
                    <a16:creationId xmlns:a16="http://schemas.microsoft.com/office/drawing/2014/main" id="{36CF2006-8053-D8C5-32FA-326A68C3F9BA}"/>
                  </a:ext>
                </a:extLst>
              </p:cNvPr>
              <p:cNvSpPr/>
              <p:nvPr/>
            </p:nvSpPr>
            <p:spPr>
              <a:xfrm rot="5400000" flipV="1">
                <a:off x="8153149" y="1092555"/>
                <a:ext cx="294262" cy="520008"/>
              </a:xfrm>
              <a:prstGeom prst="rect">
                <a:avLst/>
              </a:prstGeom>
              <a:gradFill>
                <a:gsLst>
                  <a:gs pos="65000">
                    <a:srgbClr val="FFC000"/>
                  </a:gs>
                  <a:gs pos="0">
                    <a:srgbClr val="9933FF"/>
                  </a:gs>
                  <a:gs pos="16000">
                    <a:srgbClr val="0000FF"/>
                  </a:gs>
                  <a:gs pos="39000">
                    <a:srgbClr val="00B050"/>
                  </a:gs>
                  <a:gs pos="90000">
                    <a:srgbClr val="FF0000"/>
                  </a:gs>
                </a:gsLst>
                <a:lin ang="0" scaled="1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endParaRPr lang="ja-JP" altLang="en-US" sz="1200">
                  <a:latin typeface="Arial" panose="020B0604020202020204" pitchFamily="34" charset="0"/>
                  <a:ea typeface="メイリオ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E255815B-8BF0-3552-2D22-BCD10FF59A62}"/>
                </a:ext>
              </a:extLst>
            </p:cNvPr>
            <p:cNvSpPr txBox="1"/>
            <p:nvPr/>
          </p:nvSpPr>
          <p:spPr>
            <a:xfrm>
              <a:off x="7254306" y="1265168"/>
              <a:ext cx="1059405" cy="1589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pectral information</a:t>
              </a:r>
            </a:p>
          </p:txBody>
        </p:sp>
        <p:cxnSp>
          <p:nvCxnSpPr>
            <p:cNvPr id="192" name="直線矢印コネクタ 191">
              <a:extLst>
                <a:ext uri="{FF2B5EF4-FFF2-40B4-BE49-F238E27FC236}">
                  <a16:creationId xmlns:a16="http://schemas.microsoft.com/office/drawing/2014/main" id="{01D892A4-ECCD-17D0-FC08-05D9F8FE0609}"/>
                </a:ext>
              </a:extLst>
            </p:cNvPr>
            <p:cNvCxnSpPr/>
            <p:nvPr/>
          </p:nvCxnSpPr>
          <p:spPr>
            <a:xfrm>
              <a:off x="8031480" y="1045607"/>
              <a:ext cx="0" cy="741396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直線矢印コネクタ 192">
              <a:extLst>
                <a:ext uri="{FF2B5EF4-FFF2-40B4-BE49-F238E27FC236}">
                  <a16:creationId xmlns:a16="http://schemas.microsoft.com/office/drawing/2014/main" id="{4B909593-FE10-7406-2A21-363BCC30FED3}"/>
                </a:ext>
              </a:extLst>
            </p:cNvPr>
            <p:cNvCxnSpPr>
              <a:cxnSpLocks/>
            </p:cNvCxnSpPr>
            <p:nvPr/>
          </p:nvCxnSpPr>
          <p:spPr>
            <a:xfrm>
              <a:off x="8093717" y="926893"/>
              <a:ext cx="792586" cy="1"/>
            </a:xfrm>
            <a:prstGeom prst="straightConnector1">
              <a:avLst/>
            </a:prstGeom>
            <a:ln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F8F1B86B-9C56-B157-86EE-533BE81886FD}"/>
                </a:ext>
              </a:extLst>
            </p:cNvPr>
            <p:cNvSpPr txBox="1"/>
            <p:nvPr/>
          </p:nvSpPr>
          <p:spPr>
            <a:xfrm>
              <a:off x="8070595" y="709616"/>
              <a:ext cx="1718426" cy="1589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patial information</a:t>
              </a:r>
              <a:endParaRPr lang="ja-JP" altLang="en-US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6336C4D-F24D-C919-9D79-B0C47D21686C}"/>
              </a:ext>
            </a:extLst>
          </p:cNvPr>
          <p:cNvSpPr txBox="1"/>
          <p:nvPr/>
        </p:nvSpPr>
        <p:spPr>
          <a:xfrm>
            <a:off x="661256" y="6440072"/>
            <a:ext cx="1004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mager</a:t>
            </a:r>
            <a:endParaRPr lang="ja-JP" altLang="en-US" sz="1200" b="1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四角形: 角を丸くする 36">
            <a:extLst>
              <a:ext uri="{FF2B5EF4-FFF2-40B4-BE49-F238E27FC236}">
                <a16:creationId xmlns:a16="http://schemas.microsoft.com/office/drawing/2014/main" id="{D4F43764-C09D-0933-36B7-1967526E3C94}"/>
              </a:ext>
            </a:extLst>
          </p:cNvPr>
          <p:cNvSpPr/>
          <p:nvPr/>
        </p:nvSpPr>
        <p:spPr>
          <a:xfrm>
            <a:off x="513672" y="976664"/>
            <a:ext cx="2486646" cy="3537757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8" name="平行四辺形 37">
            <a:extLst>
              <a:ext uri="{FF2B5EF4-FFF2-40B4-BE49-F238E27FC236}">
                <a16:creationId xmlns:a16="http://schemas.microsoft.com/office/drawing/2014/main" id="{E93BCC2F-B34E-1C0F-A86F-B840A401C6EA}"/>
              </a:ext>
            </a:extLst>
          </p:cNvPr>
          <p:cNvSpPr/>
          <p:nvPr/>
        </p:nvSpPr>
        <p:spPr>
          <a:xfrm rot="5608729" flipV="1">
            <a:off x="1648237" y="1710667"/>
            <a:ext cx="272867" cy="163514"/>
          </a:xfrm>
          <a:prstGeom prst="parallelogram">
            <a:avLst>
              <a:gd name="adj" fmla="val 51667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9" name="四角形: 角を丸くする 38">
            <a:extLst>
              <a:ext uri="{FF2B5EF4-FFF2-40B4-BE49-F238E27FC236}">
                <a16:creationId xmlns:a16="http://schemas.microsoft.com/office/drawing/2014/main" id="{286735D4-9D33-22B2-65CC-F80D6A71B4C9}"/>
              </a:ext>
            </a:extLst>
          </p:cNvPr>
          <p:cNvSpPr/>
          <p:nvPr/>
        </p:nvSpPr>
        <p:spPr>
          <a:xfrm rot="16200000">
            <a:off x="3680673" y="399315"/>
            <a:ext cx="1726701" cy="2726668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40" name="楕円 39">
            <a:extLst>
              <a:ext uri="{FF2B5EF4-FFF2-40B4-BE49-F238E27FC236}">
                <a16:creationId xmlns:a16="http://schemas.microsoft.com/office/drawing/2014/main" id="{E12532CC-CE58-E25A-8CCD-244379EBC14D}"/>
              </a:ext>
            </a:extLst>
          </p:cNvPr>
          <p:cNvSpPr/>
          <p:nvPr/>
        </p:nvSpPr>
        <p:spPr>
          <a:xfrm>
            <a:off x="4015930" y="4065139"/>
            <a:ext cx="943134" cy="309284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41" name="楕円 40">
            <a:extLst>
              <a:ext uri="{FF2B5EF4-FFF2-40B4-BE49-F238E27FC236}">
                <a16:creationId xmlns:a16="http://schemas.microsoft.com/office/drawing/2014/main" id="{ED7791EB-FF47-7CD4-EFEE-53037459C6B7}"/>
              </a:ext>
            </a:extLst>
          </p:cNvPr>
          <p:cNvSpPr/>
          <p:nvPr/>
        </p:nvSpPr>
        <p:spPr>
          <a:xfrm rot="5400000">
            <a:off x="3008077" y="3497138"/>
            <a:ext cx="876155" cy="332927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42" name="楕円 41">
            <a:extLst>
              <a:ext uri="{FF2B5EF4-FFF2-40B4-BE49-F238E27FC236}">
                <a16:creationId xmlns:a16="http://schemas.microsoft.com/office/drawing/2014/main" id="{19BBB28F-012C-BC69-705D-06C6790CB953}"/>
              </a:ext>
            </a:extLst>
          </p:cNvPr>
          <p:cNvSpPr/>
          <p:nvPr/>
        </p:nvSpPr>
        <p:spPr>
          <a:xfrm>
            <a:off x="4058065" y="2815755"/>
            <a:ext cx="943134" cy="309284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B8FFE282-B741-D019-BDBC-1DCDDB9511D0}"/>
              </a:ext>
            </a:extLst>
          </p:cNvPr>
          <p:cNvCxnSpPr>
            <a:cxnSpLocks/>
          </p:cNvCxnSpPr>
          <p:nvPr/>
        </p:nvCxnSpPr>
        <p:spPr>
          <a:xfrm>
            <a:off x="4430551" y="3653303"/>
            <a:ext cx="0" cy="1283055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824AF66E-628E-3869-E175-5372C220BC7A}"/>
              </a:ext>
            </a:extLst>
          </p:cNvPr>
          <p:cNvCxnSpPr>
            <a:cxnSpLocks/>
          </p:cNvCxnSpPr>
          <p:nvPr/>
        </p:nvCxnSpPr>
        <p:spPr>
          <a:xfrm flipV="1">
            <a:off x="4547957" y="2471703"/>
            <a:ext cx="0" cy="2443084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BECA2EF1-EAE0-A87B-DF4A-8E45F920C4BD}"/>
              </a:ext>
            </a:extLst>
          </p:cNvPr>
          <p:cNvSpPr/>
          <p:nvPr/>
        </p:nvSpPr>
        <p:spPr>
          <a:xfrm rot="18900000" flipH="1">
            <a:off x="4461219" y="3252090"/>
            <a:ext cx="52568" cy="823023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5CFF55DA-B073-E452-3E28-8EAF1239F193}"/>
              </a:ext>
            </a:extLst>
          </p:cNvPr>
          <p:cNvSpPr/>
          <p:nvPr/>
        </p:nvSpPr>
        <p:spPr>
          <a:xfrm>
            <a:off x="3958984" y="5002074"/>
            <a:ext cx="1101580" cy="105139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802444C-EE61-D19B-8F32-72A1185CA1E0}"/>
              </a:ext>
            </a:extLst>
          </p:cNvPr>
          <p:cNvSpPr txBox="1"/>
          <p:nvPr/>
        </p:nvSpPr>
        <p:spPr>
          <a:xfrm>
            <a:off x="3215407" y="1434141"/>
            <a:ext cx="1518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etection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8" name="楕円 47">
            <a:extLst>
              <a:ext uri="{FF2B5EF4-FFF2-40B4-BE49-F238E27FC236}">
                <a16:creationId xmlns:a16="http://schemas.microsoft.com/office/drawing/2014/main" id="{5F0D41A8-ECB4-834E-6875-A6AD60280CAE}"/>
              </a:ext>
            </a:extLst>
          </p:cNvPr>
          <p:cNvSpPr/>
          <p:nvPr/>
        </p:nvSpPr>
        <p:spPr>
          <a:xfrm>
            <a:off x="2201246" y="3241481"/>
            <a:ext cx="322614" cy="869260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E22D028A-BC50-E6B0-471C-F2B321AED93F}"/>
              </a:ext>
            </a:extLst>
          </p:cNvPr>
          <p:cNvCxnSpPr/>
          <p:nvPr/>
        </p:nvCxnSpPr>
        <p:spPr>
          <a:xfrm>
            <a:off x="2903964" y="3164666"/>
            <a:ext cx="0" cy="1002691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112FF851-3469-67E1-E37D-78D2A18BFAAD}"/>
              </a:ext>
            </a:extLst>
          </p:cNvPr>
          <p:cNvCxnSpPr>
            <a:cxnSpLocks/>
          </p:cNvCxnSpPr>
          <p:nvPr/>
        </p:nvCxnSpPr>
        <p:spPr>
          <a:xfrm>
            <a:off x="807547" y="3666012"/>
            <a:ext cx="3619691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B8755CD-385F-F875-C04A-9DE855ABD8E1}"/>
              </a:ext>
            </a:extLst>
          </p:cNvPr>
          <p:cNvSpPr txBox="1"/>
          <p:nvPr/>
        </p:nvSpPr>
        <p:spPr>
          <a:xfrm>
            <a:off x="4674649" y="4618069"/>
            <a:ext cx="1931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ample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4E2A3DB5-EFAF-E5CC-B65C-21519D7E62AF}"/>
              </a:ext>
            </a:extLst>
          </p:cNvPr>
          <p:cNvGrpSpPr>
            <a:grpSpLocks noChangeAspect="1"/>
          </p:cNvGrpSpPr>
          <p:nvPr/>
        </p:nvGrpSpPr>
        <p:grpSpPr>
          <a:xfrm rot="5400000">
            <a:off x="3521257" y="5168403"/>
            <a:ext cx="582231" cy="583200"/>
            <a:chOff x="2193341" y="2890350"/>
            <a:chExt cx="761997" cy="709063"/>
          </a:xfrm>
        </p:grpSpPr>
        <p:sp>
          <p:nvSpPr>
            <p:cNvPr id="188" name="フローチャート: 結合子 187">
              <a:extLst>
                <a:ext uri="{FF2B5EF4-FFF2-40B4-BE49-F238E27FC236}">
                  <a16:creationId xmlns:a16="http://schemas.microsoft.com/office/drawing/2014/main" id="{8AC9CE47-592C-FDD6-422D-4B9B32C34843}"/>
                </a:ext>
              </a:extLst>
            </p:cNvPr>
            <p:cNvSpPr/>
            <p:nvPr/>
          </p:nvSpPr>
          <p:spPr>
            <a:xfrm>
              <a:off x="2193341" y="2890350"/>
              <a:ext cx="761997" cy="709063"/>
            </a:xfrm>
            <a:prstGeom prst="flowChartConnector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9" name="楕円 188">
              <a:extLst>
                <a:ext uri="{FF2B5EF4-FFF2-40B4-BE49-F238E27FC236}">
                  <a16:creationId xmlns:a16="http://schemas.microsoft.com/office/drawing/2014/main" id="{153F1AE9-E404-1B87-4FD3-4B5FDE6B236F}"/>
                </a:ext>
              </a:extLst>
            </p:cNvPr>
            <p:cNvSpPr/>
            <p:nvPr/>
          </p:nvSpPr>
          <p:spPr>
            <a:xfrm rot="5400000">
              <a:off x="2564319" y="2981543"/>
              <a:ext cx="29457" cy="533682"/>
            </a:xfrm>
            <a:prstGeom prst="ellipse">
              <a:avLst/>
            </a:prstGeom>
            <a:solidFill>
              <a:srgbClr val="9933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0A74DCAF-F406-FE77-8002-EC920BB25CA8}"/>
              </a:ext>
            </a:extLst>
          </p:cNvPr>
          <p:cNvGrpSpPr>
            <a:grpSpLocks noChangeAspect="1"/>
          </p:cNvGrpSpPr>
          <p:nvPr/>
        </p:nvGrpSpPr>
        <p:grpSpPr>
          <a:xfrm rot="5400000">
            <a:off x="4848343" y="5185783"/>
            <a:ext cx="582230" cy="583200"/>
            <a:chOff x="2201651" y="2859468"/>
            <a:chExt cx="761997" cy="709063"/>
          </a:xfrm>
        </p:grpSpPr>
        <p:sp>
          <p:nvSpPr>
            <p:cNvPr id="186" name="フローチャート: 結合子 185">
              <a:extLst>
                <a:ext uri="{FF2B5EF4-FFF2-40B4-BE49-F238E27FC236}">
                  <a16:creationId xmlns:a16="http://schemas.microsoft.com/office/drawing/2014/main" id="{364494E4-0384-D4C5-3B4D-472ECD421A3B}"/>
                </a:ext>
              </a:extLst>
            </p:cNvPr>
            <p:cNvSpPr/>
            <p:nvPr/>
          </p:nvSpPr>
          <p:spPr>
            <a:xfrm>
              <a:off x="2201651" y="2859468"/>
              <a:ext cx="761997" cy="709063"/>
            </a:xfrm>
            <a:prstGeom prst="flowChartConnector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7" name="楕円 186">
              <a:extLst>
                <a:ext uri="{FF2B5EF4-FFF2-40B4-BE49-F238E27FC236}">
                  <a16:creationId xmlns:a16="http://schemas.microsoft.com/office/drawing/2014/main" id="{DB438F06-F58F-F3EE-429A-926BD374608A}"/>
                </a:ext>
              </a:extLst>
            </p:cNvPr>
            <p:cNvSpPr/>
            <p:nvPr/>
          </p:nvSpPr>
          <p:spPr>
            <a:xfrm rot="5400000">
              <a:off x="2559609" y="2952242"/>
              <a:ext cx="29457" cy="533682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54" name="矢印: 右 53">
            <a:extLst>
              <a:ext uri="{FF2B5EF4-FFF2-40B4-BE49-F238E27FC236}">
                <a16:creationId xmlns:a16="http://schemas.microsoft.com/office/drawing/2014/main" id="{D04C3F3E-966F-2E84-BDB3-4FCCFE90F30D}"/>
              </a:ext>
            </a:extLst>
          </p:cNvPr>
          <p:cNvSpPr/>
          <p:nvPr/>
        </p:nvSpPr>
        <p:spPr>
          <a:xfrm>
            <a:off x="4365969" y="5359466"/>
            <a:ext cx="210929" cy="25630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B1F13887-0AC3-671D-03DA-5936D4A3C5E5}"/>
              </a:ext>
            </a:extLst>
          </p:cNvPr>
          <p:cNvSpPr txBox="1"/>
          <p:nvPr/>
        </p:nvSpPr>
        <p:spPr>
          <a:xfrm>
            <a:off x="2688150" y="5232767"/>
            <a:ext cx="12340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xcitation profile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3220A6E-D9B5-AA68-2993-930505BF4CCB}"/>
              </a:ext>
            </a:extLst>
          </p:cNvPr>
          <p:cNvSpPr txBox="1"/>
          <p:nvPr/>
        </p:nvSpPr>
        <p:spPr>
          <a:xfrm>
            <a:off x="5402736" y="5224390"/>
            <a:ext cx="10092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Fluorescent profile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71DA72C-26CB-2E03-6D37-0F61266B688F}"/>
              </a:ext>
            </a:extLst>
          </p:cNvPr>
          <p:cNvSpPr txBox="1"/>
          <p:nvPr/>
        </p:nvSpPr>
        <p:spPr>
          <a:xfrm>
            <a:off x="617651" y="1111775"/>
            <a:ext cx="1931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xcitation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1A1FEA19-609E-6C19-671B-DE607C8C8A3D}"/>
              </a:ext>
            </a:extLst>
          </p:cNvPr>
          <p:cNvGrpSpPr/>
          <p:nvPr/>
        </p:nvGrpSpPr>
        <p:grpSpPr>
          <a:xfrm>
            <a:off x="1586765" y="3382877"/>
            <a:ext cx="264485" cy="607319"/>
            <a:chOff x="6109945" y="3562001"/>
            <a:chExt cx="497415" cy="1381999"/>
          </a:xfrm>
          <a:solidFill>
            <a:schemeClr val="accent1">
              <a:lumMod val="20000"/>
              <a:lumOff val="80000"/>
            </a:schemeClr>
          </a:solidFill>
        </p:grpSpPr>
        <p:sp>
          <p:nvSpPr>
            <p:cNvPr id="182" name="円柱 181">
              <a:extLst>
                <a:ext uri="{FF2B5EF4-FFF2-40B4-BE49-F238E27FC236}">
                  <a16:creationId xmlns:a16="http://schemas.microsoft.com/office/drawing/2014/main" id="{0E2D81AC-9F63-CD47-5B48-C30F0FCF7178}"/>
                </a:ext>
              </a:extLst>
            </p:cNvPr>
            <p:cNvSpPr/>
            <p:nvPr/>
          </p:nvSpPr>
          <p:spPr>
            <a:xfrm>
              <a:off x="6380263" y="3562001"/>
              <a:ext cx="227097" cy="873889"/>
            </a:xfrm>
            <a:prstGeom prst="can">
              <a:avLst>
                <a:gd name="adj" fmla="val 75331"/>
              </a:avLst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3" name="円柱 182">
              <a:extLst>
                <a:ext uri="{FF2B5EF4-FFF2-40B4-BE49-F238E27FC236}">
                  <a16:creationId xmlns:a16="http://schemas.microsoft.com/office/drawing/2014/main" id="{0EA8D1E7-10C3-1962-7EDF-D174714AFB41}"/>
                </a:ext>
              </a:extLst>
            </p:cNvPr>
            <p:cNvSpPr/>
            <p:nvPr/>
          </p:nvSpPr>
          <p:spPr>
            <a:xfrm>
              <a:off x="6290157" y="3731371"/>
              <a:ext cx="227097" cy="873889"/>
            </a:xfrm>
            <a:prstGeom prst="can">
              <a:avLst>
                <a:gd name="adj" fmla="val 75331"/>
              </a:avLst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4" name="円柱 183">
              <a:extLst>
                <a:ext uri="{FF2B5EF4-FFF2-40B4-BE49-F238E27FC236}">
                  <a16:creationId xmlns:a16="http://schemas.microsoft.com/office/drawing/2014/main" id="{41655744-DE6C-C722-630B-140B02A19940}"/>
                </a:ext>
              </a:extLst>
            </p:cNvPr>
            <p:cNvSpPr/>
            <p:nvPr/>
          </p:nvSpPr>
          <p:spPr>
            <a:xfrm>
              <a:off x="6200051" y="3900741"/>
              <a:ext cx="227097" cy="873889"/>
            </a:xfrm>
            <a:prstGeom prst="can">
              <a:avLst>
                <a:gd name="adj" fmla="val 75331"/>
              </a:avLst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85" name="円柱 184">
              <a:extLst>
                <a:ext uri="{FF2B5EF4-FFF2-40B4-BE49-F238E27FC236}">
                  <a16:creationId xmlns:a16="http://schemas.microsoft.com/office/drawing/2014/main" id="{E52EE9F8-E2EB-9F04-023D-B4972326ED23}"/>
                </a:ext>
              </a:extLst>
            </p:cNvPr>
            <p:cNvSpPr/>
            <p:nvPr/>
          </p:nvSpPr>
          <p:spPr>
            <a:xfrm>
              <a:off x="6109945" y="4070111"/>
              <a:ext cx="227097" cy="873889"/>
            </a:xfrm>
            <a:prstGeom prst="can">
              <a:avLst>
                <a:gd name="adj" fmla="val 75331"/>
              </a:avLst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endParaRPr lang="ja-JP" altLang="en-US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26F010B8-BD81-73F8-513B-CCA9CFC717EB}"/>
              </a:ext>
            </a:extLst>
          </p:cNvPr>
          <p:cNvSpPr/>
          <p:nvPr/>
        </p:nvSpPr>
        <p:spPr>
          <a:xfrm>
            <a:off x="1610387" y="2814691"/>
            <a:ext cx="441330" cy="193684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>
            <a:noAutofit/>
          </a:bodyPr>
          <a:lstStyle/>
          <a:p>
            <a:pPr algn="ctr"/>
            <a:r>
              <a:rPr lang="en-US" altLang="ja-JP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638</a:t>
            </a:r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6BE588E6-56E8-E84C-8814-8EF1AF2CD64C}"/>
              </a:ext>
            </a:extLst>
          </p:cNvPr>
          <p:cNvSpPr/>
          <p:nvPr/>
        </p:nvSpPr>
        <p:spPr>
          <a:xfrm>
            <a:off x="1822581" y="2444651"/>
            <a:ext cx="441330" cy="193684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>
            <a:noAutofit/>
          </a:bodyPr>
          <a:lstStyle/>
          <a:p>
            <a:pPr algn="ctr"/>
            <a:r>
              <a:rPr lang="en-US" altLang="ja-JP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532</a:t>
            </a:r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A57889D1-B6A0-FC9D-0B8D-D59BA6E7C13E}"/>
              </a:ext>
            </a:extLst>
          </p:cNvPr>
          <p:cNvSpPr/>
          <p:nvPr/>
        </p:nvSpPr>
        <p:spPr>
          <a:xfrm>
            <a:off x="2002376" y="2074613"/>
            <a:ext cx="441330" cy="193684"/>
          </a:xfrm>
          <a:prstGeom prst="rect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>
            <a:noAutofit/>
          </a:bodyPr>
          <a:lstStyle/>
          <a:p>
            <a:pPr algn="ctr"/>
            <a:r>
              <a:rPr lang="en-US" altLang="ja-JP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488</a:t>
            </a:r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4557FACD-67D4-C3AC-A06C-F896F356E9AE}"/>
              </a:ext>
            </a:extLst>
          </p:cNvPr>
          <p:cNvSpPr/>
          <p:nvPr/>
        </p:nvSpPr>
        <p:spPr>
          <a:xfrm>
            <a:off x="2191889" y="1704575"/>
            <a:ext cx="441330" cy="193684"/>
          </a:xfrm>
          <a:prstGeom prst="rect">
            <a:avLst/>
          </a:prstGeom>
          <a:solidFill>
            <a:srgbClr val="9933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>
            <a:noAutofit/>
          </a:bodyPr>
          <a:lstStyle/>
          <a:p>
            <a:pPr algn="ctr"/>
            <a:r>
              <a:rPr lang="en-US" altLang="ja-JP" sz="1200"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405</a:t>
            </a:r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8ECBB81F-F665-20A7-822C-D43EB289A327}"/>
              </a:ext>
            </a:extLst>
          </p:cNvPr>
          <p:cNvCxnSpPr>
            <a:cxnSpLocks/>
            <a:stCxn id="62" idx="1"/>
          </p:cNvCxnSpPr>
          <p:nvPr/>
        </p:nvCxnSpPr>
        <p:spPr>
          <a:xfrm flipH="1">
            <a:off x="1776819" y="1801417"/>
            <a:ext cx="415070" cy="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楕円 94">
            <a:extLst>
              <a:ext uri="{FF2B5EF4-FFF2-40B4-BE49-F238E27FC236}">
                <a16:creationId xmlns:a16="http://schemas.microsoft.com/office/drawing/2014/main" id="{887CCFB6-C634-A967-97B2-01692F2BC3C2}"/>
              </a:ext>
            </a:extLst>
          </p:cNvPr>
          <p:cNvSpPr/>
          <p:nvPr/>
        </p:nvSpPr>
        <p:spPr>
          <a:xfrm rot="5400000">
            <a:off x="1914327" y="1743551"/>
            <a:ext cx="262941" cy="141289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4FB469C9-8835-9C82-DE5E-3D30511C33CB}"/>
              </a:ext>
            </a:extLst>
          </p:cNvPr>
          <p:cNvSpPr txBox="1"/>
          <p:nvPr/>
        </p:nvSpPr>
        <p:spPr>
          <a:xfrm>
            <a:off x="451737" y="3857184"/>
            <a:ext cx="10424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Resonant mirror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C39A141A-3C46-8FF3-133D-94E67452DB0D}"/>
              </a:ext>
            </a:extLst>
          </p:cNvPr>
          <p:cNvCxnSpPr>
            <a:cxnSpLocks/>
          </p:cNvCxnSpPr>
          <p:nvPr/>
        </p:nvCxnSpPr>
        <p:spPr>
          <a:xfrm flipH="1">
            <a:off x="1587673" y="1797661"/>
            <a:ext cx="196881" cy="3759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平行四辺形 135">
            <a:extLst>
              <a:ext uri="{FF2B5EF4-FFF2-40B4-BE49-F238E27FC236}">
                <a16:creationId xmlns:a16="http://schemas.microsoft.com/office/drawing/2014/main" id="{FB41BA07-756C-085D-E3BA-C70504C9EE2F}"/>
              </a:ext>
            </a:extLst>
          </p:cNvPr>
          <p:cNvSpPr/>
          <p:nvPr/>
        </p:nvSpPr>
        <p:spPr>
          <a:xfrm rot="5608729" flipV="1">
            <a:off x="1473584" y="2076864"/>
            <a:ext cx="272867" cy="163514"/>
          </a:xfrm>
          <a:prstGeom prst="parallelogram">
            <a:avLst>
              <a:gd name="adj" fmla="val 51667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98C315A8-EF6A-4965-6866-063A8F9E0C44}"/>
              </a:ext>
            </a:extLst>
          </p:cNvPr>
          <p:cNvCxnSpPr>
            <a:cxnSpLocks/>
            <a:stCxn id="61" idx="1"/>
          </p:cNvCxnSpPr>
          <p:nvPr/>
        </p:nvCxnSpPr>
        <p:spPr>
          <a:xfrm flipH="1" flipV="1">
            <a:off x="1586200" y="2168723"/>
            <a:ext cx="416175" cy="27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楕円 137">
            <a:extLst>
              <a:ext uri="{FF2B5EF4-FFF2-40B4-BE49-F238E27FC236}">
                <a16:creationId xmlns:a16="http://schemas.microsoft.com/office/drawing/2014/main" id="{BF78DF63-7110-EB12-2E28-F77DF759B53A}"/>
              </a:ext>
            </a:extLst>
          </p:cNvPr>
          <p:cNvSpPr/>
          <p:nvPr/>
        </p:nvSpPr>
        <p:spPr>
          <a:xfrm rot="5400000">
            <a:off x="1723711" y="2115352"/>
            <a:ext cx="262941" cy="141289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139" name="直線コネクタ 138">
            <a:extLst>
              <a:ext uri="{FF2B5EF4-FFF2-40B4-BE49-F238E27FC236}">
                <a16:creationId xmlns:a16="http://schemas.microsoft.com/office/drawing/2014/main" id="{BF1ED2D1-2005-D891-53B7-381C55EDEDE3}"/>
              </a:ext>
            </a:extLst>
          </p:cNvPr>
          <p:cNvCxnSpPr>
            <a:cxnSpLocks/>
          </p:cNvCxnSpPr>
          <p:nvPr/>
        </p:nvCxnSpPr>
        <p:spPr>
          <a:xfrm flipH="1">
            <a:off x="1388562" y="2171248"/>
            <a:ext cx="196881" cy="3759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平行四辺形 139">
            <a:extLst>
              <a:ext uri="{FF2B5EF4-FFF2-40B4-BE49-F238E27FC236}">
                <a16:creationId xmlns:a16="http://schemas.microsoft.com/office/drawing/2014/main" id="{160BCE18-5D6F-9A66-44D2-93A540411084}"/>
              </a:ext>
            </a:extLst>
          </p:cNvPr>
          <p:cNvSpPr/>
          <p:nvPr/>
        </p:nvSpPr>
        <p:spPr>
          <a:xfrm rot="5608729" flipV="1">
            <a:off x="1268512" y="2450206"/>
            <a:ext cx="272867" cy="163514"/>
          </a:xfrm>
          <a:prstGeom prst="parallelogram">
            <a:avLst>
              <a:gd name="adj" fmla="val 51667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61C4B466-8136-6350-D39F-DCDF89A156F4}"/>
              </a:ext>
            </a:extLst>
          </p:cNvPr>
          <p:cNvCxnSpPr>
            <a:cxnSpLocks/>
            <a:stCxn id="60" idx="1"/>
          </p:cNvCxnSpPr>
          <p:nvPr/>
        </p:nvCxnSpPr>
        <p:spPr>
          <a:xfrm flipH="1" flipV="1">
            <a:off x="1388751" y="2540128"/>
            <a:ext cx="433828" cy="13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楕円 141">
            <a:extLst>
              <a:ext uri="{FF2B5EF4-FFF2-40B4-BE49-F238E27FC236}">
                <a16:creationId xmlns:a16="http://schemas.microsoft.com/office/drawing/2014/main" id="{DDC16D5A-2991-847A-034C-A582C5C0C5D6}"/>
              </a:ext>
            </a:extLst>
          </p:cNvPr>
          <p:cNvSpPr/>
          <p:nvPr/>
        </p:nvSpPr>
        <p:spPr>
          <a:xfrm rot="5400000">
            <a:off x="1535085" y="2491256"/>
            <a:ext cx="262941" cy="141289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0C05931C-6C68-81E2-9DA8-EFCF08AC849D}"/>
              </a:ext>
            </a:extLst>
          </p:cNvPr>
          <p:cNvCxnSpPr>
            <a:cxnSpLocks/>
          </p:cNvCxnSpPr>
          <p:nvPr/>
        </p:nvCxnSpPr>
        <p:spPr>
          <a:xfrm flipH="1">
            <a:off x="1189451" y="2536620"/>
            <a:ext cx="201182" cy="3841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平行四辺形 143">
            <a:extLst>
              <a:ext uri="{FF2B5EF4-FFF2-40B4-BE49-F238E27FC236}">
                <a16:creationId xmlns:a16="http://schemas.microsoft.com/office/drawing/2014/main" id="{A24F2D98-728A-B2A8-9001-A6F98195E294}"/>
              </a:ext>
            </a:extLst>
          </p:cNvPr>
          <p:cNvSpPr/>
          <p:nvPr/>
        </p:nvSpPr>
        <p:spPr>
          <a:xfrm rot="5608729" flipV="1">
            <a:off x="1078805" y="2805224"/>
            <a:ext cx="285526" cy="163514"/>
          </a:xfrm>
          <a:prstGeom prst="parallelogram">
            <a:avLst>
              <a:gd name="adj" fmla="val 51667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7D1ADC05-ACCD-1E5A-357C-AAA7AFB1DA14}"/>
              </a:ext>
            </a:extLst>
          </p:cNvPr>
          <p:cNvCxnSpPr>
            <a:cxnSpLocks/>
          </p:cNvCxnSpPr>
          <p:nvPr/>
        </p:nvCxnSpPr>
        <p:spPr>
          <a:xfrm flipH="1">
            <a:off x="781284" y="2915514"/>
            <a:ext cx="418842" cy="7998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D0BF844D-2EE1-51CE-69A0-E9C739A44468}"/>
              </a:ext>
            </a:extLst>
          </p:cNvPr>
          <p:cNvCxnSpPr>
            <a:cxnSpLocks/>
            <a:stCxn id="59" idx="1"/>
          </p:cNvCxnSpPr>
          <p:nvPr/>
        </p:nvCxnSpPr>
        <p:spPr>
          <a:xfrm flipH="1">
            <a:off x="1197157" y="2911531"/>
            <a:ext cx="413229" cy="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楕円 146">
            <a:extLst>
              <a:ext uri="{FF2B5EF4-FFF2-40B4-BE49-F238E27FC236}">
                <a16:creationId xmlns:a16="http://schemas.microsoft.com/office/drawing/2014/main" id="{90D88BE6-D6DF-2175-3133-8E0E397BCF88}"/>
              </a:ext>
            </a:extLst>
          </p:cNvPr>
          <p:cNvSpPr/>
          <p:nvPr/>
        </p:nvSpPr>
        <p:spPr>
          <a:xfrm rot="5400000">
            <a:off x="1334668" y="2867160"/>
            <a:ext cx="262941" cy="141289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0D6FE426-63B1-C01E-6ADB-B66516E9D700}"/>
              </a:ext>
            </a:extLst>
          </p:cNvPr>
          <p:cNvSpPr txBox="1"/>
          <p:nvPr/>
        </p:nvSpPr>
        <p:spPr>
          <a:xfrm>
            <a:off x="660629" y="1931158"/>
            <a:ext cx="10424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ichroic mirrors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9" name="平行四辺形 148">
            <a:extLst>
              <a:ext uri="{FF2B5EF4-FFF2-40B4-BE49-F238E27FC236}">
                <a16:creationId xmlns:a16="http://schemas.microsoft.com/office/drawing/2014/main" id="{7B769CB2-2810-3D48-2D7C-4C4062619522}"/>
              </a:ext>
            </a:extLst>
          </p:cNvPr>
          <p:cNvSpPr/>
          <p:nvPr/>
        </p:nvSpPr>
        <p:spPr>
          <a:xfrm rot="5400000">
            <a:off x="651440" y="3629418"/>
            <a:ext cx="285526" cy="111811"/>
          </a:xfrm>
          <a:prstGeom prst="parallelogram">
            <a:avLst>
              <a:gd name="adj" fmla="val 51667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50" name="円弧 149">
            <a:extLst>
              <a:ext uri="{FF2B5EF4-FFF2-40B4-BE49-F238E27FC236}">
                <a16:creationId xmlns:a16="http://schemas.microsoft.com/office/drawing/2014/main" id="{72976AE1-E3E9-7AE0-E263-2B80E2E226B5}"/>
              </a:ext>
            </a:extLst>
          </p:cNvPr>
          <p:cNvSpPr/>
          <p:nvPr/>
        </p:nvSpPr>
        <p:spPr>
          <a:xfrm>
            <a:off x="558347" y="3680815"/>
            <a:ext cx="519352" cy="113011"/>
          </a:xfrm>
          <a:prstGeom prst="arc">
            <a:avLst>
              <a:gd name="adj1" fmla="val 9056950"/>
              <a:gd name="adj2" fmla="val 11701627"/>
            </a:avLst>
          </a:prstGeom>
          <a:ln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6DC0A443-D2C5-95E8-12E5-E7AB4C7724D0}"/>
              </a:ext>
            </a:extLst>
          </p:cNvPr>
          <p:cNvSpPr txBox="1"/>
          <p:nvPr/>
        </p:nvSpPr>
        <p:spPr>
          <a:xfrm>
            <a:off x="1255572" y="4020720"/>
            <a:ext cx="10424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ylindrical lens array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FDB45E49-86C1-5A18-F717-8DB0162FEA63}"/>
              </a:ext>
            </a:extLst>
          </p:cNvPr>
          <p:cNvSpPr txBox="1"/>
          <p:nvPr/>
        </p:nvSpPr>
        <p:spPr>
          <a:xfrm>
            <a:off x="2415671" y="2315015"/>
            <a:ext cx="1042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lasers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016D02B2-9B75-7A15-6900-7DDDF789E491}"/>
              </a:ext>
            </a:extLst>
          </p:cNvPr>
          <p:cNvSpPr txBox="1"/>
          <p:nvPr/>
        </p:nvSpPr>
        <p:spPr>
          <a:xfrm>
            <a:off x="2478187" y="2805814"/>
            <a:ext cx="11914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ntermediate plane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A11F89E6-C575-7E66-A3EE-0F37A398D02D}"/>
              </a:ext>
            </a:extLst>
          </p:cNvPr>
          <p:cNvSpPr txBox="1"/>
          <p:nvPr/>
        </p:nvSpPr>
        <p:spPr>
          <a:xfrm>
            <a:off x="2055143" y="4162350"/>
            <a:ext cx="9184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maging lens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9D9976F2-CF23-77EA-DA26-C9C971A849EE}"/>
              </a:ext>
            </a:extLst>
          </p:cNvPr>
          <p:cNvSpPr txBox="1"/>
          <p:nvPr/>
        </p:nvSpPr>
        <p:spPr>
          <a:xfrm>
            <a:off x="3027185" y="4123269"/>
            <a:ext cx="918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ube lens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03C2A11C-80B1-E137-0A80-3EE998F38AF4}"/>
              </a:ext>
            </a:extLst>
          </p:cNvPr>
          <p:cNvSpPr txBox="1"/>
          <p:nvPr/>
        </p:nvSpPr>
        <p:spPr>
          <a:xfrm>
            <a:off x="4988908" y="2886168"/>
            <a:ext cx="9184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ube lens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C0C7A3F4-C38C-289B-62FB-A140A0C1C15B}"/>
              </a:ext>
            </a:extLst>
          </p:cNvPr>
          <p:cNvSpPr txBox="1"/>
          <p:nvPr/>
        </p:nvSpPr>
        <p:spPr>
          <a:xfrm>
            <a:off x="4942938" y="4155611"/>
            <a:ext cx="1403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Objective lens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B8362232-3D0A-DE64-95A4-329FEA2E81A6}"/>
              </a:ext>
            </a:extLst>
          </p:cNvPr>
          <p:cNvSpPr txBox="1"/>
          <p:nvPr/>
        </p:nvSpPr>
        <p:spPr>
          <a:xfrm>
            <a:off x="4385893" y="1599755"/>
            <a:ext cx="1042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rating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D174FBDE-CE22-E11A-7F23-510C29B7F393}"/>
              </a:ext>
            </a:extLst>
          </p:cNvPr>
          <p:cNvSpPr txBox="1"/>
          <p:nvPr/>
        </p:nvSpPr>
        <p:spPr>
          <a:xfrm>
            <a:off x="5509839" y="2074613"/>
            <a:ext cx="10424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oncave</a:t>
            </a:r>
          </a:p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mirror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A8BE211D-5E2B-F9CF-9164-209AE99D549D}"/>
              </a:ext>
            </a:extLst>
          </p:cNvPr>
          <p:cNvCxnSpPr/>
          <p:nvPr/>
        </p:nvCxnSpPr>
        <p:spPr>
          <a:xfrm>
            <a:off x="4260678" y="2437074"/>
            <a:ext cx="26991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>
            <a:extLst>
              <a:ext uri="{FF2B5EF4-FFF2-40B4-BE49-F238E27FC236}">
                <a16:creationId xmlns:a16="http://schemas.microsoft.com/office/drawing/2014/main" id="{BC495C73-905B-3146-B56F-EBE13106252F}"/>
              </a:ext>
            </a:extLst>
          </p:cNvPr>
          <p:cNvCxnSpPr/>
          <p:nvPr/>
        </p:nvCxnSpPr>
        <p:spPr>
          <a:xfrm>
            <a:off x="4587600" y="2437074"/>
            <a:ext cx="26991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6767097F-6960-F79E-6270-60EDCAA76C4E}"/>
              </a:ext>
            </a:extLst>
          </p:cNvPr>
          <p:cNvSpPr txBox="1"/>
          <p:nvPr/>
        </p:nvSpPr>
        <p:spPr>
          <a:xfrm>
            <a:off x="4775573" y="2431195"/>
            <a:ext cx="1042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Slit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92CBD7EA-1C6D-5CB0-A7EA-6AA78FA3F901}"/>
              </a:ext>
            </a:extLst>
          </p:cNvPr>
          <p:cNvSpPr txBox="1"/>
          <p:nvPr/>
        </p:nvSpPr>
        <p:spPr>
          <a:xfrm>
            <a:off x="4909696" y="3544165"/>
            <a:ext cx="1310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ichroic mirror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F058847B-E789-333E-7EBA-DC1D46AE2BEA}"/>
              </a:ext>
            </a:extLst>
          </p:cNvPr>
          <p:cNvSpPr txBox="1"/>
          <p:nvPr/>
        </p:nvSpPr>
        <p:spPr>
          <a:xfrm>
            <a:off x="5036109" y="4947341"/>
            <a:ext cx="1310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-Y stage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5" name="正方形/長方形 164">
            <a:extLst>
              <a:ext uri="{FF2B5EF4-FFF2-40B4-BE49-F238E27FC236}">
                <a16:creationId xmlns:a16="http://schemas.microsoft.com/office/drawing/2014/main" id="{AC00A6AE-4532-3325-EB4F-3D3A597749A2}"/>
              </a:ext>
            </a:extLst>
          </p:cNvPr>
          <p:cNvSpPr/>
          <p:nvPr/>
        </p:nvSpPr>
        <p:spPr>
          <a:xfrm>
            <a:off x="4316225" y="4947261"/>
            <a:ext cx="372316" cy="5271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689AE955-798E-EB36-3086-73CCE3DD5A42}"/>
              </a:ext>
            </a:extLst>
          </p:cNvPr>
          <p:cNvSpPr txBox="1"/>
          <p:nvPr/>
        </p:nvSpPr>
        <p:spPr>
          <a:xfrm>
            <a:off x="3815372" y="851963"/>
            <a:ext cx="1042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mager</a:t>
            </a:r>
            <a:endParaRPr lang="ja-JP" altLang="en-US" sz="120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id="{03D9CE4B-FA3D-8D52-9E5F-1B2E367A2345}"/>
              </a:ext>
            </a:extLst>
          </p:cNvPr>
          <p:cNvGrpSpPr/>
          <p:nvPr/>
        </p:nvGrpSpPr>
        <p:grpSpPr>
          <a:xfrm rot="16200000" flipV="1">
            <a:off x="4893855" y="1846805"/>
            <a:ext cx="171055" cy="864361"/>
            <a:chOff x="5448809" y="966161"/>
            <a:chExt cx="450062" cy="848211"/>
          </a:xfrm>
        </p:grpSpPr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F23AC5BC-9852-380F-CEEB-5A5C4A5C9120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670616" y="1587392"/>
              <a:ext cx="0" cy="4436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B662D8EF-4461-0ED4-AF7E-BDA729FCFBCB}"/>
                </a:ext>
              </a:extLst>
            </p:cNvPr>
            <p:cNvCxnSpPr>
              <a:cxnSpLocks/>
            </p:cNvCxnSpPr>
            <p:nvPr/>
          </p:nvCxnSpPr>
          <p:spPr>
            <a:xfrm rot="16200000" flipV="1">
              <a:off x="5474765" y="1390267"/>
              <a:ext cx="8482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8" name="グループ化 167">
            <a:extLst>
              <a:ext uri="{FF2B5EF4-FFF2-40B4-BE49-F238E27FC236}">
                <a16:creationId xmlns:a16="http://schemas.microsoft.com/office/drawing/2014/main" id="{1D293245-4765-C9DC-7C8D-8FF31F0CA55E}"/>
              </a:ext>
            </a:extLst>
          </p:cNvPr>
          <p:cNvGrpSpPr/>
          <p:nvPr/>
        </p:nvGrpSpPr>
        <p:grpSpPr>
          <a:xfrm rot="16200000" flipV="1">
            <a:off x="4814985" y="1596801"/>
            <a:ext cx="912265" cy="303865"/>
            <a:chOff x="5894832" y="682753"/>
            <a:chExt cx="1087744" cy="292092"/>
          </a:xfrm>
        </p:grpSpPr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CD61AC70-44EA-EDDF-A469-9E0DD2AFBDE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894832" y="682753"/>
              <a:ext cx="550929" cy="2920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9C96DCB7-7388-6AF3-A09B-A4FED7E5AE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45665" y="682753"/>
              <a:ext cx="536911" cy="2920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9" name="二等辺三角形 168">
            <a:extLst>
              <a:ext uri="{FF2B5EF4-FFF2-40B4-BE49-F238E27FC236}">
                <a16:creationId xmlns:a16="http://schemas.microsoft.com/office/drawing/2014/main" id="{40BAD30C-6E6D-8257-B5F0-D4B435E7E683}"/>
              </a:ext>
            </a:extLst>
          </p:cNvPr>
          <p:cNvSpPr/>
          <p:nvPr/>
        </p:nvSpPr>
        <p:spPr>
          <a:xfrm rot="12919816">
            <a:off x="5239023" y="1263644"/>
            <a:ext cx="71690" cy="513462"/>
          </a:xfrm>
          <a:prstGeom prst="triangle">
            <a:avLst/>
          </a:prstGeom>
          <a:gradFill flip="none" rotWithShape="1">
            <a:gsLst>
              <a:gs pos="65000">
                <a:srgbClr val="FFC000"/>
              </a:gs>
              <a:gs pos="0">
                <a:srgbClr val="9933FF"/>
              </a:gs>
              <a:gs pos="16000">
                <a:srgbClr val="0000FF"/>
              </a:gs>
              <a:gs pos="39000">
                <a:srgbClr val="00B050"/>
              </a:gs>
              <a:gs pos="90000">
                <a:srgbClr val="FF0000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4A47DAEA-93E8-C70D-670D-0CDCF15AAD0B}"/>
              </a:ext>
            </a:extLst>
          </p:cNvPr>
          <p:cNvSpPr/>
          <p:nvPr/>
        </p:nvSpPr>
        <p:spPr>
          <a:xfrm rot="16200000" flipV="1">
            <a:off x="5038386" y="937071"/>
            <a:ext cx="44005" cy="753041"/>
          </a:xfrm>
          <a:prstGeom prst="rect">
            <a:avLst/>
          </a:prstGeom>
          <a:gradFill>
            <a:gsLst>
              <a:gs pos="65000">
                <a:srgbClr val="FFC000"/>
              </a:gs>
              <a:gs pos="0">
                <a:srgbClr val="9933FF"/>
              </a:gs>
              <a:gs pos="16000">
                <a:srgbClr val="0000FF"/>
              </a:gs>
              <a:gs pos="39000">
                <a:srgbClr val="00B050"/>
              </a:gs>
              <a:gs pos="90000">
                <a:srgbClr val="FF0000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71" name="正方形/長方形 170">
            <a:extLst>
              <a:ext uri="{FF2B5EF4-FFF2-40B4-BE49-F238E27FC236}">
                <a16:creationId xmlns:a16="http://schemas.microsoft.com/office/drawing/2014/main" id="{84E4789A-1988-0F54-6CA7-AA2B5EB11DD2}"/>
              </a:ext>
            </a:extLst>
          </p:cNvPr>
          <p:cNvSpPr/>
          <p:nvPr/>
        </p:nvSpPr>
        <p:spPr>
          <a:xfrm rot="18900000" flipV="1">
            <a:off x="4679822" y="1139866"/>
            <a:ext cx="29548" cy="440908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A4D4DBAF-84EF-DBD6-6179-BB0496874B45}"/>
              </a:ext>
            </a:extLst>
          </p:cNvPr>
          <p:cNvSpPr/>
          <p:nvPr/>
        </p:nvSpPr>
        <p:spPr>
          <a:xfrm rot="16200000" flipV="1">
            <a:off x="4725912" y="797949"/>
            <a:ext cx="73008" cy="43043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4DB3E00A-AB6D-77EE-6A04-FA37918D98DE}"/>
              </a:ext>
            </a:extLst>
          </p:cNvPr>
          <p:cNvSpPr/>
          <p:nvPr/>
        </p:nvSpPr>
        <p:spPr>
          <a:xfrm rot="10800000">
            <a:off x="4663708" y="1048757"/>
            <a:ext cx="46589" cy="280840"/>
          </a:xfrm>
          <a:prstGeom prst="rect">
            <a:avLst/>
          </a:prstGeom>
          <a:gradFill>
            <a:gsLst>
              <a:gs pos="65000">
                <a:srgbClr val="FFC000"/>
              </a:gs>
              <a:gs pos="0">
                <a:srgbClr val="9933FF"/>
              </a:gs>
              <a:gs pos="16000">
                <a:srgbClr val="0000FF"/>
              </a:gs>
              <a:gs pos="39000">
                <a:srgbClr val="00B050"/>
              </a:gs>
              <a:gs pos="90000">
                <a:srgbClr val="FF0000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74" name="正方形/長方形 173">
            <a:extLst>
              <a:ext uri="{FF2B5EF4-FFF2-40B4-BE49-F238E27FC236}">
                <a16:creationId xmlns:a16="http://schemas.microsoft.com/office/drawing/2014/main" id="{89580EC4-6842-13BF-8D65-E485960D4490}"/>
              </a:ext>
            </a:extLst>
          </p:cNvPr>
          <p:cNvSpPr/>
          <p:nvPr/>
        </p:nvSpPr>
        <p:spPr>
          <a:xfrm rot="2327668" flipV="1">
            <a:off x="4522401" y="1977112"/>
            <a:ext cx="31806" cy="409595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ja-JP" altLang="en-US" sz="1200"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grpSp>
        <p:nvGrpSpPr>
          <p:cNvPr id="175" name="グループ化 174">
            <a:extLst>
              <a:ext uri="{FF2B5EF4-FFF2-40B4-BE49-F238E27FC236}">
                <a16:creationId xmlns:a16="http://schemas.microsoft.com/office/drawing/2014/main" id="{DC2F366E-6BDE-11F8-0494-2C637153F844}"/>
              </a:ext>
            </a:extLst>
          </p:cNvPr>
          <p:cNvGrpSpPr>
            <a:grpSpLocks noChangeAspect="1"/>
          </p:cNvGrpSpPr>
          <p:nvPr/>
        </p:nvGrpSpPr>
        <p:grpSpPr>
          <a:xfrm rot="16200000" flipV="1">
            <a:off x="3749725" y="860019"/>
            <a:ext cx="1800001" cy="1800000"/>
            <a:chOff x="6354521" y="1248011"/>
            <a:chExt cx="853356" cy="654848"/>
          </a:xfrm>
        </p:grpSpPr>
        <p:sp>
          <p:nvSpPr>
            <p:cNvPr id="176" name="円弧 175">
              <a:extLst>
                <a:ext uri="{FF2B5EF4-FFF2-40B4-BE49-F238E27FC236}">
                  <a16:creationId xmlns:a16="http://schemas.microsoft.com/office/drawing/2014/main" id="{A07FEE38-2458-5CA1-D94E-C25999091FEC}"/>
                </a:ext>
              </a:extLst>
            </p:cNvPr>
            <p:cNvSpPr/>
            <p:nvPr/>
          </p:nvSpPr>
          <p:spPr>
            <a:xfrm>
              <a:off x="6569953" y="1408359"/>
              <a:ext cx="426678" cy="327424"/>
            </a:xfrm>
            <a:prstGeom prst="arc">
              <a:avLst>
                <a:gd name="adj1" fmla="val 14411666"/>
                <a:gd name="adj2" fmla="val 17886094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円弧 176">
              <a:extLst>
                <a:ext uri="{FF2B5EF4-FFF2-40B4-BE49-F238E27FC236}">
                  <a16:creationId xmlns:a16="http://schemas.microsoft.com/office/drawing/2014/main" id="{94880776-B51B-04B9-3E82-6F87FBD02A4B}"/>
                </a:ext>
              </a:extLst>
            </p:cNvPr>
            <p:cNvSpPr/>
            <p:nvPr/>
          </p:nvSpPr>
          <p:spPr>
            <a:xfrm>
              <a:off x="6354521" y="1248011"/>
              <a:ext cx="853356" cy="654848"/>
            </a:xfrm>
            <a:prstGeom prst="arc">
              <a:avLst>
                <a:gd name="adj1" fmla="val 13285926"/>
                <a:gd name="adj2" fmla="val 1904683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" name="図 2" descr="室内, 窓, 壁, 座っている が含まれている画像&#10;&#10;自動的に生成された説明">
            <a:extLst>
              <a:ext uri="{FF2B5EF4-FFF2-40B4-BE49-F238E27FC236}">
                <a16:creationId xmlns:a16="http://schemas.microsoft.com/office/drawing/2014/main" id="{FCF22597-0B5A-D7B0-0192-67B3B22A2122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269603" y="6540579"/>
            <a:ext cx="2322909" cy="175747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8FE587D-8D7C-07A3-9896-0BF310221C48}"/>
              </a:ext>
            </a:extLst>
          </p:cNvPr>
          <p:cNvSpPr txBox="1"/>
          <p:nvPr/>
        </p:nvSpPr>
        <p:spPr>
          <a:xfrm>
            <a:off x="3932526" y="641581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AF6EBD-3C9E-3478-7D4A-B0205A8D3F12}"/>
              </a:ext>
            </a:extLst>
          </p:cNvPr>
          <p:cNvSpPr txBox="1"/>
          <p:nvPr/>
        </p:nvSpPr>
        <p:spPr>
          <a:xfrm>
            <a:off x="2898451" y="60769"/>
            <a:ext cx="39613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figure 1 Nakamura </a:t>
            </a:r>
            <a:r>
              <a:rPr lang="en-US" altLang="ja-JP" i="1"/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24594890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四角形: 角を丸くする 29">
            <a:extLst>
              <a:ext uri="{FF2B5EF4-FFF2-40B4-BE49-F238E27FC236}">
                <a16:creationId xmlns:a16="http://schemas.microsoft.com/office/drawing/2014/main" id="{C5DC31E7-A408-49C5-7AB5-14B47CFD75F4}"/>
              </a:ext>
            </a:extLst>
          </p:cNvPr>
          <p:cNvSpPr/>
          <p:nvPr/>
        </p:nvSpPr>
        <p:spPr>
          <a:xfrm rot="5400000">
            <a:off x="3180525" y="2247864"/>
            <a:ext cx="767266" cy="765772"/>
          </a:xfrm>
          <a:prstGeom prst="roundRect">
            <a:avLst>
              <a:gd name="adj" fmla="val 1888"/>
            </a:avLst>
          </a:prstGeom>
          <a:solidFill>
            <a:srgbClr val="C0504D">
              <a:alpha val="10196"/>
            </a:srgbClr>
          </a:solidFill>
          <a:ln w="25400" cap="flat" cmpd="sng" algn="ctr">
            <a:noFill/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四角形: 角を丸くする 30">
            <a:extLst>
              <a:ext uri="{FF2B5EF4-FFF2-40B4-BE49-F238E27FC236}">
                <a16:creationId xmlns:a16="http://schemas.microsoft.com/office/drawing/2014/main" id="{7D2F7B6F-FA3F-8B5C-1385-56C749386C6C}"/>
              </a:ext>
            </a:extLst>
          </p:cNvPr>
          <p:cNvSpPr/>
          <p:nvPr/>
        </p:nvSpPr>
        <p:spPr>
          <a:xfrm rot="5400000">
            <a:off x="2034470" y="2250290"/>
            <a:ext cx="690126" cy="765772"/>
          </a:xfrm>
          <a:prstGeom prst="roundRect">
            <a:avLst>
              <a:gd name="adj" fmla="val 0"/>
            </a:avLst>
          </a:prstGeom>
          <a:solidFill>
            <a:srgbClr val="000000">
              <a:alpha val="10196"/>
            </a:srgbClr>
          </a:solidFill>
          <a:ln w="25400" cap="flat" cmpd="sng" algn="ctr">
            <a:noFill/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四角形: 角を丸くする 31">
            <a:extLst>
              <a:ext uri="{FF2B5EF4-FFF2-40B4-BE49-F238E27FC236}">
                <a16:creationId xmlns:a16="http://schemas.microsoft.com/office/drawing/2014/main" id="{F7D1034E-2589-690E-0524-ED698F63636D}"/>
              </a:ext>
            </a:extLst>
          </p:cNvPr>
          <p:cNvSpPr/>
          <p:nvPr/>
        </p:nvSpPr>
        <p:spPr>
          <a:xfrm>
            <a:off x="4098271" y="2247864"/>
            <a:ext cx="818652" cy="765772"/>
          </a:xfrm>
          <a:prstGeom prst="roundRect">
            <a:avLst>
              <a:gd name="adj" fmla="val 0"/>
            </a:avLst>
          </a:prstGeom>
          <a:solidFill>
            <a:srgbClr val="1952A6">
              <a:alpha val="10196"/>
            </a:srgbClr>
          </a:solidFill>
          <a:ln w="25400" cap="flat" cmpd="sng" algn="ctr">
            <a:noFill/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128151CA-7FF6-7341-5EA0-C2A4AA087D9B}"/>
              </a:ext>
            </a:extLst>
          </p:cNvPr>
          <p:cNvSpPr/>
          <p:nvPr/>
        </p:nvSpPr>
        <p:spPr>
          <a:xfrm>
            <a:off x="2272553" y="895820"/>
            <a:ext cx="485868" cy="914097"/>
          </a:xfrm>
          <a:prstGeom prst="rect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>
                <a:shade val="50000"/>
              </a:sysClr>
            </a:solidFill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10388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1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A</a:t>
            </a:r>
            <a:endParaRPr kumimoji="1" lang="ja-JP" altLang="en-US" sz="111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26EEE9EB-7972-9829-EE79-BBA3E798923C}"/>
              </a:ext>
            </a:extLst>
          </p:cNvPr>
          <p:cNvSpPr/>
          <p:nvPr/>
        </p:nvSpPr>
        <p:spPr>
          <a:xfrm>
            <a:off x="3427617" y="895820"/>
            <a:ext cx="288594" cy="914097"/>
          </a:xfrm>
          <a:prstGeom prst="rect">
            <a:avLst/>
          </a:prstGeom>
          <a:solidFill>
            <a:srgbClr val="C0504D"/>
          </a:solidFill>
          <a:ln w="25400" cap="flat" cmpd="sng" algn="ctr">
            <a:solidFill>
              <a:srgbClr val="C0504D"/>
            </a:solidFill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10388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W</a:t>
            </a: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EB52085C-BB4B-7751-757E-0459DFAFF5CD}"/>
              </a:ext>
            </a:extLst>
          </p:cNvPr>
          <p:cNvSpPr/>
          <p:nvPr/>
        </p:nvSpPr>
        <p:spPr>
          <a:xfrm>
            <a:off x="4284921" y="1198574"/>
            <a:ext cx="396930" cy="284118"/>
          </a:xfrm>
          <a:prstGeom prst="rect">
            <a:avLst/>
          </a:prstGeom>
          <a:solidFill>
            <a:srgbClr val="4F81BD"/>
          </a:solidFill>
          <a:ln w="25400" cap="flat" cmpd="sng" algn="ctr">
            <a:noFill/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10388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H</a:t>
            </a: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DB0CACE4-4575-0C79-F83B-58AB326A8042}"/>
              </a:ext>
            </a:extLst>
          </p:cNvPr>
          <p:cNvSpPr/>
          <p:nvPr/>
        </p:nvSpPr>
        <p:spPr>
          <a:xfrm>
            <a:off x="5179614" y="897096"/>
            <a:ext cx="396579" cy="911543"/>
          </a:xfrm>
          <a:prstGeom prst="rect">
            <a:avLst/>
          </a:prstGeom>
          <a:solidFill>
            <a:sysClr val="window" lastClr="FFFFFF">
              <a:lumMod val="85000"/>
            </a:sysClr>
          </a:solidFill>
          <a:ln w="25400" cap="flat" cmpd="sng" algn="ctr">
            <a:noFill/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10388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Δ</a:t>
            </a: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AAE7A0E-BD04-5D71-8C59-A1A54EDF04A8}"/>
              </a:ext>
            </a:extLst>
          </p:cNvPr>
          <p:cNvSpPr txBox="1"/>
          <p:nvPr/>
        </p:nvSpPr>
        <p:spPr>
          <a:xfrm>
            <a:off x="3834143" y="1223467"/>
            <a:ext cx="22029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388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*</a:t>
            </a:r>
            <a:endParaRPr kumimoji="1" lang="ja-JP" altLang="en-US" sz="1108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ECD69E3-B774-C12A-1D50-6EB4B3CA8F41}"/>
              </a:ext>
            </a:extLst>
          </p:cNvPr>
          <p:cNvSpPr txBox="1"/>
          <p:nvPr/>
        </p:nvSpPr>
        <p:spPr>
          <a:xfrm>
            <a:off x="4830044" y="1183287"/>
            <a:ext cx="215070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388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+</a:t>
            </a:r>
            <a:endParaRPr kumimoji="1" lang="ja-JP" altLang="en-US" sz="1108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sp>
        <p:nvSpPr>
          <p:cNvPr id="40" name="矢印: 右 39">
            <a:extLst>
              <a:ext uri="{FF2B5EF4-FFF2-40B4-BE49-F238E27FC236}">
                <a16:creationId xmlns:a16="http://schemas.microsoft.com/office/drawing/2014/main" id="{424B61F2-8060-AD03-0B87-45A2985267D5}"/>
              </a:ext>
            </a:extLst>
          </p:cNvPr>
          <p:cNvSpPr/>
          <p:nvPr/>
        </p:nvSpPr>
        <p:spPr>
          <a:xfrm>
            <a:off x="2923137" y="1162035"/>
            <a:ext cx="193460" cy="313148"/>
          </a:xfrm>
          <a:prstGeom prst="rightArrow">
            <a:avLst/>
          </a:prstGeom>
          <a:noFill/>
          <a:ln w="25400" cap="flat" cmpd="sng" algn="ctr">
            <a:solidFill>
              <a:sysClr val="windowText" lastClr="000000">
                <a:lumMod val="50000"/>
                <a:lumOff val="50000"/>
              </a:sysClr>
            </a:solidFill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8" name="矢印: 右 47">
            <a:extLst>
              <a:ext uri="{FF2B5EF4-FFF2-40B4-BE49-F238E27FC236}">
                <a16:creationId xmlns:a16="http://schemas.microsoft.com/office/drawing/2014/main" id="{C40D4036-51AD-895F-1CC0-152D1F2BDFF5}"/>
              </a:ext>
            </a:extLst>
          </p:cNvPr>
          <p:cNvSpPr/>
          <p:nvPr/>
        </p:nvSpPr>
        <p:spPr>
          <a:xfrm rot="5400000">
            <a:off x="4289643" y="1964181"/>
            <a:ext cx="357422" cy="184482"/>
          </a:xfrm>
          <a:prstGeom prst="rightArrow">
            <a:avLst/>
          </a:prstGeom>
          <a:solidFill>
            <a:srgbClr val="4F81BD">
              <a:lumMod val="40000"/>
              <a:lumOff val="60000"/>
            </a:srgbClr>
          </a:solidFill>
          <a:ln>
            <a:solidFill>
              <a:srgbClr val="4F81BD">
                <a:lumMod val="40000"/>
                <a:lumOff val="60000"/>
              </a:srgbClr>
            </a:solidFill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1898BD95-02C6-B217-0194-DA70E9BFC19D}"/>
              </a:ext>
            </a:extLst>
          </p:cNvPr>
          <p:cNvGrpSpPr/>
          <p:nvPr/>
        </p:nvGrpSpPr>
        <p:grpSpPr>
          <a:xfrm rot="5400000">
            <a:off x="2118829" y="2289671"/>
            <a:ext cx="518516" cy="699088"/>
            <a:chOff x="-2525486" y="2405449"/>
            <a:chExt cx="1397726" cy="1204686"/>
          </a:xfrm>
        </p:grpSpPr>
        <p:sp>
          <p:nvSpPr>
            <p:cNvPr id="50" name="フリーフォーム: 図形 49">
              <a:extLst>
                <a:ext uri="{FF2B5EF4-FFF2-40B4-BE49-F238E27FC236}">
                  <a16:creationId xmlns:a16="http://schemas.microsoft.com/office/drawing/2014/main" id="{57F749F2-12FA-02D8-B87E-84F5D0CCF95D}"/>
                </a:ext>
              </a:extLst>
            </p:cNvPr>
            <p:cNvSpPr/>
            <p:nvPr/>
          </p:nvSpPr>
          <p:spPr>
            <a:xfrm>
              <a:off x="-2499360" y="2569790"/>
              <a:ext cx="1371600" cy="1018955"/>
            </a:xfrm>
            <a:custGeom>
              <a:avLst/>
              <a:gdLst>
                <a:gd name="connsiteX0" fmla="*/ 0 w 1371600"/>
                <a:gd name="connsiteY0" fmla="*/ 1143100 h 1158065"/>
                <a:gd name="connsiteX1" fmla="*/ 426720 w 1371600"/>
                <a:gd name="connsiteY1" fmla="*/ 998320 h 1158065"/>
                <a:gd name="connsiteX2" fmla="*/ 624840 w 1371600"/>
                <a:gd name="connsiteY2" fmla="*/ 100 h 1158065"/>
                <a:gd name="connsiteX3" fmla="*/ 1005840 w 1371600"/>
                <a:gd name="connsiteY3" fmla="*/ 937360 h 1158065"/>
                <a:gd name="connsiteX4" fmla="*/ 1371600 w 1371600"/>
                <a:gd name="connsiteY4" fmla="*/ 1089760 h 11580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371600" h="1158065">
                  <a:moveTo>
                    <a:pt x="0" y="1143100"/>
                  </a:moveTo>
                  <a:cubicBezTo>
                    <a:pt x="161290" y="1165960"/>
                    <a:pt x="322580" y="1188820"/>
                    <a:pt x="426720" y="998320"/>
                  </a:cubicBezTo>
                  <a:cubicBezTo>
                    <a:pt x="530860" y="807820"/>
                    <a:pt x="528320" y="10260"/>
                    <a:pt x="624840" y="100"/>
                  </a:cubicBezTo>
                  <a:cubicBezTo>
                    <a:pt x="721360" y="-10060"/>
                    <a:pt x="881380" y="755750"/>
                    <a:pt x="1005840" y="937360"/>
                  </a:cubicBezTo>
                  <a:cubicBezTo>
                    <a:pt x="1130300" y="1118970"/>
                    <a:pt x="1250950" y="1104365"/>
                    <a:pt x="1371600" y="1089760"/>
                  </a:cubicBezTo>
                </a:path>
              </a:pathLst>
            </a:custGeom>
            <a:noFill/>
            <a:ln w="25400" cap="flat" cmpd="sng" algn="ctr">
              <a:solidFill>
                <a:srgbClr val="00B050">
                  <a:alpha val="30196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1" name="フリーフォーム: 図形 50">
              <a:extLst>
                <a:ext uri="{FF2B5EF4-FFF2-40B4-BE49-F238E27FC236}">
                  <a16:creationId xmlns:a16="http://schemas.microsoft.com/office/drawing/2014/main" id="{37B6FFCB-6CC2-8EF4-7378-24E96EADDD18}"/>
                </a:ext>
              </a:extLst>
            </p:cNvPr>
            <p:cNvSpPr/>
            <p:nvPr/>
          </p:nvSpPr>
          <p:spPr>
            <a:xfrm>
              <a:off x="-2491740" y="3047997"/>
              <a:ext cx="1341120" cy="544768"/>
            </a:xfrm>
            <a:custGeom>
              <a:avLst/>
              <a:gdLst>
                <a:gd name="connsiteX0" fmla="*/ 0 w 1341120"/>
                <a:gd name="connsiteY0" fmla="*/ 541023 h 544768"/>
                <a:gd name="connsiteX1" fmla="*/ 944880 w 1341120"/>
                <a:gd name="connsiteY1" fmla="*/ 464823 h 544768"/>
                <a:gd name="connsiteX2" fmla="*/ 1104900 w 1341120"/>
                <a:gd name="connsiteY2" fmla="*/ 3 h 544768"/>
                <a:gd name="connsiteX3" fmla="*/ 1341120 w 1341120"/>
                <a:gd name="connsiteY3" fmla="*/ 472443 h 5447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41120" h="544768">
                  <a:moveTo>
                    <a:pt x="0" y="541023"/>
                  </a:moveTo>
                  <a:cubicBezTo>
                    <a:pt x="380365" y="548008"/>
                    <a:pt x="760730" y="554993"/>
                    <a:pt x="944880" y="464823"/>
                  </a:cubicBezTo>
                  <a:cubicBezTo>
                    <a:pt x="1129030" y="374653"/>
                    <a:pt x="1038860" y="-1267"/>
                    <a:pt x="1104900" y="3"/>
                  </a:cubicBezTo>
                  <a:cubicBezTo>
                    <a:pt x="1170940" y="1273"/>
                    <a:pt x="1256030" y="236858"/>
                    <a:pt x="1341120" y="472443"/>
                  </a:cubicBezTo>
                </a:path>
              </a:pathLst>
            </a:custGeom>
            <a:noFill/>
            <a:ln w="25400" cap="flat" cmpd="sng" algn="ctr">
              <a:solidFill>
                <a:srgbClr val="00B0F0">
                  <a:alpha val="30196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2" name="フリーフォーム: 図形 51">
              <a:extLst>
                <a:ext uri="{FF2B5EF4-FFF2-40B4-BE49-F238E27FC236}">
                  <a16:creationId xmlns:a16="http://schemas.microsoft.com/office/drawing/2014/main" id="{F3E17C35-D988-7925-FD17-21744FA3211C}"/>
                </a:ext>
              </a:extLst>
            </p:cNvPr>
            <p:cNvSpPr/>
            <p:nvPr/>
          </p:nvSpPr>
          <p:spPr>
            <a:xfrm>
              <a:off x="-2506980" y="3316584"/>
              <a:ext cx="1356360" cy="280056"/>
            </a:xfrm>
            <a:custGeom>
              <a:avLst/>
              <a:gdLst>
                <a:gd name="connsiteX0" fmla="*/ 0 w 1356360"/>
                <a:gd name="connsiteY0" fmla="*/ 741132 h 741132"/>
                <a:gd name="connsiteX1" fmla="*/ 114300 w 1356360"/>
                <a:gd name="connsiteY1" fmla="*/ 1992 h 741132"/>
                <a:gd name="connsiteX2" fmla="*/ 411480 w 1356360"/>
                <a:gd name="connsiteY2" fmla="*/ 527772 h 741132"/>
                <a:gd name="connsiteX3" fmla="*/ 1356360 w 1356360"/>
                <a:gd name="connsiteY3" fmla="*/ 664932 h 7411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56360" h="741132">
                  <a:moveTo>
                    <a:pt x="0" y="741132"/>
                  </a:moveTo>
                  <a:cubicBezTo>
                    <a:pt x="22860" y="389342"/>
                    <a:pt x="45720" y="37552"/>
                    <a:pt x="114300" y="1992"/>
                  </a:cubicBezTo>
                  <a:cubicBezTo>
                    <a:pt x="182880" y="-33568"/>
                    <a:pt x="204470" y="417282"/>
                    <a:pt x="411480" y="527772"/>
                  </a:cubicBezTo>
                  <a:cubicBezTo>
                    <a:pt x="618490" y="638262"/>
                    <a:pt x="987425" y="651597"/>
                    <a:pt x="1356360" y="664932"/>
                  </a:cubicBezTo>
                </a:path>
              </a:pathLst>
            </a:custGeom>
            <a:noFill/>
            <a:ln w="25400" cap="flat" cmpd="sng" algn="ctr">
              <a:solidFill>
                <a:srgbClr val="FF0000">
                  <a:alpha val="30196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3" name="フリーフォーム: 図形 52">
              <a:extLst>
                <a:ext uri="{FF2B5EF4-FFF2-40B4-BE49-F238E27FC236}">
                  <a16:creationId xmlns:a16="http://schemas.microsoft.com/office/drawing/2014/main" id="{A6D52757-FAA8-EC41-579A-C9BE2CAB3AAE}"/>
                </a:ext>
              </a:extLst>
            </p:cNvPr>
            <p:cNvSpPr/>
            <p:nvPr/>
          </p:nvSpPr>
          <p:spPr>
            <a:xfrm>
              <a:off x="-2525486" y="2405449"/>
              <a:ext cx="1378857" cy="1204686"/>
            </a:xfrm>
            <a:custGeom>
              <a:avLst/>
              <a:gdLst>
                <a:gd name="connsiteX0" fmla="*/ 0 w 1378857"/>
                <a:gd name="connsiteY0" fmla="*/ 1204686 h 1204686"/>
                <a:gd name="connsiteX1" fmla="*/ 145143 w 1378857"/>
                <a:gd name="connsiteY1" fmla="*/ 464457 h 1204686"/>
                <a:gd name="connsiteX2" fmla="*/ 391886 w 1378857"/>
                <a:gd name="connsiteY2" fmla="*/ 783772 h 1204686"/>
                <a:gd name="connsiteX3" fmla="*/ 653143 w 1378857"/>
                <a:gd name="connsiteY3" fmla="*/ 0 h 1204686"/>
                <a:gd name="connsiteX4" fmla="*/ 1001486 w 1378857"/>
                <a:gd name="connsiteY4" fmla="*/ 783772 h 1204686"/>
                <a:gd name="connsiteX5" fmla="*/ 1146629 w 1378857"/>
                <a:gd name="connsiteY5" fmla="*/ 609600 h 1204686"/>
                <a:gd name="connsiteX6" fmla="*/ 1378857 w 1378857"/>
                <a:gd name="connsiteY6" fmla="*/ 1088572 h 12046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378857" h="1204686">
                  <a:moveTo>
                    <a:pt x="0" y="1204686"/>
                  </a:moveTo>
                  <a:cubicBezTo>
                    <a:pt x="39914" y="869647"/>
                    <a:pt x="79829" y="534609"/>
                    <a:pt x="145143" y="464457"/>
                  </a:cubicBezTo>
                  <a:cubicBezTo>
                    <a:pt x="210457" y="394305"/>
                    <a:pt x="307219" y="861181"/>
                    <a:pt x="391886" y="783772"/>
                  </a:cubicBezTo>
                  <a:cubicBezTo>
                    <a:pt x="476553" y="706363"/>
                    <a:pt x="551543" y="0"/>
                    <a:pt x="653143" y="0"/>
                  </a:cubicBezTo>
                  <a:cubicBezTo>
                    <a:pt x="754743" y="0"/>
                    <a:pt x="919238" y="682172"/>
                    <a:pt x="1001486" y="783772"/>
                  </a:cubicBezTo>
                  <a:cubicBezTo>
                    <a:pt x="1083734" y="885372"/>
                    <a:pt x="1083734" y="558800"/>
                    <a:pt x="1146629" y="609600"/>
                  </a:cubicBezTo>
                  <a:cubicBezTo>
                    <a:pt x="1209524" y="660400"/>
                    <a:pt x="1294190" y="874486"/>
                    <a:pt x="1378857" y="1088572"/>
                  </a:cubicBezTo>
                </a:path>
              </a:pathLst>
            </a:custGeom>
            <a:noFill/>
            <a:ln w="254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32E5C659-EA5E-982E-D688-1ED1DFF8867F}"/>
              </a:ext>
            </a:extLst>
          </p:cNvPr>
          <p:cNvGrpSpPr/>
          <p:nvPr/>
        </p:nvGrpSpPr>
        <p:grpSpPr>
          <a:xfrm rot="5400000">
            <a:off x="3293159" y="2343273"/>
            <a:ext cx="530300" cy="523618"/>
            <a:chOff x="-2222260" y="2138779"/>
            <a:chExt cx="1371600" cy="1147020"/>
          </a:xfrm>
        </p:grpSpPr>
        <p:sp>
          <p:nvSpPr>
            <p:cNvPr id="55" name="フリーフォーム: 図形 54">
              <a:extLst>
                <a:ext uri="{FF2B5EF4-FFF2-40B4-BE49-F238E27FC236}">
                  <a16:creationId xmlns:a16="http://schemas.microsoft.com/office/drawing/2014/main" id="{EBE7BD97-07D5-6C4D-32F6-8D6C5B3908B2}"/>
                </a:ext>
              </a:extLst>
            </p:cNvPr>
            <p:cNvSpPr/>
            <p:nvPr/>
          </p:nvSpPr>
          <p:spPr>
            <a:xfrm>
              <a:off x="-2222260" y="2499789"/>
              <a:ext cx="1371600" cy="398406"/>
            </a:xfrm>
            <a:custGeom>
              <a:avLst/>
              <a:gdLst>
                <a:gd name="connsiteX0" fmla="*/ 0 w 1371600"/>
                <a:gd name="connsiteY0" fmla="*/ 1143100 h 1158065"/>
                <a:gd name="connsiteX1" fmla="*/ 426720 w 1371600"/>
                <a:gd name="connsiteY1" fmla="*/ 998320 h 1158065"/>
                <a:gd name="connsiteX2" fmla="*/ 624840 w 1371600"/>
                <a:gd name="connsiteY2" fmla="*/ 100 h 1158065"/>
                <a:gd name="connsiteX3" fmla="*/ 1005840 w 1371600"/>
                <a:gd name="connsiteY3" fmla="*/ 937360 h 1158065"/>
                <a:gd name="connsiteX4" fmla="*/ 1371600 w 1371600"/>
                <a:gd name="connsiteY4" fmla="*/ 1089760 h 11580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371600" h="1158065">
                  <a:moveTo>
                    <a:pt x="0" y="1143100"/>
                  </a:moveTo>
                  <a:cubicBezTo>
                    <a:pt x="161290" y="1165960"/>
                    <a:pt x="322580" y="1188820"/>
                    <a:pt x="426720" y="998320"/>
                  </a:cubicBezTo>
                  <a:cubicBezTo>
                    <a:pt x="530860" y="807820"/>
                    <a:pt x="528320" y="10260"/>
                    <a:pt x="624840" y="100"/>
                  </a:cubicBezTo>
                  <a:cubicBezTo>
                    <a:pt x="721360" y="-10060"/>
                    <a:pt x="881380" y="755750"/>
                    <a:pt x="1005840" y="937360"/>
                  </a:cubicBezTo>
                  <a:cubicBezTo>
                    <a:pt x="1130300" y="1118970"/>
                    <a:pt x="1250950" y="1104365"/>
                    <a:pt x="1371600" y="1089760"/>
                  </a:cubicBezTo>
                </a:path>
              </a:pathLst>
            </a:custGeom>
            <a:noFill/>
            <a:ln w="25400" cap="flat" cmpd="sng" algn="ctr">
              <a:solidFill>
                <a:srgbClr val="00B05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6" name="フリーフォーム: 図形 55">
              <a:extLst>
                <a:ext uri="{FF2B5EF4-FFF2-40B4-BE49-F238E27FC236}">
                  <a16:creationId xmlns:a16="http://schemas.microsoft.com/office/drawing/2014/main" id="{3FC0DA64-B222-47D2-BC6F-DDAA0BC554EA}"/>
                </a:ext>
              </a:extLst>
            </p:cNvPr>
            <p:cNvSpPr/>
            <p:nvPr/>
          </p:nvSpPr>
          <p:spPr>
            <a:xfrm>
              <a:off x="-2191780" y="3020533"/>
              <a:ext cx="1341120" cy="265266"/>
            </a:xfrm>
            <a:custGeom>
              <a:avLst/>
              <a:gdLst>
                <a:gd name="connsiteX0" fmla="*/ 0 w 1341120"/>
                <a:gd name="connsiteY0" fmla="*/ 541023 h 544768"/>
                <a:gd name="connsiteX1" fmla="*/ 944880 w 1341120"/>
                <a:gd name="connsiteY1" fmla="*/ 464823 h 544768"/>
                <a:gd name="connsiteX2" fmla="*/ 1104900 w 1341120"/>
                <a:gd name="connsiteY2" fmla="*/ 3 h 544768"/>
                <a:gd name="connsiteX3" fmla="*/ 1341120 w 1341120"/>
                <a:gd name="connsiteY3" fmla="*/ 472443 h 5447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41120" h="544768">
                  <a:moveTo>
                    <a:pt x="0" y="541023"/>
                  </a:moveTo>
                  <a:cubicBezTo>
                    <a:pt x="380365" y="548008"/>
                    <a:pt x="760730" y="554993"/>
                    <a:pt x="944880" y="464823"/>
                  </a:cubicBezTo>
                  <a:cubicBezTo>
                    <a:pt x="1129030" y="374653"/>
                    <a:pt x="1038860" y="-1267"/>
                    <a:pt x="1104900" y="3"/>
                  </a:cubicBezTo>
                  <a:cubicBezTo>
                    <a:pt x="1170940" y="1273"/>
                    <a:pt x="1256030" y="236858"/>
                    <a:pt x="1341120" y="472443"/>
                  </a:cubicBezTo>
                </a:path>
              </a:pathLst>
            </a:custGeom>
            <a:noFill/>
            <a:ln w="25400" cap="flat" cmpd="sng" algn="ctr">
              <a:solidFill>
                <a:srgbClr val="00B0F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7" name="フリーフォーム: 図形 56">
              <a:extLst>
                <a:ext uri="{FF2B5EF4-FFF2-40B4-BE49-F238E27FC236}">
                  <a16:creationId xmlns:a16="http://schemas.microsoft.com/office/drawing/2014/main" id="{E5DB7B44-9ACF-AD15-0278-56CE5AEE4C34}"/>
                </a:ext>
              </a:extLst>
            </p:cNvPr>
            <p:cNvSpPr/>
            <p:nvPr/>
          </p:nvSpPr>
          <p:spPr>
            <a:xfrm>
              <a:off x="-2213636" y="2138779"/>
              <a:ext cx="1356360" cy="256928"/>
            </a:xfrm>
            <a:custGeom>
              <a:avLst/>
              <a:gdLst>
                <a:gd name="connsiteX0" fmla="*/ 0 w 1356360"/>
                <a:gd name="connsiteY0" fmla="*/ 741132 h 741132"/>
                <a:gd name="connsiteX1" fmla="*/ 114300 w 1356360"/>
                <a:gd name="connsiteY1" fmla="*/ 1992 h 741132"/>
                <a:gd name="connsiteX2" fmla="*/ 411480 w 1356360"/>
                <a:gd name="connsiteY2" fmla="*/ 527772 h 741132"/>
                <a:gd name="connsiteX3" fmla="*/ 1356360 w 1356360"/>
                <a:gd name="connsiteY3" fmla="*/ 664932 h 7411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56360" h="741132">
                  <a:moveTo>
                    <a:pt x="0" y="741132"/>
                  </a:moveTo>
                  <a:cubicBezTo>
                    <a:pt x="22860" y="389342"/>
                    <a:pt x="45720" y="37552"/>
                    <a:pt x="114300" y="1992"/>
                  </a:cubicBezTo>
                  <a:cubicBezTo>
                    <a:pt x="182880" y="-33568"/>
                    <a:pt x="204470" y="417282"/>
                    <a:pt x="411480" y="527772"/>
                  </a:cubicBezTo>
                  <a:cubicBezTo>
                    <a:pt x="618490" y="638262"/>
                    <a:pt x="987425" y="651597"/>
                    <a:pt x="1356360" y="664932"/>
                  </a:cubicBezTo>
                </a:path>
              </a:pathLst>
            </a:custGeom>
            <a:noFill/>
            <a:ln w="25400" cap="flat" cmpd="sng" algn="ctr">
              <a:solidFill>
                <a:srgbClr val="FF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778266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108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5FA2E95-EAC6-19CC-9A82-625530779040}"/>
              </a:ext>
            </a:extLst>
          </p:cNvPr>
          <p:cNvSpPr txBox="1"/>
          <p:nvPr/>
        </p:nvSpPr>
        <p:spPr>
          <a:xfrm>
            <a:off x="3859827" y="2516772"/>
            <a:ext cx="1127503" cy="21586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＊ </a:t>
            </a: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108" b="0" i="0" u="none" strike="noStrike" kern="1200" cap="none" spc="0" normalizeH="0" baseline="0" noProof="0" err="1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L</a:t>
            </a: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108" b="0" i="0" u="none" strike="noStrike" kern="1200" cap="none" spc="0" normalizeH="0" baseline="0" noProof="0" err="1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M</a:t>
            </a: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</a:t>
            </a:r>
            <a:r>
              <a:rPr kumimoji="1" lang="en-US" altLang="ja-JP" sz="1108" b="0" i="0" u="none" strike="noStrike" kern="1200" cap="none" spc="0" normalizeH="0" baseline="0" noProof="0" err="1">
                <a:ln>
                  <a:noFill/>
                </a:ln>
                <a:solidFill>
                  <a:srgbClr val="00B0F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xN</a:t>
            </a: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)</a:t>
            </a:r>
            <a:endParaRPr kumimoji="1" lang="ja-JP" altLang="en-US" sz="1108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9" name="大かっこ 58">
            <a:extLst>
              <a:ext uri="{FF2B5EF4-FFF2-40B4-BE49-F238E27FC236}">
                <a16:creationId xmlns:a16="http://schemas.microsoft.com/office/drawing/2014/main" id="{D653DF21-4215-BC24-B042-80D042356A05}"/>
              </a:ext>
            </a:extLst>
          </p:cNvPr>
          <p:cNvSpPr/>
          <p:nvPr/>
        </p:nvSpPr>
        <p:spPr>
          <a:xfrm rot="5400000">
            <a:off x="3238389" y="2326604"/>
            <a:ext cx="664865" cy="591306"/>
          </a:xfrm>
          <a:prstGeom prst="bracketPair">
            <a:avLst>
              <a:gd name="adj" fmla="val 10684"/>
            </a:avLst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0" name="矢印: 右 59">
            <a:extLst>
              <a:ext uri="{FF2B5EF4-FFF2-40B4-BE49-F238E27FC236}">
                <a16:creationId xmlns:a16="http://schemas.microsoft.com/office/drawing/2014/main" id="{73FDFD2A-146D-27AF-C593-348970050AFB}"/>
              </a:ext>
            </a:extLst>
          </p:cNvPr>
          <p:cNvSpPr/>
          <p:nvPr/>
        </p:nvSpPr>
        <p:spPr>
          <a:xfrm>
            <a:off x="2896058" y="2488770"/>
            <a:ext cx="222327" cy="283967"/>
          </a:xfrm>
          <a:prstGeom prst="rightArrow">
            <a:avLst/>
          </a:prstGeom>
          <a:noFill/>
          <a:ln w="25400" cap="flat" cmpd="sng" algn="ctr">
            <a:solidFill>
              <a:sysClr val="windowText" lastClr="000000">
                <a:lumMod val="50000"/>
                <a:lumOff val="50000"/>
              </a:sysClr>
            </a:solidFill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4B32396-8449-EE64-B4B2-6CEB6B80DF1F}"/>
              </a:ext>
            </a:extLst>
          </p:cNvPr>
          <p:cNvSpPr txBox="1"/>
          <p:nvPr/>
        </p:nvSpPr>
        <p:spPr>
          <a:xfrm>
            <a:off x="4973619" y="2517907"/>
            <a:ext cx="578458" cy="21586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＋    </a:t>
            </a:r>
            <a:r>
              <a:rPr kumimoji="1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Δ</a:t>
            </a:r>
            <a:endParaRPr kumimoji="1" lang="ja-JP" altLang="en-US" sz="1108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7C37D89-17A5-50D3-9052-B14A2BEE7F6F}"/>
              </a:ext>
            </a:extLst>
          </p:cNvPr>
          <p:cNvSpPr txBox="1"/>
          <p:nvPr/>
        </p:nvSpPr>
        <p:spPr>
          <a:xfrm>
            <a:off x="1694637" y="2013380"/>
            <a:ext cx="1383642" cy="194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0" i="0" u="sng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mage at one pixel</a:t>
            </a:r>
            <a:endParaRPr kumimoji="1" lang="ja-JP" altLang="en-US" sz="1108" b="0" i="0" u="sng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3" name="四角形: 角を丸くする 62">
            <a:extLst>
              <a:ext uri="{FF2B5EF4-FFF2-40B4-BE49-F238E27FC236}">
                <a16:creationId xmlns:a16="http://schemas.microsoft.com/office/drawing/2014/main" id="{D2CB2AAF-F110-BAEB-F9DF-FB1D369DD13C}"/>
              </a:ext>
            </a:extLst>
          </p:cNvPr>
          <p:cNvSpPr/>
          <p:nvPr/>
        </p:nvSpPr>
        <p:spPr>
          <a:xfrm>
            <a:off x="5291487" y="2247864"/>
            <a:ext cx="204912" cy="765772"/>
          </a:xfrm>
          <a:prstGeom prst="roundRect">
            <a:avLst>
              <a:gd name="adj" fmla="val 0"/>
            </a:avLst>
          </a:prstGeom>
          <a:solidFill>
            <a:sysClr val="windowText" lastClr="000000">
              <a:lumMod val="50000"/>
              <a:lumOff val="50000"/>
              <a:alpha val="10196"/>
            </a:sysClr>
          </a:solidFill>
          <a:ln w="25400" cap="flat" cmpd="sng" algn="ctr">
            <a:noFill/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5" name="矢印: 右 64">
            <a:extLst>
              <a:ext uri="{FF2B5EF4-FFF2-40B4-BE49-F238E27FC236}">
                <a16:creationId xmlns:a16="http://schemas.microsoft.com/office/drawing/2014/main" id="{0AFEED6A-271F-C36F-62FA-68DAD560377B}"/>
              </a:ext>
            </a:extLst>
          </p:cNvPr>
          <p:cNvSpPr/>
          <p:nvPr/>
        </p:nvSpPr>
        <p:spPr>
          <a:xfrm rot="5400000">
            <a:off x="3390235" y="1967491"/>
            <a:ext cx="357423" cy="184483"/>
          </a:xfrm>
          <a:prstGeom prst="rightArrow">
            <a:avLst/>
          </a:prstGeom>
          <a:solidFill>
            <a:srgbClr val="C0504D">
              <a:lumMod val="40000"/>
              <a:lumOff val="60000"/>
            </a:srgbClr>
          </a:solidFill>
          <a:ln>
            <a:solidFill>
              <a:srgbClr val="C0504D">
                <a:lumMod val="40000"/>
                <a:lumOff val="60000"/>
              </a:srgbClr>
            </a:solidFill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F45B6F61-0152-4B31-CE14-2BE02F84542F}"/>
              </a:ext>
            </a:extLst>
          </p:cNvPr>
          <p:cNvSpPr/>
          <p:nvPr/>
        </p:nvSpPr>
        <p:spPr>
          <a:xfrm>
            <a:off x="2271944" y="1602660"/>
            <a:ext cx="500231" cy="38956"/>
          </a:xfrm>
          <a:prstGeom prst="rect">
            <a:avLst/>
          </a:prstGeom>
          <a:noFill/>
          <a:ln w="12700" cap="flat" cmpd="sng" algn="ctr">
            <a:solidFill>
              <a:sysClr val="windowText" lastClr="000000">
                <a:lumMod val="50000"/>
                <a:lumOff val="50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70" name="Picture 4">
            <a:extLst>
              <a:ext uri="{FF2B5EF4-FFF2-40B4-BE49-F238E27FC236}">
                <a16:creationId xmlns:a16="http://schemas.microsoft.com/office/drawing/2014/main" id="{6AB048D5-2DE5-E851-F5B1-45C6760EED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8271" y="4143513"/>
            <a:ext cx="1675512" cy="1832859"/>
          </a:xfrm>
          <a:prstGeom prst="rect">
            <a:avLst/>
          </a:prstGeom>
          <a:noFill/>
          <a:ln>
            <a:noFill/>
          </a:ln>
          <a:effectLst/>
          <a:scene3d>
            <a:camera prst="isometricOffAxis2Top">
              <a:rot lat="18075712" lon="3207255" rev="18441437"/>
            </a:camera>
            <a:lightRig rig="threePt" dir="t"/>
          </a:scene3d>
          <a:sp3d prstMaterial="powder">
            <a:bevelB w="0" h="69850"/>
          </a:sp3d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1" name="右大かっこ 70">
            <a:extLst>
              <a:ext uri="{FF2B5EF4-FFF2-40B4-BE49-F238E27FC236}">
                <a16:creationId xmlns:a16="http://schemas.microsoft.com/office/drawing/2014/main" id="{622AD731-30A9-36F0-BB69-BC2B60697658}"/>
              </a:ext>
            </a:extLst>
          </p:cNvPr>
          <p:cNvSpPr/>
          <p:nvPr/>
        </p:nvSpPr>
        <p:spPr>
          <a:xfrm>
            <a:off x="4617873" y="3464800"/>
            <a:ext cx="100615" cy="946042"/>
          </a:xfrm>
          <a:prstGeom prst="rightBracket">
            <a:avLst>
              <a:gd name="adj" fmla="val 140089"/>
            </a:avLst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9EA3D1A-0996-14C3-E3AB-A85FBA9F40A3}"/>
              </a:ext>
            </a:extLst>
          </p:cNvPr>
          <p:cNvSpPr txBox="1"/>
          <p:nvPr/>
        </p:nvSpPr>
        <p:spPr>
          <a:xfrm>
            <a:off x="4613884" y="3659795"/>
            <a:ext cx="1056492" cy="262829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1108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</a:t>
            </a:r>
          </a:p>
        </p:txBody>
      </p:sp>
      <p:sp>
        <p:nvSpPr>
          <p:cNvPr id="73" name="右大かっこ 72">
            <a:extLst>
              <a:ext uri="{FF2B5EF4-FFF2-40B4-BE49-F238E27FC236}">
                <a16:creationId xmlns:a16="http://schemas.microsoft.com/office/drawing/2014/main" id="{D9F66B47-4117-728F-511A-F36F8929454E}"/>
              </a:ext>
            </a:extLst>
          </p:cNvPr>
          <p:cNvSpPr/>
          <p:nvPr/>
        </p:nvSpPr>
        <p:spPr>
          <a:xfrm rot="5598235">
            <a:off x="3914479" y="4687010"/>
            <a:ext cx="38956" cy="1530395"/>
          </a:xfrm>
          <a:prstGeom prst="rightBracket">
            <a:avLst>
              <a:gd name="adj" fmla="val 191832"/>
            </a:avLst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8541F15-DDB4-D600-3099-8C177B3D22B1}"/>
              </a:ext>
            </a:extLst>
          </p:cNvPr>
          <p:cNvSpPr txBox="1"/>
          <p:nvPr/>
        </p:nvSpPr>
        <p:spPr>
          <a:xfrm>
            <a:off x="3591185" y="5425968"/>
            <a:ext cx="508473" cy="262829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1108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 pix</a:t>
            </a:r>
          </a:p>
        </p:txBody>
      </p:sp>
      <p:sp>
        <p:nvSpPr>
          <p:cNvPr id="75" name="右大かっこ 74">
            <a:extLst>
              <a:ext uri="{FF2B5EF4-FFF2-40B4-BE49-F238E27FC236}">
                <a16:creationId xmlns:a16="http://schemas.microsoft.com/office/drawing/2014/main" id="{9C4653B1-9369-D6DF-7D7F-3691EB716F99}"/>
              </a:ext>
            </a:extLst>
          </p:cNvPr>
          <p:cNvSpPr/>
          <p:nvPr/>
        </p:nvSpPr>
        <p:spPr>
          <a:xfrm rot="13900972">
            <a:off x="3433957" y="4470267"/>
            <a:ext cx="100097" cy="928806"/>
          </a:xfrm>
          <a:prstGeom prst="rightBracket">
            <a:avLst>
              <a:gd name="adj" fmla="val 140089"/>
            </a:avLst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6E830FC-5E29-5379-4D2C-1DD30AC1EC35}"/>
              </a:ext>
            </a:extLst>
          </p:cNvPr>
          <p:cNvSpPr txBox="1"/>
          <p:nvPr/>
        </p:nvSpPr>
        <p:spPr>
          <a:xfrm>
            <a:off x="3085927" y="4722169"/>
            <a:ext cx="500458" cy="262829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1108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 pix</a:t>
            </a:r>
          </a:p>
        </p:txBody>
      </p: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DD888AA4-B237-DB5F-2B85-1707BBA27AC4}"/>
              </a:ext>
            </a:extLst>
          </p:cNvPr>
          <p:cNvCxnSpPr>
            <a:cxnSpLocks/>
          </p:cNvCxnSpPr>
          <p:nvPr/>
        </p:nvCxnSpPr>
        <p:spPr>
          <a:xfrm flipH="1" flipV="1">
            <a:off x="4130313" y="4592576"/>
            <a:ext cx="182067" cy="415506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A766BA95-3B5A-7697-3D04-F7A2A419C1B3}"/>
              </a:ext>
            </a:extLst>
          </p:cNvPr>
          <p:cNvCxnSpPr>
            <a:cxnSpLocks/>
          </p:cNvCxnSpPr>
          <p:nvPr/>
        </p:nvCxnSpPr>
        <p:spPr>
          <a:xfrm flipV="1">
            <a:off x="4349579" y="4442523"/>
            <a:ext cx="249228" cy="565561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979D5347-4ED1-FA95-BB80-0342EE492635}"/>
              </a:ext>
            </a:extLst>
          </p:cNvPr>
          <p:cNvCxnSpPr>
            <a:cxnSpLocks/>
          </p:cNvCxnSpPr>
          <p:nvPr/>
        </p:nvCxnSpPr>
        <p:spPr>
          <a:xfrm>
            <a:off x="4502913" y="4461361"/>
            <a:ext cx="646391" cy="148722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</p:cxn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6253CF87-9A17-1C39-59CD-C845F9321E6C}"/>
              </a:ext>
            </a:extLst>
          </p:cNvPr>
          <p:cNvSpPr txBox="1"/>
          <p:nvPr/>
        </p:nvSpPr>
        <p:spPr>
          <a:xfrm>
            <a:off x="5165335" y="4548599"/>
            <a:ext cx="621348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1108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</a:t>
            </a:r>
          </a:p>
        </p:txBody>
      </p: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DD27ED57-726C-3169-140E-0880CD5DFE1F}"/>
              </a:ext>
            </a:extLst>
          </p:cNvPr>
          <p:cNvCxnSpPr>
            <a:cxnSpLocks/>
          </p:cNvCxnSpPr>
          <p:nvPr/>
        </p:nvCxnSpPr>
        <p:spPr>
          <a:xfrm>
            <a:off x="2111285" y="4176519"/>
            <a:ext cx="149388" cy="324875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</p:cxn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A9623BA4-3205-2E7E-0050-F4E8F13143E1}"/>
              </a:ext>
            </a:extLst>
          </p:cNvPr>
          <p:cNvSpPr txBox="1"/>
          <p:nvPr/>
        </p:nvSpPr>
        <p:spPr>
          <a:xfrm>
            <a:off x="2142008" y="4499220"/>
            <a:ext cx="30328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1108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1DDA5A48-BC0E-B704-32AF-1649FB3C6A3D}"/>
              </a:ext>
            </a:extLst>
          </p:cNvPr>
          <p:cNvSpPr txBox="1"/>
          <p:nvPr/>
        </p:nvSpPr>
        <p:spPr>
          <a:xfrm>
            <a:off x="4977226" y="5308936"/>
            <a:ext cx="633507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sz="1108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ensor</a:t>
            </a:r>
          </a:p>
        </p:txBody>
      </p: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0E5C190F-6BCA-7C84-50CF-5C5522EFF0C0}"/>
              </a:ext>
            </a:extLst>
          </p:cNvPr>
          <p:cNvCxnSpPr>
            <a:cxnSpLocks/>
            <a:endCxn id="104" idx="0"/>
          </p:cNvCxnSpPr>
          <p:nvPr/>
        </p:nvCxnSpPr>
        <p:spPr>
          <a:xfrm>
            <a:off x="4977243" y="5195535"/>
            <a:ext cx="316737" cy="113401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</p:cxn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ADBE52B0-476C-4695-B261-EA91B9F3793E}"/>
              </a:ext>
            </a:extLst>
          </p:cNvPr>
          <p:cNvSpPr txBox="1"/>
          <p:nvPr/>
        </p:nvSpPr>
        <p:spPr>
          <a:xfrm>
            <a:off x="356004" y="864384"/>
            <a:ext cx="27122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1108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47A46D6C-D1A2-2E7B-427B-56DD5DBDDBEB}"/>
              </a:ext>
            </a:extLst>
          </p:cNvPr>
          <p:cNvSpPr txBox="1"/>
          <p:nvPr/>
        </p:nvSpPr>
        <p:spPr>
          <a:xfrm>
            <a:off x="356004" y="3204974"/>
            <a:ext cx="271228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8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1108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76A9C13C-AA7E-8D41-E6FD-8385C96C9CA4}"/>
              </a:ext>
            </a:extLst>
          </p:cNvPr>
          <p:cNvGrpSpPr/>
          <p:nvPr/>
        </p:nvGrpSpPr>
        <p:grpSpPr>
          <a:xfrm>
            <a:off x="4137341" y="3445083"/>
            <a:ext cx="456984" cy="1173891"/>
            <a:chOff x="6406592" y="4970919"/>
            <a:chExt cx="545689" cy="1401758"/>
          </a:xfrm>
        </p:grpSpPr>
        <p:sp>
          <p:nvSpPr>
            <p:cNvPr id="162" name="正方形/長方形 161">
              <a:extLst>
                <a:ext uri="{FF2B5EF4-FFF2-40B4-BE49-F238E27FC236}">
                  <a16:creationId xmlns:a16="http://schemas.microsoft.com/office/drawing/2014/main" id="{9CA8D700-CBDB-C9B1-6184-5797F09730E8}"/>
                </a:ext>
              </a:extLst>
            </p:cNvPr>
            <p:cNvSpPr/>
            <p:nvPr/>
          </p:nvSpPr>
          <p:spPr>
            <a:xfrm>
              <a:off x="6576098" y="4975785"/>
              <a:ext cx="371420" cy="114947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 anchorCtr="1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id="{11E1AE99-CF66-3042-79BC-70A0A0F0186B}"/>
                </a:ext>
              </a:extLst>
            </p:cNvPr>
            <p:cNvCxnSpPr/>
            <p:nvPr/>
          </p:nvCxnSpPr>
          <p:spPr>
            <a:xfrm flipV="1">
              <a:off x="6406592" y="4970919"/>
              <a:ext cx="169507" cy="24454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401552FA-9DC7-837D-0782-F88F70E4E315}"/>
                </a:ext>
              </a:extLst>
            </p:cNvPr>
            <p:cNvCxnSpPr/>
            <p:nvPr/>
          </p:nvCxnSpPr>
          <p:spPr>
            <a:xfrm flipV="1">
              <a:off x="6778012" y="4975785"/>
              <a:ext cx="169506" cy="24454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BAFCE40E-E956-0CB8-9CC6-7D12B6A6F898}"/>
                </a:ext>
              </a:extLst>
            </p:cNvPr>
            <p:cNvCxnSpPr/>
            <p:nvPr/>
          </p:nvCxnSpPr>
          <p:spPr>
            <a:xfrm flipV="1">
              <a:off x="6782774" y="6128132"/>
              <a:ext cx="169507" cy="24454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B2D6A144-7817-B954-50BD-CEDD9B35C8BE}"/>
                </a:ext>
              </a:extLst>
            </p:cNvPr>
            <p:cNvCxnSpPr/>
            <p:nvPr/>
          </p:nvCxnSpPr>
          <p:spPr>
            <a:xfrm flipV="1">
              <a:off x="6411355" y="6117515"/>
              <a:ext cx="169506" cy="244545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67" name="グループ化 166">
              <a:extLst>
                <a:ext uri="{FF2B5EF4-FFF2-40B4-BE49-F238E27FC236}">
                  <a16:creationId xmlns:a16="http://schemas.microsoft.com/office/drawing/2014/main" id="{CE2D23F9-D58D-00C7-7736-3CBF5888274F}"/>
                </a:ext>
              </a:extLst>
            </p:cNvPr>
            <p:cNvGrpSpPr/>
            <p:nvPr/>
          </p:nvGrpSpPr>
          <p:grpSpPr>
            <a:xfrm>
              <a:off x="6453316" y="5316480"/>
              <a:ext cx="255089" cy="256497"/>
              <a:chOff x="168697" y="4098267"/>
              <a:chExt cx="435966" cy="438372"/>
            </a:xfrm>
          </p:grpSpPr>
          <p:grpSp>
            <p:nvGrpSpPr>
              <p:cNvPr id="205" name="グループ化 204">
                <a:extLst>
                  <a:ext uri="{FF2B5EF4-FFF2-40B4-BE49-F238E27FC236}">
                    <a16:creationId xmlns:a16="http://schemas.microsoft.com/office/drawing/2014/main" id="{E2178B0E-E97C-BDB1-EDED-613C114A1C91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207" name="グループ化 206">
                  <a:extLst>
                    <a:ext uri="{FF2B5EF4-FFF2-40B4-BE49-F238E27FC236}">
                      <a16:creationId xmlns:a16="http://schemas.microsoft.com/office/drawing/2014/main" id="{F8C6BD90-A22D-FAC0-3B04-995F598381EA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13" name="直線コネクタ 212">
                    <a:extLst>
                      <a:ext uri="{FF2B5EF4-FFF2-40B4-BE49-F238E27FC236}">
                        <a16:creationId xmlns:a16="http://schemas.microsoft.com/office/drawing/2014/main" id="{42EEC9F4-7E1D-31CA-5C2D-FE4BAA9665EA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4" name="直線コネクタ 213">
                    <a:extLst>
                      <a:ext uri="{FF2B5EF4-FFF2-40B4-BE49-F238E27FC236}">
                        <a16:creationId xmlns:a16="http://schemas.microsoft.com/office/drawing/2014/main" id="{33248B06-B044-F030-FDD0-484F72FC907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5" name="直線コネクタ 214">
                    <a:extLst>
                      <a:ext uri="{FF2B5EF4-FFF2-40B4-BE49-F238E27FC236}">
                        <a16:creationId xmlns:a16="http://schemas.microsoft.com/office/drawing/2014/main" id="{511E03DD-44DE-143B-4517-F3B7F15532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8" name="グループ化 207">
                  <a:extLst>
                    <a:ext uri="{FF2B5EF4-FFF2-40B4-BE49-F238E27FC236}">
                      <a16:creationId xmlns:a16="http://schemas.microsoft.com/office/drawing/2014/main" id="{9EA3460A-7EB6-F9AA-536B-1967AEFC7026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09" name="直線コネクタ 208">
                    <a:extLst>
                      <a:ext uri="{FF2B5EF4-FFF2-40B4-BE49-F238E27FC236}">
                        <a16:creationId xmlns:a16="http://schemas.microsoft.com/office/drawing/2014/main" id="{3E92C896-9608-8A99-DA90-F413AE88761B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0" name="直線コネクタ 209">
                    <a:extLst>
                      <a:ext uri="{FF2B5EF4-FFF2-40B4-BE49-F238E27FC236}">
                        <a16:creationId xmlns:a16="http://schemas.microsoft.com/office/drawing/2014/main" id="{2013500D-A6DB-96A8-65C3-D9C3E01AB2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1" name="直線コネクタ 210">
                    <a:extLst>
                      <a:ext uri="{FF2B5EF4-FFF2-40B4-BE49-F238E27FC236}">
                        <a16:creationId xmlns:a16="http://schemas.microsoft.com/office/drawing/2014/main" id="{E6F2807C-83FB-1046-4D34-1153B5B9CF9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2" name="直線コネクタ 211">
                    <a:extLst>
                      <a:ext uri="{FF2B5EF4-FFF2-40B4-BE49-F238E27FC236}">
                        <a16:creationId xmlns:a16="http://schemas.microsoft.com/office/drawing/2014/main" id="{BE5D611F-6C71-0316-849D-9700F7A3276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06" name="楕円 205">
                <a:extLst>
                  <a:ext uri="{FF2B5EF4-FFF2-40B4-BE49-F238E27FC236}">
                    <a16:creationId xmlns:a16="http://schemas.microsoft.com/office/drawing/2014/main" id="{3C249534-A0FA-5456-9E6A-D8C6FCA0F734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8" name="グループ化 167">
              <a:extLst>
                <a:ext uri="{FF2B5EF4-FFF2-40B4-BE49-F238E27FC236}">
                  <a16:creationId xmlns:a16="http://schemas.microsoft.com/office/drawing/2014/main" id="{1A3CFDB1-EF31-4BCF-D0A9-32274DAE3263}"/>
                </a:ext>
              </a:extLst>
            </p:cNvPr>
            <p:cNvGrpSpPr/>
            <p:nvPr/>
          </p:nvGrpSpPr>
          <p:grpSpPr>
            <a:xfrm rot="3565643">
              <a:off x="6649016" y="5489369"/>
              <a:ext cx="255089" cy="256497"/>
              <a:chOff x="168697" y="4098267"/>
              <a:chExt cx="435966" cy="438372"/>
            </a:xfrm>
          </p:grpSpPr>
          <p:grpSp>
            <p:nvGrpSpPr>
              <p:cNvPr id="194" name="グループ化 193">
                <a:extLst>
                  <a:ext uri="{FF2B5EF4-FFF2-40B4-BE49-F238E27FC236}">
                    <a16:creationId xmlns:a16="http://schemas.microsoft.com/office/drawing/2014/main" id="{9A205267-772B-8CF5-F4EF-678EA1640B1E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196" name="グループ化 195">
                  <a:extLst>
                    <a:ext uri="{FF2B5EF4-FFF2-40B4-BE49-F238E27FC236}">
                      <a16:creationId xmlns:a16="http://schemas.microsoft.com/office/drawing/2014/main" id="{1CCEA87E-6ADF-3719-5AB1-369343305AD9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02" name="直線コネクタ 201">
                    <a:extLst>
                      <a:ext uri="{FF2B5EF4-FFF2-40B4-BE49-F238E27FC236}">
                        <a16:creationId xmlns:a16="http://schemas.microsoft.com/office/drawing/2014/main" id="{9D2ADC4E-E453-027F-B2A4-C90745364D5B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3" name="直線コネクタ 202">
                    <a:extLst>
                      <a:ext uri="{FF2B5EF4-FFF2-40B4-BE49-F238E27FC236}">
                        <a16:creationId xmlns:a16="http://schemas.microsoft.com/office/drawing/2014/main" id="{56205629-A515-0875-D1B6-4EB6E7F619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4" name="直線コネクタ 203">
                    <a:extLst>
                      <a:ext uri="{FF2B5EF4-FFF2-40B4-BE49-F238E27FC236}">
                        <a16:creationId xmlns:a16="http://schemas.microsoft.com/office/drawing/2014/main" id="{D65667AB-B4E5-2BA1-1564-EAC5543945D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7" name="グループ化 196">
                  <a:extLst>
                    <a:ext uri="{FF2B5EF4-FFF2-40B4-BE49-F238E27FC236}">
                      <a16:creationId xmlns:a16="http://schemas.microsoft.com/office/drawing/2014/main" id="{A03533F1-6B2D-6D57-CDAB-CD2C33B927D2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198" name="直線コネクタ 197">
                    <a:extLst>
                      <a:ext uri="{FF2B5EF4-FFF2-40B4-BE49-F238E27FC236}">
                        <a16:creationId xmlns:a16="http://schemas.microsoft.com/office/drawing/2014/main" id="{A95798B0-E17B-4A6E-7020-0EC5E5408C1B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直線コネクタ 198">
                    <a:extLst>
                      <a:ext uri="{FF2B5EF4-FFF2-40B4-BE49-F238E27FC236}">
                        <a16:creationId xmlns:a16="http://schemas.microsoft.com/office/drawing/2014/main" id="{6913C656-9E8B-6CFF-C224-DF080BC1A62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直線コネクタ 199">
                    <a:extLst>
                      <a:ext uri="{FF2B5EF4-FFF2-40B4-BE49-F238E27FC236}">
                        <a16:creationId xmlns:a16="http://schemas.microsoft.com/office/drawing/2014/main" id="{19AD9FD4-F55B-3A3A-18AC-DE4F0315C02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1" name="直線コネクタ 200">
                    <a:extLst>
                      <a:ext uri="{FF2B5EF4-FFF2-40B4-BE49-F238E27FC236}">
                        <a16:creationId xmlns:a16="http://schemas.microsoft.com/office/drawing/2014/main" id="{747388E7-34C9-1568-C238-3408B489CBD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95" name="楕円 194">
                <a:extLst>
                  <a:ext uri="{FF2B5EF4-FFF2-40B4-BE49-F238E27FC236}">
                    <a16:creationId xmlns:a16="http://schemas.microsoft.com/office/drawing/2014/main" id="{DA4B8AD6-FDB5-3AB0-810B-2ACDFED2ED6F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9" name="グループ化 168">
              <a:extLst>
                <a:ext uri="{FF2B5EF4-FFF2-40B4-BE49-F238E27FC236}">
                  <a16:creationId xmlns:a16="http://schemas.microsoft.com/office/drawing/2014/main" id="{07C927E7-7593-7F85-7E5B-D181BD863E5B}"/>
                </a:ext>
              </a:extLst>
            </p:cNvPr>
            <p:cNvGrpSpPr/>
            <p:nvPr/>
          </p:nvGrpSpPr>
          <p:grpSpPr>
            <a:xfrm rot="8551401">
              <a:off x="6450892" y="5983677"/>
              <a:ext cx="255089" cy="256497"/>
              <a:chOff x="168697" y="4098267"/>
              <a:chExt cx="435966" cy="438372"/>
            </a:xfrm>
          </p:grpSpPr>
          <p:grpSp>
            <p:nvGrpSpPr>
              <p:cNvPr id="183" name="グループ化 182">
                <a:extLst>
                  <a:ext uri="{FF2B5EF4-FFF2-40B4-BE49-F238E27FC236}">
                    <a16:creationId xmlns:a16="http://schemas.microsoft.com/office/drawing/2014/main" id="{7CD7960B-2648-B4BB-5438-1D51DB6BD14F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185" name="グループ化 184">
                  <a:extLst>
                    <a:ext uri="{FF2B5EF4-FFF2-40B4-BE49-F238E27FC236}">
                      <a16:creationId xmlns:a16="http://schemas.microsoft.com/office/drawing/2014/main" id="{DECE053F-B432-C1B2-FDA0-E1418B1917E2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191" name="直線コネクタ 190">
                    <a:extLst>
                      <a:ext uri="{FF2B5EF4-FFF2-40B4-BE49-F238E27FC236}">
                        <a16:creationId xmlns:a16="http://schemas.microsoft.com/office/drawing/2014/main" id="{1301C66E-2FB0-B6D9-74D1-C5AF1DAC7B76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直線コネクタ 191">
                    <a:extLst>
                      <a:ext uri="{FF2B5EF4-FFF2-40B4-BE49-F238E27FC236}">
                        <a16:creationId xmlns:a16="http://schemas.microsoft.com/office/drawing/2014/main" id="{A17041CC-26B3-6EF1-1C27-A7811671D2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直線コネクタ 192">
                    <a:extLst>
                      <a:ext uri="{FF2B5EF4-FFF2-40B4-BE49-F238E27FC236}">
                        <a16:creationId xmlns:a16="http://schemas.microsoft.com/office/drawing/2014/main" id="{5B927AF0-CDB9-CC98-5013-19A429F599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86" name="グループ化 185">
                  <a:extLst>
                    <a:ext uri="{FF2B5EF4-FFF2-40B4-BE49-F238E27FC236}">
                      <a16:creationId xmlns:a16="http://schemas.microsoft.com/office/drawing/2014/main" id="{08553A1E-DBBB-63FE-A77F-2709D3A35826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187" name="直線コネクタ 186">
                    <a:extLst>
                      <a:ext uri="{FF2B5EF4-FFF2-40B4-BE49-F238E27FC236}">
                        <a16:creationId xmlns:a16="http://schemas.microsoft.com/office/drawing/2014/main" id="{75EF68A8-1EFC-FFCD-5805-30644ACED30F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直線コネクタ 187">
                    <a:extLst>
                      <a:ext uri="{FF2B5EF4-FFF2-40B4-BE49-F238E27FC236}">
                        <a16:creationId xmlns:a16="http://schemas.microsoft.com/office/drawing/2014/main" id="{9BBF9B31-00FA-793B-4D0D-858DCA0A56D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直線コネクタ 188">
                    <a:extLst>
                      <a:ext uri="{FF2B5EF4-FFF2-40B4-BE49-F238E27FC236}">
                        <a16:creationId xmlns:a16="http://schemas.microsoft.com/office/drawing/2014/main" id="{6CBFEE32-CF57-582A-93DE-653A568557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0" name="直線コネクタ 189">
                    <a:extLst>
                      <a:ext uri="{FF2B5EF4-FFF2-40B4-BE49-F238E27FC236}">
                        <a16:creationId xmlns:a16="http://schemas.microsoft.com/office/drawing/2014/main" id="{A3405664-2059-B449-3FF1-E6C6F8C1ACF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84" name="楕円 183">
                <a:extLst>
                  <a:ext uri="{FF2B5EF4-FFF2-40B4-BE49-F238E27FC236}">
                    <a16:creationId xmlns:a16="http://schemas.microsoft.com/office/drawing/2014/main" id="{54E110BB-8EFF-6140-8FF6-85098CC47567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0" name="グループ化 169">
              <a:extLst>
                <a:ext uri="{FF2B5EF4-FFF2-40B4-BE49-F238E27FC236}">
                  <a16:creationId xmlns:a16="http://schemas.microsoft.com/office/drawing/2014/main" id="{C5B376D5-9EDD-9137-EAB0-E427A4CA836F}"/>
                </a:ext>
              </a:extLst>
            </p:cNvPr>
            <p:cNvGrpSpPr/>
            <p:nvPr/>
          </p:nvGrpSpPr>
          <p:grpSpPr>
            <a:xfrm rot="7261200">
              <a:off x="6644337" y="5750705"/>
              <a:ext cx="255089" cy="256497"/>
              <a:chOff x="168697" y="4098267"/>
              <a:chExt cx="435966" cy="438372"/>
            </a:xfrm>
          </p:grpSpPr>
          <p:grpSp>
            <p:nvGrpSpPr>
              <p:cNvPr id="172" name="グループ化 171">
                <a:extLst>
                  <a:ext uri="{FF2B5EF4-FFF2-40B4-BE49-F238E27FC236}">
                    <a16:creationId xmlns:a16="http://schemas.microsoft.com/office/drawing/2014/main" id="{2BAB06E9-FC5C-4DC6-74C1-34CFF91D1425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174" name="グループ化 173">
                  <a:extLst>
                    <a:ext uri="{FF2B5EF4-FFF2-40B4-BE49-F238E27FC236}">
                      <a16:creationId xmlns:a16="http://schemas.microsoft.com/office/drawing/2014/main" id="{4EC23583-C9A7-AD9A-E825-1956CF88415D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180" name="直線コネクタ 179">
                    <a:extLst>
                      <a:ext uri="{FF2B5EF4-FFF2-40B4-BE49-F238E27FC236}">
                        <a16:creationId xmlns:a16="http://schemas.microsoft.com/office/drawing/2014/main" id="{2A018F75-0FFD-BC91-B7AC-5F9DF1A3DE2E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1" name="直線コネクタ 180">
                    <a:extLst>
                      <a:ext uri="{FF2B5EF4-FFF2-40B4-BE49-F238E27FC236}">
                        <a16:creationId xmlns:a16="http://schemas.microsoft.com/office/drawing/2014/main" id="{A608E04D-AD41-F5A0-28D2-B798322EFD4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2" name="直線コネクタ 181">
                    <a:extLst>
                      <a:ext uri="{FF2B5EF4-FFF2-40B4-BE49-F238E27FC236}">
                        <a16:creationId xmlns:a16="http://schemas.microsoft.com/office/drawing/2014/main" id="{AEEB210C-F376-D807-E98D-3C552171C72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75" name="グループ化 174">
                  <a:extLst>
                    <a:ext uri="{FF2B5EF4-FFF2-40B4-BE49-F238E27FC236}">
                      <a16:creationId xmlns:a16="http://schemas.microsoft.com/office/drawing/2014/main" id="{1A4AC3FD-82BB-71D8-7480-8CDE5FD4F66F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176" name="直線コネクタ 175">
                    <a:extLst>
                      <a:ext uri="{FF2B5EF4-FFF2-40B4-BE49-F238E27FC236}">
                        <a16:creationId xmlns:a16="http://schemas.microsoft.com/office/drawing/2014/main" id="{656DDD1B-0FFE-6F5B-00CD-1DD6C7D495BE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7" name="直線コネクタ 176">
                    <a:extLst>
                      <a:ext uri="{FF2B5EF4-FFF2-40B4-BE49-F238E27FC236}">
                        <a16:creationId xmlns:a16="http://schemas.microsoft.com/office/drawing/2014/main" id="{19C8F04A-FE07-C654-4A3B-394B976D075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8" name="直線コネクタ 177">
                    <a:extLst>
                      <a:ext uri="{FF2B5EF4-FFF2-40B4-BE49-F238E27FC236}">
                        <a16:creationId xmlns:a16="http://schemas.microsoft.com/office/drawing/2014/main" id="{A10F3A7D-335D-B08A-C916-6E2C8133938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直線コネクタ 178">
                    <a:extLst>
                      <a:ext uri="{FF2B5EF4-FFF2-40B4-BE49-F238E27FC236}">
                        <a16:creationId xmlns:a16="http://schemas.microsoft.com/office/drawing/2014/main" id="{218E25B5-ABE7-6BB7-3D67-3A6DA2D5CC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73" name="楕円 172">
                <a:extLst>
                  <a:ext uri="{FF2B5EF4-FFF2-40B4-BE49-F238E27FC236}">
                    <a16:creationId xmlns:a16="http://schemas.microsoft.com/office/drawing/2014/main" id="{F9D7C50A-5E41-7EF2-7965-F8A0FB763F75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1" name="正方形/長方形 170">
              <a:extLst>
                <a:ext uri="{FF2B5EF4-FFF2-40B4-BE49-F238E27FC236}">
                  <a16:creationId xmlns:a16="http://schemas.microsoft.com/office/drawing/2014/main" id="{AC96BA82-0BDB-E2FB-E1B9-884649EFD30C}"/>
                </a:ext>
              </a:extLst>
            </p:cNvPr>
            <p:cNvSpPr/>
            <p:nvPr/>
          </p:nvSpPr>
          <p:spPr>
            <a:xfrm>
              <a:off x="6406592" y="5220330"/>
              <a:ext cx="371420" cy="114947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 anchorCtr="1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16" name="グループ化 215">
            <a:extLst>
              <a:ext uri="{FF2B5EF4-FFF2-40B4-BE49-F238E27FC236}">
                <a16:creationId xmlns:a16="http://schemas.microsoft.com/office/drawing/2014/main" id="{556A308F-7518-5714-22B4-57E0830162C8}"/>
              </a:ext>
            </a:extLst>
          </p:cNvPr>
          <p:cNvGrpSpPr/>
          <p:nvPr/>
        </p:nvGrpSpPr>
        <p:grpSpPr>
          <a:xfrm>
            <a:off x="1885981" y="3783909"/>
            <a:ext cx="1240386" cy="487357"/>
            <a:chOff x="4385969" y="5818276"/>
            <a:chExt cx="1481159" cy="581958"/>
          </a:xfrm>
        </p:grpSpPr>
        <p:sp>
          <p:nvSpPr>
            <p:cNvPr id="217" name="フローチャート: データ 216">
              <a:extLst>
                <a:ext uri="{FF2B5EF4-FFF2-40B4-BE49-F238E27FC236}">
                  <a16:creationId xmlns:a16="http://schemas.microsoft.com/office/drawing/2014/main" id="{F8228E4C-E25B-7FDB-599F-D32DB9A63E9C}"/>
                </a:ext>
              </a:extLst>
            </p:cNvPr>
            <p:cNvSpPr/>
            <p:nvPr/>
          </p:nvSpPr>
          <p:spPr>
            <a:xfrm>
              <a:off x="4398081" y="6038122"/>
              <a:ext cx="1466564" cy="359752"/>
            </a:xfrm>
            <a:prstGeom prst="flowChartInputOutput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wrap="none" rtlCol="0" anchor="ctr" anchorCtr="1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18" name="直線コネクタ 217">
              <a:extLst>
                <a:ext uri="{FF2B5EF4-FFF2-40B4-BE49-F238E27FC236}">
                  <a16:creationId xmlns:a16="http://schemas.microsoft.com/office/drawing/2014/main" id="{AD02FF7D-D48F-21CC-C71D-D726BE852167}"/>
                </a:ext>
              </a:extLst>
            </p:cNvPr>
            <p:cNvCxnSpPr/>
            <p:nvPr/>
          </p:nvCxnSpPr>
          <p:spPr>
            <a:xfrm>
              <a:off x="4385969" y="6181073"/>
              <a:ext cx="0" cy="21916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9" name="直線コネクタ 218">
              <a:extLst>
                <a:ext uri="{FF2B5EF4-FFF2-40B4-BE49-F238E27FC236}">
                  <a16:creationId xmlns:a16="http://schemas.microsoft.com/office/drawing/2014/main" id="{60AE697E-9ACD-508A-9B7C-BC5C4D44F91E}"/>
                </a:ext>
              </a:extLst>
            </p:cNvPr>
            <p:cNvCxnSpPr/>
            <p:nvPr/>
          </p:nvCxnSpPr>
          <p:spPr>
            <a:xfrm>
              <a:off x="5572539" y="6177762"/>
              <a:ext cx="0" cy="21916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0" name="直線コネクタ 219">
              <a:extLst>
                <a:ext uri="{FF2B5EF4-FFF2-40B4-BE49-F238E27FC236}">
                  <a16:creationId xmlns:a16="http://schemas.microsoft.com/office/drawing/2014/main" id="{ACDBAE43-CE18-6CCB-4DA7-AE0D9A3AD477}"/>
                </a:ext>
              </a:extLst>
            </p:cNvPr>
            <p:cNvCxnSpPr/>
            <p:nvPr/>
          </p:nvCxnSpPr>
          <p:spPr>
            <a:xfrm>
              <a:off x="5867128" y="5822545"/>
              <a:ext cx="0" cy="21916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1" name="直線コネクタ 220">
              <a:extLst>
                <a:ext uri="{FF2B5EF4-FFF2-40B4-BE49-F238E27FC236}">
                  <a16:creationId xmlns:a16="http://schemas.microsoft.com/office/drawing/2014/main" id="{D045A754-637D-DBFB-2D6F-6280033F4202}"/>
                </a:ext>
              </a:extLst>
            </p:cNvPr>
            <p:cNvCxnSpPr/>
            <p:nvPr/>
          </p:nvCxnSpPr>
          <p:spPr>
            <a:xfrm>
              <a:off x="4691695" y="5818276"/>
              <a:ext cx="0" cy="21916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22" name="グループ化 221">
              <a:extLst>
                <a:ext uri="{FF2B5EF4-FFF2-40B4-BE49-F238E27FC236}">
                  <a16:creationId xmlns:a16="http://schemas.microsoft.com/office/drawing/2014/main" id="{CBFA8267-7749-BA0C-531C-B25C21B4C254}"/>
                </a:ext>
              </a:extLst>
            </p:cNvPr>
            <p:cNvGrpSpPr/>
            <p:nvPr/>
          </p:nvGrpSpPr>
          <p:grpSpPr>
            <a:xfrm rot="7367474">
              <a:off x="4653851" y="6064142"/>
              <a:ext cx="255089" cy="256497"/>
              <a:chOff x="168697" y="4098267"/>
              <a:chExt cx="435966" cy="438372"/>
            </a:xfrm>
          </p:grpSpPr>
          <p:grpSp>
            <p:nvGrpSpPr>
              <p:cNvPr id="260" name="グループ化 259">
                <a:extLst>
                  <a:ext uri="{FF2B5EF4-FFF2-40B4-BE49-F238E27FC236}">
                    <a16:creationId xmlns:a16="http://schemas.microsoft.com/office/drawing/2014/main" id="{38EC4300-7933-D603-25F2-9301C98A4596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262" name="グループ化 261">
                  <a:extLst>
                    <a:ext uri="{FF2B5EF4-FFF2-40B4-BE49-F238E27FC236}">
                      <a16:creationId xmlns:a16="http://schemas.microsoft.com/office/drawing/2014/main" id="{42DC5CE2-4278-4039-8E03-0ACC2E22E43B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68" name="直線コネクタ 267">
                    <a:extLst>
                      <a:ext uri="{FF2B5EF4-FFF2-40B4-BE49-F238E27FC236}">
                        <a16:creationId xmlns:a16="http://schemas.microsoft.com/office/drawing/2014/main" id="{3637F881-22DA-2421-27DF-6ACBA5E127F9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9" name="直線コネクタ 268">
                    <a:extLst>
                      <a:ext uri="{FF2B5EF4-FFF2-40B4-BE49-F238E27FC236}">
                        <a16:creationId xmlns:a16="http://schemas.microsoft.com/office/drawing/2014/main" id="{F3D469AD-A1D8-F3A5-03E6-6D851C7C18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0" name="直線コネクタ 269">
                    <a:extLst>
                      <a:ext uri="{FF2B5EF4-FFF2-40B4-BE49-F238E27FC236}">
                        <a16:creationId xmlns:a16="http://schemas.microsoft.com/office/drawing/2014/main" id="{AF4D3F7A-6B40-B792-035E-39DF5BFB8BE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3" name="グループ化 262">
                  <a:extLst>
                    <a:ext uri="{FF2B5EF4-FFF2-40B4-BE49-F238E27FC236}">
                      <a16:creationId xmlns:a16="http://schemas.microsoft.com/office/drawing/2014/main" id="{33C10B08-6F64-71DB-1818-B2706CFDDFC9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64" name="直線コネクタ 263">
                    <a:extLst>
                      <a:ext uri="{FF2B5EF4-FFF2-40B4-BE49-F238E27FC236}">
                        <a16:creationId xmlns:a16="http://schemas.microsoft.com/office/drawing/2014/main" id="{035DCE3D-C224-83C4-9E4E-AE84020B5F13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5" name="直線コネクタ 264">
                    <a:extLst>
                      <a:ext uri="{FF2B5EF4-FFF2-40B4-BE49-F238E27FC236}">
                        <a16:creationId xmlns:a16="http://schemas.microsoft.com/office/drawing/2014/main" id="{F579B014-52D0-843B-473C-69FA3E8637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6" name="直線コネクタ 265">
                    <a:extLst>
                      <a:ext uri="{FF2B5EF4-FFF2-40B4-BE49-F238E27FC236}">
                        <a16:creationId xmlns:a16="http://schemas.microsoft.com/office/drawing/2014/main" id="{F4503D9A-1973-E19B-91E3-73CE18F65FA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7" name="直線コネクタ 266">
                    <a:extLst>
                      <a:ext uri="{FF2B5EF4-FFF2-40B4-BE49-F238E27FC236}">
                        <a16:creationId xmlns:a16="http://schemas.microsoft.com/office/drawing/2014/main" id="{AD2D458E-BED9-E3E3-AF4C-E4A1D6B21A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61" name="楕円 260">
                <a:extLst>
                  <a:ext uri="{FF2B5EF4-FFF2-40B4-BE49-F238E27FC236}">
                    <a16:creationId xmlns:a16="http://schemas.microsoft.com/office/drawing/2014/main" id="{75CA7E69-E8FB-4CE9-879B-EFD50B6D83BD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3" name="グループ化 222">
              <a:extLst>
                <a:ext uri="{FF2B5EF4-FFF2-40B4-BE49-F238E27FC236}">
                  <a16:creationId xmlns:a16="http://schemas.microsoft.com/office/drawing/2014/main" id="{F955AC24-7665-A8E2-696D-A2ECB4EB3071}"/>
                </a:ext>
              </a:extLst>
            </p:cNvPr>
            <p:cNvGrpSpPr/>
            <p:nvPr/>
          </p:nvGrpSpPr>
          <p:grpSpPr>
            <a:xfrm>
              <a:off x="4868740" y="5853037"/>
              <a:ext cx="255089" cy="256497"/>
              <a:chOff x="168697" y="4098267"/>
              <a:chExt cx="435966" cy="438372"/>
            </a:xfrm>
          </p:grpSpPr>
          <p:grpSp>
            <p:nvGrpSpPr>
              <p:cNvPr id="249" name="グループ化 248">
                <a:extLst>
                  <a:ext uri="{FF2B5EF4-FFF2-40B4-BE49-F238E27FC236}">
                    <a16:creationId xmlns:a16="http://schemas.microsoft.com/office/drawing/2014/main" id="{03EC90C2-91B7-16E7-DA39-45AF42341070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251" name="グループ化 250">
                  <a:extLst>
                    <a:ext uri="{FF2B5EF4-FFF2-40B4-BE49-F238E27FC236}">
                      <a16:creationId xmlns:a16="http://schemas.microsoft.com/office/drawing/2014/main" id="{A59C41D0-47F3-67D4-8293-5E2F9E9016D0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57" name="直線コネクタ 256">
                    <a:extLst>
                      <a:ext uri="{FF2B5EF4-FFF2-40B4-BE49-F238E27FC236}">
                        <a16:creationId xmlns:a16="http://schemas.microsoft.com/office/drawing/2014/main" id="{2C82D626-FC5D-D8D4-47F2-592DABD6AF75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8" name="直線コネクタ 257">
                    <a:extLst>
                      <a:ext uri="{FF2B5EF4-FFF2-40B4-BE49-F238E27FC236}">
                        <a16:creationId xmlns:a16="http://schemas.microsoft.com/office/drawing/2014/main" id="{21C02BD3-E6DD-EBB7-A5FF-087D88FFDF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9" name="直線コネクタ 258">
                    <a:extLst>
                      <a:ext uri="{FF2B5EF4-FFF2-40B4-BE49-F238E27FC236}">
                        <a16:creationId xmlns:a16="http://schemas.microsoft.com/office/drawing/2014/main" id="{FBF61B4F-EE08-3148-39FB-81CBD13736B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52" name="グループ化 251">
                  <a:extLst>
                    <a:ext uri="{FF2B5EF4-FFF2-40B4-BE49-F238E27FC236}">
                      <a16:creationId xmlns:a16="http://schemas.microsoft.com/office/drawing/2014/main" id="{C222690F-7723-6B7A-1E45-4C2FF0FAD2C5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53" name="直線コネクタ 252">
                    <a:extLst>
                      <a:ext uri="{FF2B5EF4-FFF2-40B4-BE49-F238E27FC236}">
                        <a16:creationId xmlns:a16="http://schemas.microsoft.com/office/drawing/2014/main" id="{2D719A53-B425-F091-9314-31220B7DB282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" name="直線コネクタ 253">
                    <a:extLst>
                      <a:ext uri="{FF2B5EF4-FFF2-40B4-BE49-F238E27FC236}">
                        <a16:creationId xmlns:a16="http://schemas.microsoft.com/office/drawing/2014/main" id="{29950EB4-B88A-B253-4505-A55452D9FD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" name="直線コネクタ 254">
                    <a:extLst>
                      <a:ext uri="{FF2B5EF4-FFF2-40B4-BE49-F238E27FC236}">
                        <a16:creationId xmlns:a16="http://schemas.microsoft.com/office/drawing/2014/main" id="{0E563B4D-4E60-DABA-CEF6-22628805F4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6" name="直線コネクタ 255">
                    <a:extLst>
                      <a:ext uri="{FF2B5EF4-FFF2-40B4-BE49-F238E27FC236}">
                        <a16:creationId xmlns:a16="http://schemas.microsoft.com/office/drawing/2014/main" id="{1E7DE768-DC32-9C9C-72D5-D0600398BC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50" name="楕円 249">
                <a:extLst>
                  <a:ext uri="{FF2B5EF4-FFF2-40B4-BE49-F238E27FC236}">
                    <a16:creationId xmlns:a16="http://schemas.microsoft.com/office/drawing/2014/main" id="{E3394604-5549-A170-2597-EB0F2F7799B0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4" name="グループ化 223">
              <a:extLst>
                <a:ext uri="{FF2B5EF4-FFF2-40B4-BE49-F238E27FC236}">
                  <a16:creationId xmlns:a16="http://schemas.microsoft.com/office/drawing/2014/main" id="{FAC8789A-0FD3-CC79-FCDC-C7661090900B}"/>
                </a:ext>
              </a:extLst>
            </p:cNvPr>
            <p:cNvGrpSpPr/>
            <p:nvPr/>
          </p:nvGrpSpPr>
          <p:grpSpPr>
            <a:xfrm rot="4682045">
              <a:off x="5192799" y="6085839"/>
              <a:ext cx="255089" cy="256497"/>
              <a:chOff x="168697" y="4098267"/>
              <a:chExt cx="435966" cy="438372"/>
            </a:xfrm>
          </p:grpSpPr>
          <p:grpSp>
            <p:nvGrpSpPr>
              <p:cNvPr id="238" name="グループ化 237">
                <a:extLst>
                  <a:ext uri="{FF2B5EF4-FFF2-40B4-BE49-F238E27FC236}">
                    <a16:creationId xmlns:a16="http://schemas.microsoft.com/office/drawing/2014/main" id="{1715EEC5-A2C1-742F-CA97-8FF861D57CA4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240" name="グループ化 239">
                  <a:extLst>
                    <a:ext uri="{FF2B5EF4-FFF2-40B4-BE49-F238E27FC236}">
                      <a16:creationId xmlns:a16="http://schemas.microsoft.com/office/drawing/2014/main" id="{4AD2BB4C-BBDE-5987-2FEF-95B580E088A2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46" name="直線コネクタ 245">
                    <a:extLst>
                      <a:ext uri="{FF2B5EF4-FFF2-40B4-BE49-F238E27FC236}">
                        <a16:creationId xmlns:a16="http://schemas.microsoft.com/office/drawing/2014/main" id="{98F8A345-8A1A-3F5C-F719-4BF122E50AAD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" name="直線コネクタ 246">
                    <a:extLst>
                      <a:ext uri="{FF2B5EF4-FFF2-40B4-BE49-F238E27FC236}">
                        <a16:creationId xmlns:a16="http://schemas.microsoft.com/office/drawing/2014/main" id="{50BA9E64-4751-029F-24C6-5B1AE76A576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" name="直線コネクタ 247">
                    <a:extLst>
                      <a:ext uri="{FF2B5EF4-FFF2-40B4-BE49-F238E27FC236}">
                        <a16:creationId xmlns:a16="http://schemas.microsoft.com/office/drawing/2014/main" id="{3981D7C4-175C-8B7A-0054-CF6229CFCC0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41" name="グループ化 240">
                  <a:extLst>
                    <a:ext uri="{FF2B5EF4-FFF2-40B4-BE49-F238E27FC236}">
                      <a16:creationId xmlns:a16="http://schemas.microsoft.com/office/drawing/2014/main" id="{BC8984EF-5382-E4A9-05D2-C8742CBC4984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42" name="直線コネクタ 241">
                    <a:extLst>
                      <a:ext uri="{FF2B5EF4-FFF2-40B4-BE49-F238E27FC236}">
                        <a16:creationId xmlns:a16="http://schemas.microsoft.com/office/drawing/2014/main" id="{7FAC6CC6-BFBE-30B0-751D-6150FD2305BF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3" name="直線コネクタ 242">
                    <a:extLst>
                      <a:ext uri="{FF2B5EF4-FFF2-40B4-BE49-F238E27FC236}">
                        <a16:creationId xmlns:a16="http://schemas.microsoft.com/office/drawing/2014/main" id="{227F84E9-A18C-BFF9-80F9-127240B668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" name="直線コネクタ 243">
                    <a:extLst>
                      <a:ext uri="{FF2B5EF4-FFF2-40B4-BE49-F238E27FC236}">
                        <a16:creationId xmlns:a16="http://schemas.microsoft.com/office/drawing/2014/main" id="{BFA90649-6A12-9BE9-A63B-6172E6CE28F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" name="直線コネクタ 244">
                    <a:extLst>
                      <a:ext uri="{FF2B5EF4-FFF2-40B4-BE49-F238E27FC236}">
                        <a16:creationId xmlns:a16="http://schemas.microsoft.com/office/drawing/2014/main" id="{12F03CF4-0345-8118-CED5-737F97706C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39" name="楕円 238">
                <a:extLst>
                  <a:ext uri="{FF2B5EF4-FFF2-40B4-BE49-F238E27FC236}">
                    <a16:creationId xmlns:a16="http://schemas.microsoft.com/office/drawing/2014/main" id="{9AC7032F-BC8F-DE9A-4451-1CA23B828521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5" name="グループ化 224">
              <a:extLst>
                <a:ext uri="{FF2B5EF4-FFF2-40B4-BE49-F238E27FC236}">
                  <a16:creationId xmlns:a16="http://schemas.microsoft.com/office/drawing/2014/main" id="{041A6D16-2572-3C01-22D0-FBB3390ADE0C}"/>
                </a:ext>
              </a:extLst>
            </p:cNvPr>
            <p:cNvGrpSpPr/>
            <p:nvPr/>
          </p:nvGrpSpPr>
          <p:grpSpPr>
            <a:xfrm rot="18335400">
              <a:off x="5322278" y="5887164"/>
              <a:ext cx="255089" cy="256497"/>
              <a:chOff x="168697" y="4098267"/>
              <a:chExt cx="435966" cy="438372"/>
            </a:xfrm>
          </p:grpSpPr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492D5BAA-218F-E135-D758-8EB71D313E18}"/>
                  </a:ext>
                </a:extLst>
              </p:cNvPr>
              <p:cNvGrpSpPr/>
              <p:nvPr/>
            </p:nvGrpSpPr>
            <p:grpSpPr>
              <a:xfrm>
                <a:off x="168697" y="4098267"/>
                <a:ext cx="435634" cy="438372"/>
                <a:chOff x="168697" y="4098267"/>
                <a:chExt cx="435634" cy="438372"/>
              </a:xfrm>
            </p:grpSpPr>
            <p:grpSp>
              <p:nvGrpSpPr>
                <p:cNvPr id="229" name="グループ化 228">
                  <a:extLst>
                    <a:ext uri="{FF2B5EF4-FFF2-40B4-BE49-F238E27FC236}">
                      <a16:creationId xmlns:a16="http://schemas.microsoft.com/office/drawing/2014/main" id="{F77039AD-E94C-3916-04B3-4B480E575D48}"/>
                    </a:ext>
                  </a:extLst>
                </p:cNvPr>
                <p:cNvGrpSpPr/>
                <p:nvPr/>
              </p:nvGrpSpPr>
              <p:grpSpPr>
                <a:xfrm>
                  <a:off x="168697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35" name="直線コネクタ 234">
                    <a:extLst>
                      <a:ext uri="{FF2B5EF4-FFF2-40B4-BE49-F238E27FC236}">
                        <a16:creationId xmlns:a16="http://schemas.microsoft.com/office/drawing/2014/main" id="{71B37212-F6C6-5813-166D-0A9D3B67E9AD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6" name="直線コネクタ 235">
                    <a:extLst>
                      <a:ext uri="{FF2B5EF4-FFF2-40B4-BE49-F238E27FC236}">
                        <a16:creationId xmlns:a16="http://schemas.microsoft.com/office/drawing/2014/main" id="{3E0B56A0-1F56-390E-FA99-27E0DC47BF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7" name="直線コネクタ 236">
                    <a:extLst>
                      <a:ext uri="{FF2B5EF4-FFF2-40B4-BE49-F238E27FC236}">
                        <a16:creationId xmlns:a16="http://schemas.microsoft.com/office/drawing/2014/main" id="{85C97372-18B0-0DDA-E7B0-0E73B480BEA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0" name="グループ化 229">
                  <a:extLst>
                    <a:ext uri="{FF2B5EF4-FFF2-40B4-BE49-F238E27FC236}">
                      <a16:creationId xmlns:a16="http://schemas.microsoft.com/office/drawing/2014/main" id="{3676CB04-4EFF-4A88-948C-87DABECB15BE}"/>
                    </a:ext>
                  </a:extLst>
                </p:cNvPr>
                <p:cNvGrpSpPr/>
                <p:nvPr/>
              </p:nvGrpSpPr>
              <p:grpSpPr>
                <a:xfrm flipH="1">
                  <a:off x="408720" y="4098267"/>
                  <a:ext cx="195611" cy="438372"/>
                  <a:chOff x="168697" y="4098267"/>
                  <a:chExt cx="195611" cy="438372"/>
                </a:xfrm>
              </p:grpSpPr>
              <p:cxnSp>
                <p:nvCxnSpPr>
                  <p:cNvPr id="231" name="直線コネクタ 230">
                    <a:extLst>
                      <a:ext uri="{FF2B5EF4-FFF2-40B4-BE49-F238E27FC236}">
                        <a16:creationId xmlns:a16="http://schemas.microsoft.com/office/drawing/2014/main" id="{D348EC81-A32E-0B60-FB62-156D88A6563B}"/>
                      </a:ext>
                    </a:extLst>
                  </p:cNvPr>
                  <p:cNvCxnSpPr/>
                  <p:nvPr/>
                </p:nvCxnSpPr>
                <p:spPr>
                  <a:xfrm>
                    <a:off x="168697" y="4155154"/>
                    <a:ext cx="111338" cy="111338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直線コネクタ 231">
                    <a:extLst>
                      <a:ext uri="{FF2B5EF4-FFF2-40B4-BE49-F238E27FC236}">
                        <a16:creationId xmlns:a16="http://schemas.microsoft.com/office/drawing/2014/main" id="{5B683EDB-06A4-2A04-F5B4-7783F9B57F1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7124" y="4098267"/>
                    <a:ext cx="147184" cy="147184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3" name="直線コネクタ 232">
                    <a:extLst>
                      <a:ext uri="{FF2B5EF4-FFF2-40B4-BE49-F238E27FC236}">
                        <a16:creationId xmlns:a16="http://schemas.microsoft.com/office/drawing/2014/main" id="{981C894A-5485-B18A-17E9-95B5103BA42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56361" y="4231274"/>
                    <a:ext cx="0" cy="305365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直線コネクタ 233">
                    <a:extLst>
                      <a:ext uri="{FF2B5EF4-FFF2-40B4-BE49-F238E27FC236}">
                        <a16:creationId xmlns:a16="http://schemas.microsoft.com/office/drawing/2014/main" id="{C7D91772-7639-7696-8025-FE01CBC45B9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9153" y="4434127"/>
                    <a:ext cx="109256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28" name="楕円 227">
                <a:extLst>
                  <a:ext uri="{FF2B5EF4-FFF2-40B4-BE49-F238E27FC236}">
                    <a16:creationId xmlns:a16="http://schemas.microsoft.com/office/drawing/2014/main" id="{3FCE1648-E08B-11A9-EDA8-D9E47E0EEC20}"/>
                  </a:ext>
                </a:extLst>
              </p:cNvPr>
              <p:cNvSpPr/>
              <p:nvPr/>
            </p:nvSpPr>
            <p:spPr>
              <a:xfrm>
                <a:off x="515594" y="4391176"/>
                <a:ext cx="89069" cy="89069"/>
              </a:xfrm>
              <a:prstGeom prst="ellipse">
                <a:avLst/>
              </a:prstGeom>
              <a:solidFill>
                <a:srgbClr val="FF0000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108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6" name="フローチャート: データ 225">
              <a:extLst>
                <a:ext uri="{FF2B5EF4-FFF2-40B4-BE49-F238E27FC236}">
                  <a16:creationId xmlns:a16="http://schemas.microsoft.com/office/drawing/2014/main" id="{0B074F4B-386E-2AFC-175C-CF182AF0B76F}"/>
                </a:ext>
              </a:extLst>
            </p:cNvPr>
            <p:cNvSpPr/>
            <p:nvPr/>
          </p:nvSpPr>
          <p:spPr>
            <a:xfrm>
              <a:off x="4393318" y="5821665"/>
              <a:ext cx="1466564" cy="359752"/>
            </a:xfrm>
            <a:prstGeom prst="flowChartInputOutput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wrap="none" rtlCol="0" anchor="ctr" anchorCtr="1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69E12BE3-8E33-5EBE-F6F9-7C7EC957F56E}"/>
              </a:ext>
            </a:extLst>
          </p:cNvPr>
          <p:cNvSpPr txBox="1"/>
          <p:nvPr/>
        </p:nvSpPr>
        <p:spPr>
          <a:xfrm>
            <a:off x="1736045" y="3366136"/>
            <a:ext cx="1660800" cy="433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Dispersed </a:t>
            </a:r>
            <a:r>
              <a:rPr kumimoji="0" lang="ja-JP" altLang="en-US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ample</a:t>
            </a:r>
            <a:endParaRPr kumimoji="0" lang="en-US" altLang="ja-JP" sz="1108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8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of known concentration</a:t>
            </a:r>
            <a:endParaRPr kumimoji="0" lang="ja-JP" altLang="en-US" sz="1108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80" name="矢印: 折線 279">
            <a:extLst>
              <a:ext uri="{FF2B5EF4-FFF2-40B4-BE49-F238E27FC236}">
                <a16:creationId xmlns:a16="http://schemas.microsoft.com/office/drawing/2014/main" id="{8B87033A-6ACB-EADF-3FE4-6053D5894841}"/>
              </a:ext>
            </a:extLst>
          </p:cNvPr>
          <p:cNvSpPr/>
          <p:nvPr/>
        </p:nvSpPr>
        <p:spPr>
          <a:xfrm rot="16200000" flipH="1">
            <a:off x="1824779" y="1623577"/>
            <a:ext cx="386468" cy="340312"/>
          </a:xfrm>
          <a:prstGeom prst="bentArrow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662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81" name="矢印: 右 280">
            <a:extLst>
              <a:ext uri="{FF2B5EF4-FFF2-40B4-BE49-F238E27FC236}">
                <a16:creationId xmlns:a16="http://schemas.microsoft.com/office/drawing/2014/main" id="{D67BEAD6-2843-E2E2-0284-F90E796D8D45}"/>
              </a:ext>
            </a:extLst>
          </p:cNvPr>
          <p:cNvSpPr/>
          <p:nvPr/>
        </p:nvSpPr>
        <p:spPr>
          <a:xfrm>
            <a:off x="3249723" y="3813019"/>
            <a:ext cx="698067" cy="419924"/>
          </a:xfrm>
          <a:prstGeom prst="rightArrow">
            <a:avLst/>
          </a:prstGeom>
          <a:noFill/>
          <a:ln w="25400" cap="flat" cmpd="sng" algn="ctr">
            <a:solidFill>
              <a:sysClr val="windowText" lastClr="000000">
                <a:lumMod val="50000"/>
                <a:lumOff val="50000"/>
              </a:sysClr>
            </a:solidFill>
            <a:prstDash val="solid"/>
          </a:ln>
          <a:effectLst/>
        </p:spPr>
        <p:txBody>
          <a:bodyPr wrap="none" rtlCol="0" anchor="ctr" anchorCtr="1"/>
          <a:lstStyle/>
          <a:p>
            <a:pPr marL="0" marR="0" lvl="0" indent="0" algn="ctr" defTabSz="77826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8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558D873-EB16-52EC-8D33-7786395F91A7}"/>
              </a:ext>
            </a:extLst>
          </p:cNvPr>
          <p:cNvSpPr txBox="1"/>
          <p:nvPr/>
        </p:nvSpPr>
        <p:spPr>
          <a:xfrm>
            <a:off x="2898451" y="60769"/>
            <a:ext cx="39052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figure 2 Nakamura </a:t>
            </a:r>
            <a:r>
              <a:rPr lang="en-US" altLang="ja-JP" i="1"/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21684069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図 44" descr="カーテン が含まれている画像&#10;&#10;自動的に生成された説明">
            <a:extLst>
              <a:ext uri="{FF2B5EF4-FFF2-40B4-BE49-F238E27FC236}">
                <a16:creationId xmlns:a16="http://schemas.microsoft.com/office/drawing/2014/main" id="{93BFDCF3-7F4A-739C-1797-E68892B46A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127" y="4160628"/>
            <a:ext cx="1260000" cy="708099"/>
          </a:xfrm>
          <a:prstGeom prst="rect">
            <a:avLst/>
          </a:prstGeom>
        </p:spPr>
      </p:pic>
      <p:pic>
        <p:nvPicPr>
          <p:cNvPr id="49" name="図 48" descr="衣料, 食品 が含まれている画像&#10;&#10;自動的に生成された説明">
            <a:extLst>
              <a:ext uri="{FF2B5EF4-FFF2-40B4-BE49-F238E27FC236}">
                <a16:creationId xmlns:a16="http://schemas.microsoft.com/office/drawing/2014/main" id="{B6FCC3A7-52AB-EA22-499D-6C8B7A1A6CA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40" y="4160628"/>
            <a:ext cx="1260000" cy="712623"/>
          </a:xfrm>
          <a:prstGeom prst="rect">
            <a:avLst/>
          </a:prstGeom>
        </p:spPr>
      </p:pic>
      <p:pic>
        <p:nvPicPr>
          <p:cNvPr id="52" name="図 51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1D704CFC-760B-8ED4-7EA0-1F4CA0D4AFF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217" y="4160628"/>
            <a:ext cx="1260000" cy="705600"/>
          </a:xfrm>
          <a:prstGeom prst="rect">
            <a:avLst/>
          </a:prstGeom>
        </p:spPr>
      </p:pic>
      <p:pic>
        <p:nvPicPr>
          <p:cNvPr id="54" name="図 53" descr="布, 食品, 帽子 が含まれている画像&#10;&#10;自動的に生成された説明">
            <a:extLst>
              <a:ext uri="{FF2B5EF4-FFF2-40B4-BE49-F238E27FC236}">
                <a16:creationId xmlns:a16="http://schemas.microsoft.com/office/drawing/2014/main" id="{52295245-E694-30EB-6773-03CEB4E7E83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0762" y="4160628"/>
            <a:ext cx="1260000" cy="707459"/>
          </a:xfrm>
          <a:prstGeom prst="rect">
            <a:avLst/>
          </a:prstGeom>
        </p:spPr>
      </p:pic>
      <p:pic>
        <p:nvPicPr>
          <p:cNvPr id="56" name="図 55" descr="食品, 座る, テーブル, フルーツ が含まれている画像&#10;&#10;自動的に生成された説明">
            <a:extLst>
              <a:ext uri="{FF2B5EF4-FFF2-40B4-BE49-F238E27FC236}">
                <a16:creationId xmlns:a16="http://schemas.microsoft.com/office/drawing/2014/main" id="{91259C77-B106-6963-6F7B-9BE15245518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127" y="5179820"/>
            <a:ext cx="1260000" cy="708750"/>
          </a:xfrm>
          <a:prstGeom prst="rect">
            <a:avLst/>
          </a:prstGeom>
        </p:spPr>
      </p:pic>
      <p:pic>
        <p:nvPicPr>
          <p:cNvPr id="41" name="図 40" descr="布 が含まれている画像&#10;&#10;自動的に生成された説明">
            <a:extLst>
              <a:ext uri="{FF2B5EF4-FFF2-40B4-BE49-F238E27FC236}">
                <a16:creationId xmlns:a16="http://schemas.microsoft.com/office/drawing/2014/main" id="{D0796926-587A-43B9-2C7A-16E8586C0D5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0762" y="1018384"/>
            <a:ext cx="1260000" cy="711951"/>
          </a:xfrm>
          <a:prstGeom prst="rect">
            <a:avLst/>
          </a:prstGeom>
        </p:spPr>
      </p:pic>
      <p:pic>
        <p:nvPicPr>
          <p:cNvPr id="39" name="図 38" descr="衣料, 布, 敷物 が含まれている画像&#10;&#10;自動的に生成された説明">
            <a:extLst>
              <a:ext uri="{FF2B5EF4-FFF2-40B4-BE49-F238E27FC236}">
                <a16:creationId xmlns:a16="http://schemas.microsoft.com/office/drawing/2014/main" id="{885593BE-3EF2-4474-5718-D7853A596B5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217" y="1998726"/>
            <a:ext cx="1260000" cy="713306"/>
          </a:xfrm>
          <a:prstGeom prst="rect">
            <a:avLst/>
          </a:prstGeom>
        </p:spPr>
      </p:pic>
      <p:pic>
        <p:nvPicPr>
          <p:cNvPr id="37" name="図 36" descr="文字の書かれた紙&#10;&#10;低い精度で自動的に生成された説明">
            <a:extLst>
              <a:ext uri="{FF2B5EF4-FFF2-40B4-BE49-F238E27FC236}">
                <a16:creationId xmlns:a16="http://schemas.microsoft.com/office/drawing/2014/main" id="{4F6874E3-715B-1650-43EE-A13EFA4A534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40" y="1018384"/>
            <a:ext cx="1260000" cy="707459"/>
          </a:xfrm>
          <a:prstGeom prst="rect">
            <a:avLst/>
          </a:prstGeom>
        </p:spPr>
      </p:pic>
      <p:pic>
        <p:nvPicPr>
          <p:cNvPr id="35" name="図 34" descr="布, 食品, 敷物 が含まれている画像&#10;&#10;自動的に生成された説明">
            <a:extLst>
              <a:ext uri="{FF2B5EF4-FFF2-40B4-BE49-F238E27FC236}">
                <a16:creationId xmlns:a16="http://schemas.microsoft.com/office/drawing/2014/main" id="{35B10091-4225-5253-243E-78F31E4FDAD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456" y="1996080"/>
            <a:ext cx="1260000" cy="708412"/>
          </a:xfrm>
          <a:prstGeom prst="rect">
            <a:avLst/>
          </a:prstGeom>
        </p:spPr>
      </p:pic>
      <p:pic>
        <p:nvPicPr>
          <p:cNvPr id="33" name="図 32" descr="布, カーテン, 敷物 が含まれている画像&#10;&#10;自動的に生成された説明">
            <a:extLst>
              <a:ext uri="{FF2B5EF4-FFF2-40B4-BE49-F238E27FC236}">
                <a16:creationId xmlns:a16="http://schemas.microsoft.com/office/drawing/2014/main" id="{D78F789B-18FC-75C3-8FEB-F7A314C333A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40" y="1996080"/>
            <a:ext cx="1260000" cy="713106"/>
          </a:xfrm>
          <a:prstGeom prst="rect">
            <a:avLst/>
          </a:prstGeom>
        </p:spPr>
      </p:pic>
      <p:pic>
        <p:nvPicPr>
          <p:cNvPr id="31" name="図 30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F35C312C-1BB8-736F-DD24-098D4ADC5E58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0762" y="1998726"/>
            <a:ext cx="1260000" cy="710085"/>
          </a:xfrm>
          <a:prstGeom prst="rect">
            <a:avLst/>
          </a:prstGeom>
        </p:spPr>
      </p:pic>
      <p:pic>
        <p:nvPicPr>
          <p:cNvPr id="29" name="図 28" descr="布 が含まれている画像&#10;&#10;自動的に生成された説明">
            <a:extLst>
              <a:ext uri="{FF2B5EF4-FFF2-40B4-BE49-F238E27FC236}">
                <a16:creationId xmlns:a16="http://schemas.microsoft.com/office/drawing/2014/main" id="{8E9ECFBC-FF10-D38A-8C86-D6ABC5431B3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695" y="1018384"/>
            <a:ext cx="1260000" cy="708099"/>
          </a:xfrm>
          <a:prstGeom prst="rect">
            <a:avLst/>
          </a:prstGeom>
        </p:spPr>
      </p:pic>
      <p:pic>
        <p:nvPicPr>
          <p:cNvPr id="20" name="図 19" descr="布, 敷物 が含まれている画像&#10;&#10;自動的に生成された説明">
            <a:extLst>
              <a:ext uri="{FF2B5EF4-FFF2-40B4-BE49-F238E27FC236}">
                <a16:creationId xmlns:a16="http://schemas.microsoft.com/office/drawing/2014/main" id="{B040311B-E2B0-0925-7C93-6B8424B09BC9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130" y="1018384"/>
            <a:ext cx="1260000" cy="709412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6DC196A-EED8-D4C9-4700-1214215EEB98}"/>
              </a:ext>
            </a:extLst>
          </p:cNvPr>
          <p:cNvSpPr txBox="1"/>
          <p:nvPr/>
        </p:nvSpPr>
        <p:spPr>
          <a:xfrm>
            <a:off x="99921" y="60902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2A12CC1-E7E9-B0A4-3018-1F3B1272B578}"/>
              </a:ext>
            </a:extLst>
          </p:cNvPr>
          <p:cNvSpPr txBox="1"/>
          <p:nvPr/>
        </p:nvSpPr>
        <p:spPr>
          <a:xfrm>
            <a:off x="648127" y="3920598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45RO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0EFE172-7510-C9CB-E775-965870BF40D1}"/>
              </a:ext>
            </a:extLst>
          </p:cNvPr>
          <p:cNvSpPr txBox="1"/>
          <p:nvPr/>
        </p:nvSpPr>
        <p:spPr>
          <a:xfrm>
            <a:off x="1953240" y="3920598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85841C0-CD93-7FD9-02CD-D8CBA35DB2C2}"/>
              </a:ext>
            </a:extLst>
          </p:cNvPr>
          <p:cNvSpPr txBox="1"/>
          <p:nvPr/>
        </p:nvSpPr>
        <p:spPr>
          <a:xfrm>
            <a:off x="3263217" y="3920598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EA05BBC-012B-1630-F206-4DD841B5EF04}"/>
              </a:ext>
            </a:extLst>
          </p:cNvPr>
          <p:cNvSpPr txBox="1"/>
          <p:nvPr/>
        </p:nvSpPr>
        <p:spPr>
          <a:xfrm>
            <a:off x="4570762" y="3920598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Sox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EAAFDAC-A8E8-ED32-FB69-3B489D380D86}"/>
              </a:ext>
            </a:extLst>
          </p:cNvPr>
          <p:cNvSpPr txBox="1"/>
          <p:nvPr/>
        </p:nvSpPr>
        <p:spPr>
          <a:xfrm>
            <a:off x="648127" y="4932170"/>
            <a:ext cx="397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31AAB8F3-D3E2-06FA-004B-1413ED1A2C9F}"/>
              </a:ext>
            </a:extLst>
          </p:cNvPr>
          <p:cNvSpPr txBox="1"/>
          <p:nvPr/>
        </p:nvSpPr>
        <p:spPr>
          <a:xfrm>
            <a:off x="99921" y="366681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CAAF6930-C78B-7AA2-923E-E04F9E31B72E}"/>
              </a:ext>
            </a:extLst>
          </p:cNvPr>
          <p:cNvSpPr txBox="1"/>
          <p:nvPr/>
        </p:nvSpPr>
        <p:spPr>
          <a:xfrm>
            <a:off x="648127" y="772224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CA138C0E-E0A5-51C0-FA42-CA11F4CACE7A}"/>
              </a:ext>
            </a:extLst>
          </p:cNvPr>
          <p:cNvSpPr txBox="1"/>
          <p:nvPr/>
        </p:nvSpPr>
        <p:spPr>
          <a:xfrm>
            <a:off x="1953240" y="789784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221A765-37AC-59F7-30D5-4D4C77ACA049}"/>
              </a:ext>
            </a:extLst>
          </p:cNvPr>
          <p:cNvSpPr txBox="1"/>
          <p:nvPr/>
        </p:nvSpPr>
        <p:spPr>
          <a:xfrm>
            <a:off x="3263217" y="789784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67411D8F-C10E-A32F-FDF2-813996CE0C8D}"/>
              </a:ext>
            </a:extLst>
          </p:cNvPr>
          <p:cNvSpPr txBox="1"/>
          <p:nvPr/>
        </p:nvSpPr>
        <p:spPr>
          <a:xfrm>
            <a:off x="4570762" y="789784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8A3AAD0F-E5E3-898D-6209-FE3D96D84866}"/>
              </a:ext>
            </a:extLst>
          </p:cNvPr>
          <p:cNvSpPr txBox="1"/>
          <p:nvPr/>
        </p:nvSpPr>
        <p:spPr>
          <a:xfrm>
            <a:off x="648127" y="1749472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54D845E-288A-1ECA-0E36-FA0EB473E067}"/>
              </a:ext>
            </a:extLst>
          </p:cNvPr>
          <p:cNvSpPr txBox="1"/>
          <p:nvPr/>
        </p:nvSpPr>
        <p:spPr>
          <a:xfrm>
            <a:off x="3263217" y="1751076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D41538B-A778-EC40-A732-F37040A081FE}"/>
              </a:ext>
            </a:extLst>
          </p:cNvPr>
          <p:cNvSpPr txBox="1"/>
          <p:nvPr/>
        </p:nvSpPr>
        <p:spPr>
          <a:xfrm>
            <a:off x="4570762" y="1751076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671C1A5B-3F1B-82A5-2D74-921BE1027FED}"/>
              </a:ext>
            </a:extLst>
          </p:cNvPr>
          <p:cNvSpPr txBox="1"/>
          <p:nvPr/>
        </p:nvSpPr>
        <p:spPr>
          <a:xfrm>
            <a:off x="99921" y="63458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872B740D-296A-FEBB-1B43-4B6DDBFEE6F5}"/>
              </a:ext>
            </a:extLst>
          </p:cNvPr>
          <p:cNvSpPr txBox="1"/>
          <p:nvPr/>
        </p:nvSpPr>
        <p:spPr>
          <a:xfrm>
            <a:off x="1953240" y="1751076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923165BE-4FCE-61F1-44A1-80934B098F33}"/>
              </a:ext>
            </a:extLst>
          </p:cNvPr>
          <p:cNvCxnSpPr>
            <a:cxnSpLocks/>
          </p:cNvCxnSpPr>
          <p:nvPr/>
        </p:nvCxnSpPr>
        <p:spPr>
          <a:xfrm>
            <a:off x="1730016" y="1605836"/>
            <a:ext cx="14779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BA775CFC-F2C4-FDF5-4ABC-519387F02DA7}"/>
              </a:ext>
            </a:extLst>
          </p:cNvPr>
          <p:cNvCxnSpPr>
            <a:cxnSpLocks/>
          </p:cNvCxnSpPr>
          <p:nvPr/>
        </p:nvCxnSpPr>
        <p:spPr>
          <a:xfrm>
            <a:off x="1730016" y="4693019"/>
            <a:ext cx="14779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図 58" descr="チーズ, 食品 が含まれている画像&#10;&#10;自動的に生成された説明">
            <a:extLst>
              <a:ext uri="{FF2B5EF4-FFF2-40B4-BE49-F238E27FC236}">
                <a16:creationId xmlns:a16="http://schemas.microsoft.com/office/drawing/2014/main" id="{A5BCC2CA-6361-01E9-756A-85902467967B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370" y="6894902"/>
            <a:ext cx="1260000" cy="711715"/>
          </a:xfrm>
          <a:prstGeom prst="rect">
            <a:avLst/>
          </a:prstGeom>
        </p:spPr>
      </p:pic>
      <p:pic>
        <p:nvPicPr>
          <p:cNvPr id="61" name="図 60" descr="地図と文字の加工写真&#10;&#10;低い精度で自動的に生成された説明">
            <a:extLst>
              <a:ext uri="{FF2B5EF4-FFF2-40B4-BE49-F238E27FC236}">
                <a16:creationId xmlns:a16="http://schemas.microsoft.com/office/drawing/2014/main" id="{8BC1F132-CA03-4F20-A680-86026B08F29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5483" y="6894902"/>
            <a:ext cx="1260000" cy="706829"/>
          </a:xfrm>
          <a:prstGeom prst="rect">
            <a:avLst/>
          </a:prstGeom>
        </p:spPr>
      </p:pic>
      <p:pic>
        <p:nvPicPr>
          <p:cNvPr id="63" name="図 62" descr="チーズ, 食品 が含まれている画像&#10;&#10;自動的に生成された説明">
            <a:extLst>
              <a:ext uri="{FF2B5EF4-FFF2-40B4-BE49-F238E27FC236}">
                <a16:creationId xmlns:a16="http://schemas.microsoft.com/office/drawing/2014/main" id="{4EA884E6-A3BC-F113-FA17-9770F210064F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130" y="6894902"/>
            <a:ext cx="1260000" cy="710769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60BF781F-FA0D-932B-AF58-206A20B99333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4777" y="6894902"/>
            <a:ext cx="1260000" cy="708750"/>
          </a:xfrm>
          <a:prstGeom prst="rect">
            <a:avLst/>
          </a:prstGeom>
        </p:spPr>
      </p:pic>
      <p:pic>
        <p:nvPicPr>
          <p:cNvPr id="67" name="図 66" descr="チーズ, 食品 が含まれている画像&#10;&#10;自動的に生成された説明">
            <a:extLst>
              <a:ext uri="{FF2B5EF4-FFF2-40B4-BE49-F238E27FC236}">
                <a16:creationId xmlns:a16="http://schemas.microsoft.com/office/drawing/2014/main" id="{DBCEE60D-F5BC-4C4B-CA3E-36409453EA2A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370" y="8087112"/>
            <a:ext cx="1260000" cy="710085"/>
          </a:xfrm>
          <a:prstGeom prst="rect">
            <a:avLst/>
          </a:prstGeom>
        </p:spPr>
      </p:pic>
      <p:pic>
        <p:nvPicPr>
          <p:cNvPr id="69" name="図 68" descr="食品, 砂糖 が含まれている画像&#10;&#10;自動的に生成された説明">
            <a:extLst>
              <a:ext uri="{FF2B5EF4-FFF2-40B4-BE49-F238E27FC236}">
                <a16:creationId xmlns:a16="http://schemas.microsoft.com/office/drawing/2014/main" id="{F36EEF6C-21FA-C225-2AFC-F95333CE5035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40" y="8087112"/>
            <a:ext cx="1260000" cy="708099"/>
          </a:xfrm>
          <a:prstGeom prst="rect">
            <a:avLst/>
          </a:prstGeom>
        </p:spPr>
      </p:pic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E4B28B52-8E9E-9360-5E44-C5F46F9B6FD0}"/>
              </a:ext>
            </a:extLst>
          </p:cNvPr>
          <p:cNvSpPr txBox="1"/>
          <p:nvPr/>
        </p:nvSpPr>
        <p:spPr>
          <a:xfrm>
            <a:off x="648127" y="6651062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3A943F6C-2D76-38D7-E5DA-3F5433CF5EAA}"/>
              </a:ext>
            </a:extLst>
          </p:cNvPr>
          <p:cNvSpPr txBox="1"/>
          <p:nvPr/>
        </p:nvSpPr>
        <p:spPr>
          <a:xfrm>
            <a:off x="1953240" y="6651062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E29D8447-B3E3-A8A8-F2AE-A8676492BAD2}"/>
              </a:ext>
            </a:extLst>
          </p:cNvPr>
          <p:cNvSpPr txBox="1"/>
          <p:nvPr/>
        </p:nvSpPr>
        <p:spPr>
          <a:xfrm>
            <a:off x="3263217" y="6651062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2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7FCFB235-02DE-A0F9-4A02-A6C791455488}"/>
              </a:ext>
            </a:extLst>
          </p:cNvPr>
          <p:cNvSpPr txBox="1"/>
          <p:nvPr/>
        </p:nvSpPr>
        <p:spPr>
          <a:xfrm>
            <a:off x="4570762" y="6651062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82649C59-57B4-AF34-F6BC-4DD6D491AC3A}"/>
              </a:ext>
            </a:extLst>
          </p:cNvPr>
          <p:cNvSpPr txBox="1"/>
          <p:nvPr/>
        </p:nvSpPr>
        <p:spPr>
          <a:xfrm>
            <a:off x="648127" y="7835652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18770DDE-39DE-BC69-C63B-588C442751D5}"/>
              </a:ext>
            </a:extLst>
          </p:cNvPr>
          <p:cNvSpPr txBox="1"/>
          <p:nvPr/>
        </p:nvSpPr>
        <p:spPr>
          <a:xfrm>
            <a:off x="1953240" y="7835652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9F2C3617-A357-4E88-4850-35684EB96A52}"/>
              </a:ext>
            </a:extLst>
          </p:cNvPr>
          <p:cNvCxnSpPr>
            <a:cxnSpLocks/>
          </p:cNvCxnSpPr>
          <p:nvPr/>
        </p:nvCxnSpPr>
        <p:spPr>
          <a:xfrm>
            <a:off x="1730016" y="7508830"/>
            <a:ext cx="14779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 descr="敷物, 布 が含まれている画像&#10;&#10;自動的に生成された説明">
            <a:extLst>
              <a:ext uri="{FF2B5EF4-FFF2-40B4-BE49-F238E27FC236}">
                <a16:creationId xmlns:a16="http://schemas.microsoft.com/office/drawing/2014/main" id="{60CC8C68-1299-5A01-164E-2400A7402284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127" y="2948562"/>
            <a:ext cx="1260000" cy="714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9FD548F-1EC0-0C5F-ADCD-5D1530F76F33}"/>
              </a:ext>
            </a:extLst>
          </p:cNvPr>
          <p:cNvSpPr txBox="1"/>
          <p:nvPr/>
        </p:nvSpPr>
        <p:spPr>
          <a:xfrm>
            <a:off x="672511" y="2705920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76B016D7-B67F-74C1-C377-F1955C19EEBA}"/>
              </a:ext>
            </a:extLst>
          </p:cNvPr>
          <p:cNvCxnSpPr>
            <a:cxnSpLocks/>
          </p:cNvCxnSpPr>
          <p:nvPr/>
        </p:nvCxnSpPr>
        <p:spPr>
          <a:xfrm>
            <a:off x="1730016" y="4605401"/>
            <a:ext cx="14779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図 5" descr="背景パターン&#10;&#10;低い精度で自動的に生成された説明">
            <a:extLst>
              <a:ext uri="{FF2B5EF4-FFF2-40B4-BE49-F238E27FC236}">
                <a16:creationId xmlns:a16="http://schemas.microsoft.com/office/drawing/2014/main" id="{1BAA812D-95E0-327E-EEC5-E205F5110CF8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40" y="5186702"/>
            <a:ext cx="1260000" cy="714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EBB43BE-A4B4-6598-6839-AE77160BC08D}"/>
              </a:ext>
            </a:extLst>
          </p:cNvPr>
          <p:cNvSpPr txBox="1"/>
          <p:nvPr/>
        </p:nvSpPr>
        <p:spPr>
          <a:xfrm>
            <a:off x="1970918" y="4944302"/>
            <a:ext cx="397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 descr="マップ が含まれている画像&#10;&#10;自動的に生成された説明">
            <a:extLst>
              <a:ext uri="{FF2B5EF4-FFF2-40B4-BE49-F238E27FC236}">
                <a16:creationId xmlns:a16="http://schemas.microsoft.com/office/drawing/2014/main" id="{8BD6B4C0-6962-B0AE-9306-99568992ACA8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130" y="8081873"/>
            <a:ext cx="1260000" cy="7140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B993AEC-DC95-EF14-FA47-BCBB3776F5D3}"/>
              </a:ext>
            </a:extLst>
          </p:cNvPr>
          <p:cNvSpPr txBox="1"/>
          <p:nvPr/>
        </p:nvSpPr>
        <p:spPr>
          <a:xfrm>
            <a:off x="3260130" y="7849511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7636F3-7E64-865F-FD52-3544B5992BC3}"/>
              </a:ext>
            </a:extLst>
          </p:cNvPr>
          <p:cNvSpPr txBox="1"/>
          <p:nvPr/>
        </p:nvSpPr>
        <p:spPr>
          <a:xfrm>
            <a:off x="2898451" y="60769"/>
            <a:ext cx="39052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figure 3 Nakamura </a:t>
            </a:r>
            <a:r>
              <a:rPr lang="en-US" altLang="ja-JP" i="1"/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4080695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4B50DE-3439-F5DB-CF8A-C3F8C081EB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グラフ, 散布図&#10;&#10;自動的に生成された説明">
            <a:extLst>
              <a:ext uri="{FF2B5EF4-FFF2-40B4-BE49-F238E27FC236}">
                <a16:creationId xmlns:a16="http://schemas.microsoft.com/office/drawing/2014/main" id="{9078E2D0-4624-4877-1452-274390EFC8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646" y="4183958"/>
            <a:ext cx="2340000" cy="1886043"/>
          </a:xfrm>
          <a:prstGeom prst="rect">
            <a:avLst/>
          </a:prstGeom>
        </p:spPr>
      </p:pic>
      <p:pic>
        <p:nvPicPr>
          <p:cNvPr id="7" name="図 6" descr="グラフ, 散布図&#10;&#10;自動的に生成された説明">
            <a:extLst>
              <a:ext uri="{FF2B5EF4-FFF2-40B4-BE49-F238E27FC236}">
                <a16:creationId xmlns:a16="http://schemas.microsoft.com/office/drawing/2014/main" id="{F53721F0-EF03-8A35-66C5-552F3A5BB0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698" y="1788860"/>
            <a:ext cx="2340000" cy="1886043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03D4F33-C1C0-C033-30EA-7C3B3462B6F6}"/>
              </a:ext>
            </a:extLst>
          </p:cNvPr>
          <p:cNvSpPr txBox="1"/>
          <p:nvPr/>
        </p:nvSpPr>
        <p:spPr>
          <a:xfrm>
            <a:off x="2898451" y="60769"/>
            <a:ext cx="39052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figure 4 Nakamura </a:t>
            </a:r>
            <a:r>
              <a:rPr lang="en-US" altLang="ja-JP" i="1"/>
              <a:t>et al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E8D80B5-F9BB-AB6B-ABFD-FF57773581AC}"/>
              </a:ext>
            </a:extLst>
          </p:cNvPr>
          <p:cNvSpPr txBox="1"/>
          <p:nvPr/>
        </p:nvSpPr>
        <p:spPr>
          <a:xfrm>
            <a:off x="852396" y="137102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3015CF7-3551-A872-466C-ED582BAF2500}"/>
              </a:ext>
            </a:extLst>
          </p:cNvPr>
          <p:cNvSpPr txBox="1"/>
          <p:nvPr/>
        </p:nvSpPr>
        <p:spPr>
          <a:xfrm>
            <a:off x="852396" y="385387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BDD31EE-D719-8B9E-7E4B-72AF4C74BAA9}"/>
              </a:ext>
            </a:extLst>
          </p:cNvPr>
          <p:cNvSpPr txBox="1"/>
          <p:nvPr/>
        </p:nvSpPr>
        <p:spPr>
          <a:xfrm>
            <a:off x="4483027" y="1371025"/>
            <a:ext cx="142858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u="sng">
                <a:latin typeface="Arial" panose="020B0604020202020204" pitchFamily="34" charset="0"/>
                <a:cs typeface="Arial" panose="020B0604020202020204" pitchFamily="34" charset="0"/>
              </a:rPr>
              <a:t>Sample26</a:t>
            </a:r>
            <a:endParaRPr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3512848-1BE0-9A77-C03F-09834CF3CFB6}"/>
              </a:ext>
            </a:extLst>
          </p:cNvPr>
          <p:cNvSpPr txBox="1"/>
          <p:nvPr/>
        </p:nvSpPr>
        <p:spPr>
          <a:xfrm>
            <a:off x="1314698" y="1388961"/>
            <a:ext cx="23942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u="sng">
                <a:latin typeface="Arial" panose="020B0604020202020204" pitchFamily="34" charset="0"/>
                <a:cs typeface="Arial" panose="020B0604020202020204" pitchFamily="34" charset="0"/>
              </a:rPr>
              <a:t>Sample1 (Control)</a:t>
            </a:r>
            <a:endParaRPr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7041711-5309-6B71-F9C6-76C7BE7F762F}"/>
              </a:ext>
            </a:extLst>
          </p:cNvPr>
          <p:cNvSpPr txBox="1"/>
          <p:nvPr/>
        </p:nvSpPr>
        <p:spPr>
          <a:xfrm rot="16200000">
            <a:off x="3079616" y="2542610"/>
            <a:ext cx="164932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5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00BC4E9-9BEA-893E-ED2C-FF8CE56795CF}"/>
              </a:ext>
            </a:extLst>
          </p:cNvPr>
          <p:cNvSpPr txBox="1"/>
          <p:nvPr/>
        </p:nvSpPr>
        <p:spPr>
          <a:xfrm rot="16200000">
            <a:off x="355681" y="2542609"/>
            <a:ext cx="164932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5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783A28A-930C-5204-8FA7-EE78D26370B0}"/>
              </a:ext>
            </a:extLst>
          </p:cNvPr>
          <p:cNvSpPr txBox="1"/>
          <p:nvPr/>
        </p:nvSpPr>
        <p:spPr>
          <a:xfrm rot="16200000">
            <a:off x="3087240" y="4928475"/>
            <a:ext cx="164932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7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3FE9C71-836E-09EB-7CBF-9019440B9D66}"/>
              </a:ext>
            </a:extLst>
          </p:cNvPr>
          <p:cNvSpPr txBox="1"/>
          <p:nvPr/>
        </p:nvSpPr>
        <p:spPr>
          <a:xfrm rot="16200000">
            <a:off x="363305" y="4928474"/>
            <a:ext cx="164932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7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A38997B-72C7-9AA0-EFE8-82531EB05A7E}"/>
              </a:ext>
            </a:extLst>
          </p:cNvPr>
          <p:cNvSpPr txBox="1"/>
          <p:nvPr/>
        </p:nvSpPr>
        <p:spPr>
          <a:xfrm>
            <a:off x="1441449" y="3642182"/>
            <a:ext cx="204193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3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E1AB18A-DDD0-7921-8182-CDBECE147AB4}"/>
              </a:ext>
            </a:extLst>
          </p:cNvPr>
          <p:cNvSpPr txBox="1"/>
          <p:nvPr/>
        </p:nvSpPr>
        <p:spPr>
          <a:xfrm>
            <a:off x="4156701" y="3642182"/>
            <a:ext cx="204193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3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08C4971-8AA8-2FB4-9519-B330A839506D}"/>
              </a:ext>
            </a:extLst>
          </p:cNvPr>
          <p:cNvSpPr txBox="1"/>
          <p:nvPr/>
        </p:nvSpPr>
        <p:spPr>
          <a:xfrm>
            <a:off x="1441449" y="6070001"/>
            <a:ext cx="204193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3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A1E40C9-902B-BDAF-DC59-1EF760E7FE6A}"/>
              </a:ext>
            </a:extLst>
          </p:cNvPr>
          <p:cNvSpPr txBox="1"/>
          <p:nvPr/>
        </p:nvSpPr>
        <p:spPr>
          <a:xfrm>
            <a:off x="4145384" y="6070001"/>
            <a:ext cx="204193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Antibodies of CD3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 descr="グラフ, 散布図&#10;&#10;自動的に生成された説明">
            <a:extLst>
              <a:ext uri="{FF2B5EF4-FFF2-40B4-BE49-F238E27FC236}">
                <a16:creationId xmlns:a16="http://schemas.microsoft.com/office/drawing/2014/main" id="{D7DEA417-8374-99B6-5FE8-A43D83FCE99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7318" y="1788859"/>
            <a:ext cx="2340000" cy="1886043"/>
          </a:xfrm>
          <a:prstGeom prst="rect">
            <a:avLst/>
          </a:prstGeom>
        </p:spPr>
      </p:pic>
      <p:pic>
        <p:nvPicPr>
          <p:cNvPr id="18" name="図 17" descr="グラフ, 散布図&#10;&#10;自動的に生成された説明">
            <a:extLst>
              <a:ext uri="{FF2B5EF4-FFF2-40B4-BE49-F238E27FC236}">
                <a16:creationId xmlns:a16="http://schemas.microsoft.com/office/drawing/2014/main" id="{719E7800-E257-5272-8DF3-2AAAB9FBF00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3022" y="4183958"/>
            <a:ext cx="2340000" cy="1886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9087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4FDC4436-F77E-6001-44FD-CEA89E8AB35D}"/>
              </a:ext>
            </a:extLst>
          </p:cNvPr>
          <p:cNvSpPr>
            <a:spLocks/>
          </p:cNvSpPr>
          <p:nvPr/>
        </p:nvSpPr>
        <p:spPr>
          <a:xfrm>
            <a:off x="1334286" y="1104204"/>
            <a:ext cx="828000" cy="432000"/>
          </a:xfrm>
          <a:prstGeom prst="rect">
            <a:avLst/>
          </a:prstGeom>
          <a:solidFill>
            <a:srgbClr val="8064A2">
              <a:lumMod val="20000"/>
              <a:lumOff val="80000"/>
            </a:srgbClr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X1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C00E89B-4E34-EB13-364D-F81B8052DA56}"/>
              </a:ext>
            </a:extLst>
          </p:cNvPr>
          <p:cNvSpPr>
            <a:spLocks/>
          </p:cNvSpPr>
          <p:nvPr/>
        </p:nvSpPr>
        <p:spPr>
          <a:xfrm>
            <a:off x="1334286" y="1923194"/>
            <a:ext cx="828000" cy="432000"/>
          </a:xfrm>
          <a:prstGeom prst="rect">
            <a:avLst/>
          </a:prstGeom>
          <a:solidFill>
            <a:srgbClr val="8064A2">
              <a:lumMod val="40000"/>
              <a:lumOff val="60000"/>
            </a:srgbClr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X2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E2E425B-8009-3001-F7CB-3F11A05AD689}"/>
              </a:ext>
            </a:extLst>
          </p:cNvPr>
          <p:cNvSpPr>
            <a:spLocks/>
          </p:cNvSpPr>
          <p:nvPr/>
        </p:nvSpPr>
        <p:spPr>
          <a:xfrm>
            <a:off x="1356940" y="3051992"/>
            <a:ext cx="828000" cy="432000"/>
          </a:xfrm>
          <a:prstGeom prst="rect">
            <a:avLst/>
          </a:prstGeom>
          <a:solidFill>
            <a:srgbClr val="8064A2"/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Xm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78BC403-2B70-F70A-06AB-93787ECC978F}"/>
              </a:ext>
            </a:extLst>
          </p:cNvPr>
          <p:cNvSpPr txBox="1"/>
          <p:nvPr/>
        </p:nvSpPr>
        <p:spPr>
          <a:xfrm>
            <a:off x="846401" y="1182736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n</a:t>
            </a:r>
            <a:endParaRPr kumimoji="1" lang="ja-JP" altLang="en-US" sz="1200" i="1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BB4DA66-3DD3-91EC-1009-97BA08192C9C}"/>
              </a:ext>
            </a:extLst>
          </p:cNvPr>
          <p:cNvSpPr txBox="1"/>
          <p:nvPr/>
        </p:nvSpPr>
        <p:spPr>
          <a:xfrm>
            <a:off x="862295" y="1989219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n</a:t>
            </a:r>
            <a:endParaRPr kumimoji="1" lang="ja-JP" altLang="en-US" sz="1200" i="1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99FAA5B-90D1-2B01-16EB-49038A8E9E31}"/>
              </a:ext>
            </a:extLst>
          </p:cNvPr>
          <p:cNvSpPr txBox="1"/>
          <p:nvPr/>
        </p:nvSpPr>
        <p:spPr>
          <a:xfrm>
            <a:off x="850222" y="3139388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n</a:t>
            </a:r>
            <a:endParaRPr kumimoji="1" lang="ja-JP" altLang="en-US" sz="1200" i="1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10D7686-9559-5F7F-2661-A5FE2B014570}"/>
              </a:ext>
            </a:extLst>
          </p:cNvPr>
          <p:cNvSpPr txBox="1"/>
          <p:nvPr/>
        </p:nvSpPr>
        <p:spPr>
          <a:xfrm>
            <a:off x="1373881" y="1618063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200" i="1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2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078D0A9-36CD-C104-0072-B630A70041E4}"/>
              </a:ext>
            </a:extLst>
          </p:cNvPr>
          <p:cNvSpPr txBox="1"/>
          <p:nvPr/>
        </p:nvSpPr>
        <p:spPr>
          <a:xfrm>
            <a:off x="1394240" y="2776011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200" i="1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m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05680CD-63D1-F57F-4773-7D49B9F01EC4}"/>
              </a:ext>
            </a:extLst>
          </p:cNvPr>
          <p:cNvSpPr txBox="1"/>
          <p:nvPr/>
        </p:nvSpPr>
        <p:spPr>
          <a:xfrm rot="5400000">
            <a:off x="1412688" y="2509402"/>
            <a:ext cx="78242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400" b="1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…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8B05DED-7533-9641-FE6D-7725090331A5}"/>
              </a:ext>
            </a:extLst>
          </p:cNvPr>
          <p:cNvSpPr txBox="1">
            <a:spLocks noChangeAspect="1"/>
          </p:cNvSpPr>
          <p:nvPr/>
        </p:nvSpPr>
        <p:spPr>
          <a:xfrm>
            <a:off x="2134403" y="1693444"/>
            <a:ext cx="1550716" cy="4206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600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Matrix</a:t>
            </a:r>
          </a:p>
          <a:p>
            <a:pPr algn="ctr" defTabSz="914400"/>
            <a:r>
              <a:rPr kumimoji="1" lang="ja-JP" altLang="en-US" sz="1600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decomposition</a:t>
            </a:r>
            <a:endParaRPr kumimoji="1" lang="ja-JP" altLang="en-US" sz="1600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A1C2EEE7-7E31-A2BB-F216-BEB2DE4FFEC2}"/>
              </a:ext>
            </a:extLst>
          </p:cNvPr>
          <p:cNvSpPr>
            <a:spLocks/>
          </p:cNvSpPr>
          <p:nvPr/>
        </p:nvSpPr>
        <p:spPr>
          <a:xfrm>
            <a:off x="3699931" y="2035821"/>
            <a:ext cx="216000" cy="432000"/>
          </a:xfrm>
          <a:prstGeom prst="rect">
            <a:avLst/>
          </a:prstGeom>
          <a:solidFill>
            <a:srgbClr val="C0504D">
              <a:lumMod val="60000"/>
              <a:lumOff val="40000"/>
            </a:srgbClr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W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86D5DEC-88B3-090C-71A1-24F46B638A79}"/>
              </a:ext>
            </a:extLst>
          </p:cNvPr>
          <p:cNvSpPr txBox="1"/>
          <p:nvPr/>
        </p:nvSpPr>
        <p:spPr>
          <a:xfrm>
            <a:off x="3172347" y="2214284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n</a:t>
            </a:r>
            <a:endParaRPr kumimoji="1" lang="ja-JP" altLang="en-US" sz="1200" i="1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1440624-ACD8-2654-2D19-5E55D94D6CBB}"/>
              </a:ext>
            </a:extLst>
          </p:cNvPr>
          <p:cNvSpPr txBox="1"/>
          <p:nvPr/>
        </p:nvSpPr>
        <p:spPr>
          <a:xfrm>
            <a:off x="3715916" y="1713805"/>
            <a:ext cx="1840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k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5E6D5313-6AEB-0331-46C6-C16F770C1A9D}"/>
              </a:ext>
            </a:extLst>
          </p:cNvPr>
          <p:cNvSpPr>
            <a:spLocks/>
          </p:cNvSpPr>
          <p:nvPr/>
        </p:nvSpPr>
        <p:spPr>
          <a:xfrm rot="5400000">
            <a:off x="5209036" y="951476"/>
            <a:ext cx="216000" cy="828000"/>
          </a:xfrm>
          <a:prstGeom prst="rect">
            <a:avLst/>
          </a:prstGeom>
          <a:solidFill>
            <a:srgbClr val="4BACC6">
              <a:lumMod val="20000"/>
              <a:lumOff val="80000"/>
            </a:srgbClr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vert="vert270"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H1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DBA2472-AD47-EC26-E3BF-BA432BEBD3BC}"/>
              </a:ext>
            </a:extLst>
          </p:cNvPr>
          <p:cNvSpPr txBox="1"/>
          <p:nvPr/>
        </p:nvSpPr>
        <p:spPr>
          <a:xfrm>
            <a:off x="4594568" y="1252622"/>
            <a:ext cx="1840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k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EA9ECAE-0B1A-06F4-B792-964203E9CD5F}"/>
              </a:ext>
            </a:extLst>
          </p:cNvPr>
          <p:cNvSpPr txBox="1"/>
          <p:nvPr/>
        </p:nvSpPr>
        <p:spPr>
          <a:xfrm>
            <a:off x="4867416" y="908600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200" i="1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B98AC15C-0EB8-E17B-D8DC-800DEC0CA19B}"/>
              </a:ext>
            </a:extLst>
          </p:cNvPr>
          <p:cNvSpPr/>
          <p:nvPr/>
        </p:nvSpPr>
        <p:spPr>
          <a:xfrm rot="5400000">
            <a:off x="5219893" y="1773619"/>
            <a:ext cx="216000" cy="828000"/>
          </a:xfrm>
          <a:prstGeom prst="rect">
            <a:avLst/>
          </a:prstGeom>
          <a:solidFill>
            <a:srgbClr val="4BACC6">
              <a:lumMod val="40000"/>
              <a:lumOff val="60000"/>
            </a:srgbClr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vert="vert270"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H2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9F90DA0-AFEE-606E-BDDF-DE31F2832C59}"/>
              </a:ext>
            </a:extLst>
          </p:cNvPr>
          <p:cNvSpPr txBox="1"/>
          <p:nvPr/>
        </p:nvSpPr>
        <p:spPr>
          <a:xfrm>
            <a:off x="4596558" y="2049660"/>
            <a:ext cx="1840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k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E97AC6D-C5B2-0D1C-93EE-01DEFEB740F2}"/>
              </a:ext>
            </a:extLst>
          </p:cNvPr>
          <p:cNvSpPr txBox="1"/>
          <p:nvPr/>
        </p:nvSpPr>
        <p:spPr>
          <a:xfrm>
            <a:off x="4878526" y="1740462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200" i="1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2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330A398A-D314-2261-D513-82A03E9DF86E}"/>
              </a:ext>
            </a:extLst>
          </p:cNvPr>
          <p:cNvSpPr/>
          <p:nvPr/>
        </p:nvSpPr>
        <p:spPr>
          <a:xfrm rot="5400000">
            <a:off x="5255999" y="2779860"/>
            <a:ext cx="216000" cy="828000"/>
          </a:xfrm>
          <a:prstGeom prst="rect">
            <a:avLst/>
          </a:prstGeom>
          <a:solidFill>
            <a:srgbClr val="4BACC6"/>
          </a:solidFill>
          <a:ln w="63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vert="vert270" rtlCol="0" anchor="ctr">
            <a:no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Hm</a:t>
            </a:r>
            <a:endParaRPr kumimoji="1" lang="ja-JP" altLang="en-US" sz="1200" b="0" i="1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01EED16-0B62-DD93-02FA-A9A2B6D93DC7}"/>
              </a:ext>
            </a:extLst>
          </p:cNvPr>
          <p:cNvSpPr txBox="1"/>
          <p:nvPr/>
        </p:nvSpPr>
        <p:spPr>
          <a:xfrm>
            <a:off x="4675505" y="3052042"/>
            <a:ext cx="1840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k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FDA5A42-E36D-FE8C-2F5A-604A6E72C242}"/>
              </a:ext>
            </a:extLst>
          </p:cNvPr>
          <p:cNvSpPr txBox="1"/>
          <p:nvPr/>
        </p:nvSpPr>
        <p:spPr>
          <a:xfrm>
            <a:off x="4937497" y="2795429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200" i="1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m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8943063-DECD-8BD0-494B-CAE9C97EB7BF}"/>
              </a:ext>
            </a:extLst>
          </p:cNvPr>
          <p:cNvSpPr txBox="1"/>
          <p:nvPr/>
        </p:nvSpPr>
        <p:spPr>
          <a:xfrm>
            <a:off x="2822012" y="2515677"/>
            <a:ext cx="1943523" cy="4206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600" baseline="-25000">
                <a:solidFill>
                  <a:srgbClr val="C0504D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Common </a:t>
            </a:r>
          </a:p>
          <a:p>
            <a:pPr algn="ctr" defTabSz="914400"/>
            <a:r>
              <a:rPr kumimoji="1" lang="en-US" altLang="ja-JP" sz="1600" baseline="-25000">
                <a:solidFill>
                  <a:srgbClr val="C0504D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factors</a:t>
            </a:r>
            <a:endParaRPr kumimoji="1" lang="ja-JP" altLang="en-US" sz="1600" baseline="-25000">
              <a:solidFill>
                <a:srgbClr val="C0504D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D7545E7-8AEB-B004-C8BD-A867959661EA}"/>
              </a:ext>
            </a:extLst>
          </p:cNvPr>
          <p:cNvSpPr txBox="1"/>
          <p:nvPr/>
        </p:nvSpPr>
        <p:spPr>
          <a:xfrm>
            <a:off x="4641392" y="1447928"/>
            <a:ext cx="1337320" cy="2564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600" baseline="-25000">
                <a:solidFill>
                  <a:srgbClr val="4BACC6">
                    <a:lumMod val="75000"/>
                  </a:srgbClr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Feature vector</a:t>
            </a:r>
            <a:endParaRPr kumimoji="1" lang="ja-JP" altLang="en-US" sz="1600" baseline="-25000">
              <a:solidFill>
                <a:srgbClr val="4BACC6">
                  <a:lumMod val="75000"/>
                </a:srgbClr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46D8378-71EE-154F-66C4-893EEDF31BB9}"/>
              </a:ext>
            </a:extLst>
          </p:cNvPr>
          <p:cNvSpPr txBox="1"/>
          <p:nvPr/>
        </p:nvSpPr>
        <p:spPr>
          <a:xfrm>
            <a:off x="4624499" y="2260907"/>
            <a:ext cx="1375531" cy="2564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600" baseline="-25000">
                <a:solidFill>
                  <a:srgbClr val="4BACC6">
                    <a:lumMod val="75000"/>
                  </a:srgbClr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Feature vector</a:t>
            </a:r>
            <a:endParaRPr kumimoji="1" lang="ja-JP" altLang="en-US" sz="1600" baseline="-25000">
              <a:solidFill>
                <a:srgbClr val="4BACC6">
                  <a:lumMod val="75000"/>
                </a:srgbClr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AE3219A-9453-FAF0-3450-5DD9B50C3960}"/>
              </a:ext>
            </a:extLst>
          </p:cNvPr>
          <p:cNvSpPr txBox="1"/>
          <p:nvPr/>
        </p:nvSpPr>
        <p:spPr>
          <a:xfrm>
            <a:off x="4695189" y="3267775"/>
            <a:ext cx="1279583" cy="2564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600" baseline="-25000">
                <a:solidFill>
                  <a:srgbClr val="4BACC6">
                    <a:lumMod val="75000"/>
                  </a:srgbClr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Feature vector</a:t>
            </a:r>
            <a:endParaRPr kumimoji="1" lang="ja-JP" altLang="en-US" sz="1600" baseline="-25000">
              <a:solidFill>
                <a:srgbClr val="4BACC6">
                  <a:lumMod val="75000"/>
                </a:srgbClr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61C3A85-F961-4D22-0E5B-BA368AEBE7A5}"/>
              </a:ext>
            </a:extLst>
          </p:cNvPr>
          <p:cNvSpPr txBox="1"/>
          <p:nvPr/>
        </p:nvSpPr>
        <p:spPr>
          <a:xfrm>
            <a:off x="2500131" y="2088054"/>
            <a:ext cx="782425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ja-JP" altLang="en-US" sz="3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≈</a:t>
            </a:r>
            <a:endParaRPr kumimoji="1" lang="en-US" altLang="ja-JP" sz="3200" i="1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0C326BA-989E-5238-CD56-69A0B8A0948B}"/>
              </a:ext>
            </a:extLst>
          </p:cNvPr>
          <p:cNvSpPr txBox="1"/>
          <p:nvPr/>
        </p:nvSpPr>
        <p:spPr>
          <a:xfrm>
            <a:off x="3882817" y="2138097"/>
            <a:ext cx="7824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24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×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3A3EC37-AF0B-BAFD-B68B-87C69631F5C3}"/>
              </a:ext>
            </a:extLst>
          </p:cNvPr>
          <p:cNvSpPr txBox="1"/>
          <p:nvPr/>
        </p:nvSpPr>
        <p:spPr>
          <a:xfrm>
            <a:off x="1378537" y="797526"/>
            <a:ext cx="7824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200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200" i="1" baseline="-25000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i="1" baseline="-25000">
              <a:solidFill>
                <a:prstClr val="black"/>
              </a:solidFill>
              <a:latin typeface="Arial" panose="020B0604020202020204" pitchFamily="34" charset="0"/>
              <a:ea typeface="メイリオ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976870C-DDDF-E846-DDAA-81193DDA1C2E}"/>
              </a:ext>
            </a:extLst>
          </p:cNvPr>
          <p:cNvSpPr txBox="1"/>
          <p:nvPr/>
        </p:nvSpPr>
        <p:spPr>
          <a:xfrm rot="5400000">
            <a:off x="4970753" y="2519652"/>
            <a:ext cx="7284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00"/>
            <a:r>
              <a:rPr kumimoji="1" lang="en-US" altLang="ja-JP" sz="1400" b="1" i="1">
                <a:solidFill>
                  <a:prstClr val="black"/>
                </a:solidFill>
                <a:latin typeface="Arial" panose="020B0604020202020204" pitchFamily="34" charset="0"/>
                <a:ea typeface="メイリオ" pitchFamily="50" charset="-128"/>
                <a:cs typeface="Arial" panose="020B0604020202020204" pitchFamily="34" charset="0"/>
              </a:rPr>
              <a:t>…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2AF76B2-62D0-33C9-37E2-8EA3EC79810A}"/>
              </a:ext>
            </a:extLst>
          </p:cNvPr>
          <p:cNvSpPr txBox="1"/>
          <p:nvPr/>
        </p:nvSpPr>
        <p:spPr>
          <a:xfrm>
            <a:off x="2898451" y="60769"/>
            <a:ext cx="39052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/>
              <a:t>Supplemental figure 5 Nakamura </a:t>
            </a:r>
            <a:r>
              <a:rPr lang="en-US" altLang="ja-JP" i="1"/>
              <a:t>et al.</a:t>
            </a:r>
          </a:p>
        </p:txBody>
      </p:sp>
    </p:spTree>
    <p:extLst>
      <p:ext uri="{BB962C8B-B14F-4D97-AF65-F5344CB8AC3E}">
        <p14:creationId xmlns:p14="http://schemas.microsoft.com/office/powerpoint/2010/main" val="659949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2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2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944B8C65F9B0B4A9CBD743D526073B5" ma:contentTypeVersion="16" ma:contentTypeDescription="新しいドキュメントを作成します。" ma:contentTypeScope="" ma:versionID="1ded59d0f0df935ba80bdb8e47439810">
  <xsd:schema xmlns:xsd="http://www.w3.org/2001/XMLSchema" xmlns:xs="http://www.w3.org/2001/XMLSchema" xmlns:p="http://schemas.microsoft.com/office/2006/metadata/properties" xmlns:ns2="45a5ece8-d572-45cd-97bd-2c680894c558" xmlns:ns3="08079cf4-782d-4040-ba29-1d37fbad6a81" targetNamespace="http://schemas.microsoft.com/office/2006/metadata/properties" ma:root="true" ma:fieldsID="6046aaed2b750c11dc52dbe629f84ff6" ns2:_="" ns3:_="">
    <xsd:import namespace="45a5ece8-d572-45cd-97bd-2c680894c558"/>
    <xsd:import namespace="08079cf4-782d-4040-ba29-1d37fbad6a81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lcf76f155ced4ddcb4097134ff3c332f" minOccurs="0"/>
                <xsd:element ref="ns2:TaxCatchAll" minOccurs="0"/>
                <xsd:element ref="ns3:MediaServiceOCR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5a5ece8-d572-45cd-97bd-2c680894c55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9cd08f25-5dca-4345-b44a-c7a0ce35f999}" ma:internalName="TaxCatchAll" ma:showField="CatchAllData" ma:web="45a5ece8-d572-45cd-97bd-2c680894c55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079cf4-782d-4040-ba29-1d37fbad6a8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画像タグ" ma:readOnly="false" ma:fieldId="{5cf76f15-5ced-4ddc-b409-7134ff3c332f}" ma:taxonomyMulti="true" ma:sspId="3cb9d403-1823-4ec6-b2f2-250b7876d07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5a5ece8-d572-45cd-97bd-2c680894c558" xsi:nil="true"/>
    <lcf76f155ced4ddcb4097134ff3c332f xmlns="08079cf4-782d-4040-ba29-1d37fbad6a81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C406149-AB78-47D9-B99D-58AA4330E7C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5a5ece8-d572-45cd-97bd-2c680894c558"/>
    <ds:schemaRef ds:uri="08079cf4-782d-4040-ba29-1d37fbad6a8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307D55E-88A0-4C4A-863C-F3EF52BBE258}">
  <ds:schemaRefs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elements/1.1/"/>
    <ds:schemaRef ds:uri="45a5ece8-d572-45cd-97bd-2c680894c558"/>
    <ds:schemaRef ds:uri="http://schemas.microsoft.com/office/infopath/2007/PartnerControls"/>
    <ds:schemaRef ds:uri="http://schemas.openxmlformats.org/package/2006/metadata/core-properties"/>
    <ds:schemaRef ds:uri="08079cf4-782d-4040-ba29-1d37fbad6a81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64AF5294-49E2-488C-B265-63FFCE0697FA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ff41bcb5-c330-4cbb-8eba-49c9dbaaa5bd}" enabled="1" method="Privileged" siteId="{66c65d8a-9158-4521-a2d8-664963db48e4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1339</Words>
  <Application>Microsoft Office PowerPoint</Application>
  <PresentationFormat>画面に合わせる (4:3)</PresentationFormat>
  <Paragraphs>749</Paragraphs>
  <Slides>9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9</vt:i4>
      </vt:variant>
    </vt:vector>
  </HeadingPairs>
  <TitlesOfParts>
    <vt:vector size="15" baseType="lpstr">
      <vt:lpstr>游ゴシック</vt:lpstr>
      <vt:lpstr>Arial</vt:lpstr>
      <vt:lpstr>Calibri</vt:lpstr>
      <vt:lpstr>Calibri Light</vt:lpstr>
      <vt:lpstr>Office テーマ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cp:lastModifiedBy>Nakamura, Tomohiko (SEC)</cp:lastModifiedBy>
  <cp:revision>3</cp:revision>
  <dcterms:modified xsi:type="dcterms:W3CDTF">2025-10-07T04:14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944B8C65F9B0B4A9CBD743D526073B5</vt:lpwstr>
  </property>
  <property fmtid="{D5CDD505-2E9C-101B-9397-08002B2CF9AE}" pid="3" name="MSIP_Label_ff41bcb5-c330-4cbb-8eba-49c9dbaaa5bd_Enabled">
    <vt:lpwstr>true</vt:lpwstr>
  </property>
  <property fmtid="{D5CDD505-2E9C-101B-9397-08002B2CF9AE}" pid="4" name="MSIP_Label_ff41bcb5-c330-4cbb-8eba-49c9dbaaa5bd_SetDate">
    <vt:lpwstr>2024-04-10T04:45:26Z</vt:lpwstr>
  </property>
  <property fmtid="{D5CDD505-2E9C-101B-9397-08002B2CF9AE}" pid="5" name="MSIP_Label_ff41bcb5-c330-4cbb-8eba-49c9dbaaa5bd_Method">
    <vt:lpwstr>Privileged</vt:lpwstr>
  </property>
  <property fmtid="{D5CDD505-2E9C-101B-9397-08002B2CF9AE}" pid="6" name="MSIP_Label_ff41bcb5-c330-4cbb-8eba-49c9dbaaa5bd_Name">
    <vt:lpwstr>ff41bcb5-c330-4cbb-8eba-49c9dbaaa5bd</vt:lpwstr>
  </property>
  <property fmtid="{D5CDD505-2E9C-101B-9397-08002B2CF9AE}" pid="7" name="MSIP_Label_ff41bcb5-c330-4cbb-8eba-49c9dbaaa5bd_SiteId">
    <vt:lpwstr>66c65d8a-9158-4521-a2d8-664963db48e4</vt:lpwstr>
  </property>
  <property fmtid="{D5CDD505-2E9C-101B-9397-08002B2CF9AE}" pid="8" name="MSIP_Label_ff41bcb5-c330-4cbb-8eba-49c9dbaaa5bd_ActionId">
    <vt:lpwstr>a6a6bad2-33de-459c-a1ca-75c0c47963fa</vt:lpwstr>
  </property>
  <property fmtid="{D5CDD505-2E9C-101B-9397-08002B2CF9AE}" pid="9" name="MSIP_Label_ff41bcb5-c330-4cbb-8eba-49c9dbaaa5bd_ContentBits">
    <vt:lpwstr>0</vt:lpwstr>
  </property>
  <property fmtid="{D5CDD505-2E9C-101B-9397-08002B2CF9AE}" pid="10" name="MediaServiceImageTags">
    <vt:lpwstr/>
  </property>
</Properties>
</file>